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7" r:id="rId2"/>
    <p:sldId id="472" r:id="rId3"/>
  </p:sldIdLst>
  <p:sldSz cx="6480175" cy="9144000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99" autoAdjust="0"/>
    <p:restoredTop sz="93834" autoAdjust="0"/>
  </p:normalViewPr>
  <p:slideViewPr>
    <p:cSldViewPr snapToGrid="0">
      <p:cViewPr varScale="1">
        <p:scale>
          <a:sx n="54" d="100"/>
          <a:sy n="54" d="100"/>
        </p:scale>
        <p:origin x="2108" y="72"/>
      </p:cViewPr>
      <p:guideLst>
        <p:guide orient="horz" pos="2880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../embeddings/oleObject5.bin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349165822094021"/>
          <c:y val="7.0679963410040722E-2"/>
          <c:w val="0.78490317707379598"/>
          <c:h val="0.73123594625298716"/>
        </c:manualLayout>
      </c:layout>
      <c:scatterChart>
        <c:scatterStyle val="lineMarker"/>
        <c:varyColors val="0"/>
        <c:ser>
          <c:idx val="0"/>
          <c:order val="0"/>
          <c:tx>
            <c:v>WT+CFD</c:v>
          </c:tx>
          <c:spPr>
            <a:ln w="9525" cap="rnd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circle"/>
            <c:size val="6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ood intake^0Energy intake.xlsx]energy intake'!$C$64:$M$64</c:f>
                <c:numCache>
                  <c:formatCode>General</c:formatCode>
                  <c:ptCount val="11"/>
                  <c:pt idx="0">
                    <c:v>5.5000000000001492E-2</c:v>
                  </c:pt>
                  <c:pt idx="1">
                    <c:v>5.4999999999998821E-2</c:v>
                  </c:pt>
                  <c:pt idx="2">
                    <c:v>0.13750000000000018</c:v>
                  </c:pt>
                  <c:pt idx="3">
                    <c:v>5.5000000000001492E-2</c:v>
                  </c:pt>
                  <c:pt idx="4">
                    <c:v>0.78604166666666675</c:v>
                  </c:pt>
                  <c:pt idx="5">
                    <c:v>0.41249999999999964</c:v>
                  </c:pt>
                  <c:pt idx="6">
                    <c:v>0.11916666666666842</c:v>
                  </c:pt>
                  <c:pt idx="7">
                    <c:v>0.40333333333333243</c:v>
                  </c:pt>
                  <c:pt idx="8">
                    <c:v>0.2383333333333324</c:v>
                  </c:pt>
                  <c:pt idx="9">
                    <c:v>1.0816666666666668</c:v>
                  </c:pt>
                  <c:pt idx="10">
                    <c:v>1.1790624999999988</c:v>
                  </c:pt>
                </c:numCache>
              </c:numRef>
            </c:plus>
            <c:minus>
              <c:numRef>
                <c:f>'[Food intake^0Energy intake.xlsx]energy intake'!$C$64:$M$64</c:f>
                <c:numCache>
                  <c:formatCode>General</c:formatCode>
                  <c:ptCount val="11"/>
                  <c:pt idx="0">
                    <c:v>5.5000000000001492E-2</c:v>
                  </c:pt>
                  <c:pt idx="1">
                    <c:v>5.4999999999998821E-2</c:v>
                  </c:pt>
                  <c:pt idx="2">
                    <c:v>0.13750000000000018</c:v>
                  </c:pt>
                  <c:pt idx="3">
                    <c:v>5.5000000000001492E-2</c:v>
                  </c:pt>
                  <c:pt idx="4">
                    <c:v>0.78604166666666675</c:v>
                  </c:pt>
                  <c:pt idx="5">
                    <c:v>0.41249999999999964</c:v>
                  </c:pt>
                  <c:pt idx="6">
                    <c:v>0.11916666666666842</c:v>
                  </c:pt>
                  <c:pt idx="7">
                    <c:v>0.40333333333333243</c:v>
                  </c:pt>
                  <c:pt idx="8">
                    <c:v>0.2383333333333324</c:v>
                  </c:pt>
                  <c:pt idx="9">
                    <c:v>1.0816666666666668</c:v>
                  </c:pt>
                  <c:pt idx="10">
                    <c:v>1.179062499999998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od intake^0Energy intake.xlsx]energy intake'!$C$59:$M$59</c:f>
              <c:numCache>
                <c:formatCode>General</c:formatCode>
                <c:ptCount val="1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</c:numCache>
            </c:numRef>
          </c:xVal>
          <c:yVal>
            <c:numRef>
              <c:f>'[Food intake^0Energy intake.xlsx]energy intake'!$C$62:$M$62</c:f>
              <c:numCache>
                <c:formatCode>General</c:formatCode>
                <c:ptCount val="11"/>
                <c:pt idx="0">
                  <c:v>12.008333333333333</c:v>
                </c:pt>
                <c:pt idx="1">
                  <c:v>10.303333333333331</c:v>
                </c:pt>
                <c:pt idx="2">
                  <c:v>9.3958333333333321</c:v>
                </c:pt>
                <c:pt idx="3">
                  <c:v>10.065</c:v>
                </c:pt>
                <c:pt idx="4">
                  <c:v>12.817291666666666</c:v>
                </c:pt>
                <c:pt idx="5">
                  <c:v>11.284166666666668</c:v>
                </c:pt>
                <c:pt idx="6">
                  <c:v>10.807499999999999</c:v>
                </c:pt>
                <c:pt idx="7">
                  <c:v>11.275</c:v>
                </c:pt>
                <c:pt idx="8">
                  <c:v>12.008333333333333</c:v>
                </c:pt>
                <c:pt idx="9">
                  <c:v>11.953333333333335</c:v>
                </c:pt>
                <c:pt idx="10">
                  <c:v>12.7290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CF2-42BB-956B-5DD5F85459D2}"/>
            </c:ext>
          </c:extLst>
        </c:ser>
        <c:ser>
          <c:idx val="1"/>
          <c:order val="1"/>
          <c:tx>
            <c:v>GIPKO+CFD</c:v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triangle"/>
            <c:size val="6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ood intake^0Energy intake.xlsx]energy intake'!$C$70:$M$70</c:f>
                <c:numCache>
                  <c:formatCode>General</c:formatCode>
                  <c:ptCount val="11"/>
                  <c:pt idx="0">
                    <c:v>0.11916666666667018</c:v>
                  </c:pt>
                  <c:pt idx="1">
                    <c:v>0.27499999999999858</c:v>
                  </c:pt>
                  <c:pt idx="2">
                    <c:v>0.17416666666666636</c:v>
                  </c:pt>
                  <c:pt idx="3">
                    <c:v>1.0083333333333351</c:v>
                  </c:pt>
                  <c:pt idx="4">
                    <c:v>0.56145833333333339</c:v>
                  </c:pt>
                  <c:pt idx="5">
                    <c:v>0.12833333333333385</c:v>
                  </c:pt>
                  <c:pt idx="6">
                    <c:v>5.4999999999998821E-2</c:v>
                  </c:pt>
                  <c:pt idx="7">
                    <c:v>9.1666666666665911E-2</c:v>
                  </c:pt>
                  <c:pt idx="8">
                    <c:v>0.13749999999999929</c:v>
                  </c:pt>
                  <c:pt idx="9">
                    <c:v>0.28416666666666662</c:v>
                  </c:pt>
                  <c:pt idx="10">
                    <c:v>0.37697916666666753</c:v>
                  </c:pt>
                </c:numCache>
              </c:numRef>
            </c:plus>
            <c:minus>
              <c:numRef>
                <c:f>'[Food intake^0Energy intake.xlsx]energy intake'!$C$70:$M$70</c:f>
                <c:numCache>
                  <c:formatCode>General</c:formatCode>
                  <c:ptCount val="11"/>
                  <c:pt idx="0">
                    <c:v>0.11916666666667018</c:v>
                  </c:pt>
                  <c:pt idx="1">
                    <c:v>0.27499999999999858</c:v>
                  </c:pt>
                  <c:pt idx="2">
                    <c:v>0.17416666666666636</c:v>
                  </c:pt>
                  <c:pt idx="3">
                    <c:v>1.0083333333333351</c:v>
                  </c:pt>
                  <c:pt idx="4">
                    <c:v>0.56145833333333339</c:v>
                  </c:pt>
                  <c:pt idx="5">
                    <c:v>0.12833333333333385</c:v>
                  </c:pt>
                  <c:pt idx="6">
                    <c:v>5.4999999999998821E-2</c:v>
                  </c:pt>
                  <c:pt idx="7">
                    <c:v>9.1666666666665911E-2</c:v>
                  </c:pt>
                  <c:pt idx="8">
                    <c:v>0.13749999999999929</c:v>
                  </c:pt>
                  <c:pt idx="9">
                    <c:v>0.28416666666666662</c:v>
                  </c:pt>
                  <c:pt idx="10">
                    <c:v>0.3769791666666675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od intake^0Energy intake.xlsx]energy intake'!$C$59:$M$59</c:f>
              <c:numCache>
                <c:formatCode>General</c:formatCode>
                <c:ptCount val="1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</c:numCache>
            </c:numRef>
          </c:xVal>
          <c:yVal>
            <c:numRef>
              <c:f>'[Food intake^0Energy intake.xlsx]energy intake'!$C$68:$M$68</c:f>
              <c:numCache>
                <c:formatCode>General</c:formatCode>
                <c:ptCount val="11"/>
                <c:pt idx="0">
                  <c:v>11.064166666666667</c:v>
                </c:pt>
                <c:pt idx="1">
                  <c:v>9.9366666666666674</c:v>
                </c:pt>
                <c:pt idx="2">
                  <c:v>9.8358333333333317</c:v>
                </c:pt>
                <c:pt idx="3">
                  <c:v>9.0566666666666666</c:v>
                </c:pt>
                <c:pt idx="4">
                  <c:v>11.630208333333332</c:v>
                </c:pt>
                <c:pt idx="5">
                  <c:v>10.358333333333334</c:v>
                </c:pt>
                <c:pt idx="6">
                  <c:v>9.4966666666666697</c:v>
                </c:pt>
                <c:pt idx="7">
                  <c:v>10.120000000000001</c:v>
                </c:pt>
                <c:pt idx="8">
                  <c:v>10.385833333333332</c:v>
                </c:pt>
                <c:pt idx="9">
                  <c:v>10.440833333333334</c:v>
                </c:pt>
                <c:pt idx="10">
                  <c:v>11.060729166666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F2-42BB-956B-5DD5F85459D2}"/>
            </c:ext>
          </c:extLst>
        </c:ser>
        <c:ser>
          <c:idx val="2"/>
          <c:order val="2"/>
          <c:tx>
            <c:v>WT+HFD</c:v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ood intake^0Energy intake.xlsx]energy intake'!$C$76:$M$76</c:f>
                <c:numCache>
                  <c:formatCode>General</c:formatCode>
                  <c:ptCount val="11"/>
                  <c:pt idx="0">
                    <c:v>0.1689285714285704</c:v>
                  </c:pt>
                  <c:pt idx="1">
                    <c:v>0.19145238095238157</c:v>
                  </c:pt>
                  <c:pt idx="2">
                    <c:v>5.6309523809523476E-2</c:v>
                  </c:pt>
                  <c:pt idx="3">
                    <c:v>0.60814285714285976</c:v>
                  </c:pt>
                  <c:pt idx="4">
                    <c:v>0.49270833333333197</c:v>
                  </c:pt>
                  <c:pt idx="5">
                    <c:v>0.10135714285714048</c:v>
                  </c:pt>
                  <c:pt idx="6">
                    <c:v>0.4842619047619045</c:v>
                  </c:pt>
                  <c:pt idx="7">
                    <c:v>0.29280952380952296</c:v>
                  </c:pt>
                  <c:pt idx="8">
                    <c:v>0.38290476190476141</c:v>
                  </c:pt>
                  <c:pt idx="9">
                    <c:v>5.6309523809525253E-2</c:v>
                  </c:pt>
                  <c:pt idx="10">
                    <c:v>0.55183333333333351</c:v>
                  </c:pt>
                </c:numCache>
              </c:numRef>
            </c:plus>
            <c:minus>
              <c:numRef>
                <c:f>'[Food intake^0Energy intake.xlsx]energy intake'!$C$76:$M$76</c:f>
                <c:numCache>
                  <c:formatCode>General</c:formatCode>
                  <c:ptCount val="11"/>
                  <c:pt idx="0">
                    <c:v>0.1689285714285704</c:v>
                  </c:pt>
                  <c:pt idx="1">
                    <c:v>0.19145238095238157</c:v>
                  </c:pt>
                  <c:pt idx="2">
                    <c:v>5.6309523809523476E-2</c:v>
                  </c:pt>
                  <c:pt idx="3">
                    <c:v>0.60814285714285976</c:v>
                  </c:pt>
                  <c:pt idx="4">
                    <c:v>0.49270833333333197</c:v>
                  </c:pt>
                  <c:pt idx="5">
                    <c:v>0.10135714285714048</c:v>
                  </c:pt>
                  <c:pt idx="6">
                    <c:v>0.4842619047619045</c:v>
                  </c:pt>
                  <c:pt idx="7">
                    <c:v>0.29280952380952296</c:v>
                  </c:pt>
                  <c:pt idx="8">
                    <c:v>0.38290476190476141</c:v>
                  </c:pt>
                  <c:pt idx="9">
                    <c:v>5.6309523809525253E-2</c:v>
                  </c:pt>
                  <c:pt idx="10">
                    <c:v>0.5518333333333335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od intake^0Energy intake.xlsx]energy intake'!$C$59:$M$59</c:f>
              <c:numCache>
                <c:formatCode>General</c:formatCode>
                <c:ptCount val="1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</c:numCache>
            </c:numRef>
          </c:xVal>
          <c:yVal>
            <c:numRef>
              <c:f>'[Food intake^0Energy intake.xlsx]energy intake'!$C$74:$M$74</c:f>
              <c:numCache>
                <c:formatCode>General</c:formatCode>
                <c:ptCount val="11"/>
                <c:pt idx="0">
                  <c:v>13.705738095238097</c:v>
                </c:pt>
                <c:pt idx="1">
                  <c:v>11.453357142857143</c:v>
                </c:pt>
                <c:pt idx="2">
                  <c:v>10.732595238095236</c:v>
                </c:pt>
                <c:pt idx="3">
                  <c:v>10.743857142857141</c:v>
                </c:pt>
                <c:pt idx="4">
                  <c:v>12.711874999999999</c:v>
                </c:pt>
                <c:pt idx="5">
                  <c:v>12.849833333333336</c:v>
                </c:pt>
                <c:pt idx="6">
                  <c:v>12.624595238095241</c:v>
                </c:pt>
                <c:pt idx="7">
                  <c:v>12.906142857142857</c:v>
                </c:pt>
                <c:pt idx="8">
                  <c:v>13.581857142857144</c:v>
                </c:pt>
                <c:pt idx="9">
                  <c:v>13.052547619047619</c:v>
                </c:pt>
                <c:pt idx="10">
                  <c:v>11.9038333333333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CF2-42BB-956B-5DD5F85459D2}"/>
            </c:ext>
          </c:extLst>
        </c:ser>
        <c:ser>
          <c:idx val="3"/>
          <c:order val="3"/>
          <c:tx>
            <c:v>GIPKO+HFD</c:v>
          </c:tx>
          <c:spPr>
            <a:ln w="9525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ood intake^0Energy intake.xlsx]energy intake'!$C$82:$M$82</c:f>
                <c:numCache>
                  <c:formatCode>General</c:formatCode>
                  <c:ptCount val="11"/>
                  <c:pt idx="0">
                    <c:v>0.11261904761904516</c:v>
                  </c:pt>
                  <c:pt idx="1">
                    <c:v>0.23649999999999591</c:v>
                  </c:pt>
                  <c:pt idx="2">
                    <c:v>0.21397619047619273</c:v>
                  </c:pt>
                  <c:pt idx="3">
                    <c:v>0.1464047619047619</c:v>
                  </c:pt>
                  <c:pt idx="4">
                    <c:v>0.17737499999999962</c:v>
                  </c:pt>
                  <c:pt idx="5">
                    <c:v>1.7906428571428576</c:v>
                  </c:pt>
                  <c:pt idx="6">
                    <c:v>0.15766666666666482</c:v>
                  </c:pt>
                  <c:pt idx="7">
                    <c:v>1.0248333333333324</c:v>
                  </c:pt>
                  <c:pt idx="8">
                    <c:v>0.48426190476190634</c:v>
                  </c:pt>
                  <c:pt idx="9">
                    <c:v>0.22523809523809565</c:v>
                  </c:pt>
                  <c:pt idx="10">
                    <c:v>8.8687499999998906E-2</c:v>
                  </c:pt>
                </c:numCache>
              </c:numRef>
            </c:plus>
            <c:minus>
              <c:numRef>
                <c:f>'[Food intake^0Energy intake.xlsx]energy intake'!$C$82:$M$82</c:f>
                <c:numCache>
                  <c:formatCode>General</c:formatCode>
                  <c:ptCount val="11"/>
                  <c:pt idx="0">
                    <c:v>0.11261904761904516</c:v>
                  </c:pt>
                  <c:pt idx="1">
                    <c:v>0.23649999999999591</c:v>
                  </c:pt>
                  <c:pt idx="2">
                    <c:v>0.21397619047619273</c:v>
                  </c:pt>
                  <c:pt idx="3">
                    <c:v>0.1464047619047619</c:v>
                  </c:pt>
                  <c:pt idx="4">
                    <c:v>0.17737499999999962</c:v>
                  </c:pt>
                  <c:pt idx="5">
                    <c:v>1.7906428571428576</c:v>
                  </c:pt>
                  <c:pt idx="6">
                    <c:v>0.15766666666666482</c:v>
                  </c:pt>
                  <c:pt idx="7">
                    <c:v>1.0248333333333324</c:v>
                  </c:pt>
                  <c:pt idx="8">
                    <c:v>0.48426190476190634</c:v>
                  </c:pt>
                  <c:pt idx="9">
                    <c:v>0.22523809523809565</c:v>
                  </c:pt>
                  <c:pt idx="10">
                    <c:v>8.8687499999998906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[Food intake^0Energy intake.xlsx]energy intake'!$C$59:$M$59</c:f>
              <c:numCache>
                <c:formatCode>General</c:formatCode>
                <c:ptCount val="11"/>
                <c:pt idx="0">
                  <c:v>6</c:v>
                </c:pt>
                <c:pt idx="1">
                  <c:v>7</c:v>
                </c:pt>
                <c:pt idx="2">
                  <c:v>8</c:v>
                </c:pt>
                <c:pt idx="3">
                  <c:v>9</c:v>
                </c:pt>
                <c:pt idx="4">
                  <c:v>10</c:v>
                </c:pt>
                <c:pt idx="5">
                  <c:v>11</c:v>
                </c:pt>
                <c:pt idx="6">
                  <c:v>12</c:v>
                </c:pt>
                <c:pt idx="7">
                  <c:v>13</c:v>
                </c:pt>
                <c:pt idx="8">
                  <c:v>14</c:v>
                </c:pt>
                <c:pt idx="9">
                  <c:v>15</c:v>
                </c:pt>
                <c:pt idx="10">
                  <c:v>16</c:v>
                </c:pt>
              </c:numCache>
            </c:numRef>
          </c:xVal>
          <c:yVal>
            <c:numRef>
              <c:f>'[Food intake^0Energy intake.xlsx]energy intake'!$C$80:$M$80</c:f>
              <c:numCache>
                <c:formatCode>General</c:formatCode>
                <c:ptCount val="11"/>
                <c:pt idx="0">
                  <c:v>12.86109523809524</c:v>
                </c:pt>
                <c:pt idx="1">
                  <c:v>10.980357142857144</c:v>
                </c:pt>
                <c:pt idx="2">
                  <c:v>10.282119047619048</c:v>
                </c:pt>
                <c:pt idx="3">
                  <c:v>10.282119047619048</c:v>
                </c:pt>
                <c:pt idx="4">
                  <c:v>14.170291666666667</c:v>
                </c:pt>
                <c:pt idx="5">
                  <c:v>12.489452380952383</c:v>
                </c:pt>
                <c:pt idx="6">
                  <c:v>11.84752380952381</c:v>
                </c:pt>
                <c:pt idx="7">
                  <c:v>12.64711904761905</c:v>
                </c:pt>
                <c:pt idx="8">
                  <c:v>11.65607142857143</c:v>
                </c:pt>
                <c:pt idx="9">
                  <c:v>11.712380952380952</c:v>
                </c:pt>
                <c:pt idx="10">
                  <c:v>11.1253541666666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CF2-42BB-956B-5DD5F85459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4122616"/>
        <c:axId val="574125496"/>
      </c:scatterChart>
      <c:valAx>
        <c:axId val="574122616"/>
        <c:scaling>
          <c:orientation val="minMax"/>
          <c:max val="16.5"/>
          <c:min val="6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4125496"/>
        <c:crosses val="autoZero"/>
        <c:crossBetween val="midCat"/>
        <c:majorUnit val="2"/>
      </c:valAx>
      <c:valAx>
        <c:axId val="574125496"/>
        <c:scaling>
          <c:orientation val="minMax"/>
          <c:max val="20"/>
          <c:min val="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74122616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058961379827499"/>
          <c:y val="9.4269980958262597E-2"/>
          <c:w val="0.68336864141982301"/>
          <c:h val="0.729361329833771"/>
        </c:manualLayout>
      </c:layout>
      <c:scatterChart>
        <c:scatterStyle val="lineMarker"/>
        <c:varyColors val="0"/>
        <c:ser>
          <c:idx val="0"/>
          <c:order val="0"/>
          <c:tx>
            <c:v>WT CFD</c:v>
          </c:tx>
          <c:spPr>
            <a:ln w="9525" cap="rnd">
              <a:solidFill>
                <a:sysClr val="windowText" lastClr="000000"/>
              </a:solidFill>
              <a:prstDash val="lgDashDot"/>
              <a:round/>
            </a:ln>
            <a:effectLst/>
          </c:spPr>
          <c:marker>
            <c:symbol val="circ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518ITT'!$P$9:$T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580694901937886</c:v>
                  </c:pt>
                  <c:pt idx="2">
                    <c:v>2.6926726866991371</c:v>
                  </c:pt>
                  <c:pt idx="3">
                    <c:v>4.5866065420560602</c:v>
                  </c:pt>
                  <c:pt idx="4">
                    <c:v>7.0970983331931761</c:v>
                  </c:pt>
                </c:numCache>
              </c:numRef>
            </c:plus>
            <c:minus>
              <c:numRef>
                <c:f>'190518ITT'!$P$9:$T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580694901937886</c:v>
                  </c:pt>
                  <c:pt idx="2">
                    <c:v>2.6926726866991371</c:v>
                  </c:pt>
                  <c:pt idx="3">
                    <c:v>4.5866065420560602</c:v>
                  </c:pt>
                  <c:pt idx="4">
                    <c:v>7.0970983331931761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51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518ITT'!$P$7:$T$7</c:f>
              <c:numCache>
                <c:formatCode>General</c:formatCode>
                <c:ptCount val="5"/>
                <c:pt idx="0">
                  <c:v>100</c:v>
                </c:pt>
                <c:pt idx="1">
                  <c:v>51.197895759011907</c:v>
                </c:pt>
                <c:pt idx="2">
                  <c:v>52.837009222199711</c:v>
                </c:pt>
                <c:pt idx="3">
                  <c:v>53.749060625849197</c:v>
                </c:pt>
                <c:pt idx="4">
                  <c:v>70.6978360057483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05D-43D5-A01D-67233E86A009}"/>
            </c:ext>
          </c:extLst>
        </c:ser>
        <c:ser>
          <c:idx val="1"/>
          <c:order val="1"/>
          <c:tx>
            <c:v>GIPgfp/gfp CFD</c:v>
          </c:tx>
          <c:spPr>
            <a:ln w="9525" cap="rnd">
              <a:solidFill>
                <a:sysClr val="windowText" lastClr="000000"/>
              </a:solidFill>
              <a:prstDash val="dash"/>
              <a:round/>
            </a:ln>
            <a:effectLst/>
          </c:spPr>
          <c:marker>
            <c:symbol val="triang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518ITT'!$P$20:$T$2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1903602047109487</c:v>
                  </c:pt>
                  <c:pt idx="2">
                    <c:v>11.69446899371526</c:v>
                  </c:pt>
                  <c:pt idx="3">
                    <c:v>12.16308607562352</c:v>
                  </c:pt>
                  <c:pt idx="4">
                    <c:v>9.9896577346544913</c:v>
                  </c:pt>
                </c:numCache>
              </c:numRef>
            </c:plus>
            <c:minus>
              <c:numRef>
                <c:f>'190518ITT'!$P$20:$T$2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7.1903602047109487</c:v>
                  </c:pt>
                  <c:pt idx="2">
                    <c:v>11.69446899371526</c:v>
                  </c:pt>
                  <c:pt idx="3">
                    <c:v>12.16308607562352</c:v>
                  </c:pt>
                  <c:pt idx="4">
                    <c:v>9.9896577346544913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51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518ITT'!$P$18:$T$18</c:f>
              <c:numCache>
                <c:formatCode>General</c:formatCode>
                <c:ptCount val="5"/>
                <c:pt idx="0">
                  <c:v>100</c:v>
                </c:pt>
                <c:pt idx="1">
                  <c:v>56.463186297000298</c:v>
                </c:pt>
                <c:pt idx="2">
                  <c:v>52.157592941019011</c:v>
                </c:pt>
                <c:pt idx="3">
                  <c:v>69.402793670734781</c:v>
                </c:pt>
                <c:pt idx="4">
                  <c:v>83.9073943471656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05D-43D5-A01D-67233E86A009}"/>
            </c:ext>
          </c:extLst>
        </c:ser>
        <c:ser>
          <c:idx val="2"/>
          <c:order val="2"/>
          <c:tx>
            <c:v>WT HFD</c:v>
          </c:tx>
          <c:spPr>
            <a:ln w="9525" cap="rnd">
              <a:solidFill>
                <a:sysClr val="windowText" lastClr="000000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518ITT'!$P$33:$T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455464903611686</c:v>
                  </c:pt>
                  <c:pt idx="2">
                    <c:v>2.5390041909300192</c:v>
                  </c:pt>
                  <c:pt idx="3">
                    <c:v>3.5240550119152041</c:v>
                  </c:pt>
                  <c:pt idx="4">
                    <c:v>3.0756833978411429</c:v>
                  </c:pt>
                </c:numCache>
              </c:numRef>
            </c:plus>
            <c:minus>
              <c:numRef>
                <c:f>'190518ITT'!$P$33:$T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455464903611686</c:v>
                  </c:pt>
                  <c:pt idx="2">
                    <c:v>2.5390041909300192</c:v>
                  </c:pt>
                  <c:pt idx="3">
                    <c:v>3.5240550119152041</c:v>
                  </c:pt>
                  <c:pt idx="4">
                    <c:v>3.0756833978411429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51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518ITT'!$P$31:$T$31</c:f>
              <c:numCache>
                <c:formatCode>General</c:formatCode>
                <c:ptCount val="5"/>
                <c:pt idx="0">
                  <c:v>100</c:v>
                </c:pt>
                <c:pt idx="1">
                  <c:v>47.949112931609072</c:v>
                </c:pt>
                <c:pt idx="2">
                  <c:v>47.674967602304292</c:v>
                </c:pt>
                <c:pt idx="3">
                  <c:v>56.989600585872743</c:v>
                </c:pt>
                <c:pt idx="4">
                  <c:v>65.2506125235359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05D-43D5-A01D-67233E86A009}"/>
            </c:ext>
          </c:extLst>
        </c:ser>
        <c:ser>
          <c:idx val="3"/>
          <c:order val="3"/>
          <c:tx>
            <c:v>GIPgfp/gfp HFD</c:v>
          </c:tx>
          <c:spPr>
            <a:ln w="9525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518ITT'!$P$45:$T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7373157833221704</c:v>
                  </c:pt>
                  <c:pt idx="2">
                    <c:v>5.2959348272491464</c:v>
                  </c:pt>
                  <c:pt idx="3">
                    <c:v>7.2118003600067917</c:v>
                  </c:pt>
                  <c:pt idx="4">
                    <c:v>7.4354686740085079</c:v>
                  </c:pt>
                </c:numCache>
              </c:numRef>
            </c:plus>
            <c:minus>
              <c:numRef>
                <c:f>'190518ITT'!$P$45:$T$4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7373157833221704</c:v>
                  </c:pt>
                  <c:pt idx="2">
                    <c:v>5.2959348272491464</c:v>
                  </c:pt>
                  <c:pt idx="3">
                    <c:v>7.2118003600067917</c:v>
                  </c:pt>
                  <c:pt idx="4">
                    <c:v>7.4354686740085079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51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518ITT'!$P$43:$T$43</c:f>
              <c:numCache>
                <c:formatCode>General</c:formatCode>
                <c:ptCount val="5"/>
                <c:pt idx="0">
                  <c:v>100</c:v>
                </c:pt>
                <c:pt idx="1">
                  <c:v>53.934445184445153</c:v>
                </c:pt>
                <c:pt idx="2">
                  <c:v>55.966797091797012</c:v>
                </c:pt>
                <c:pt idx="3">
                  <c:v>67.576030451030448</c:v>
                </c:pt>
                <c:pt idx="4">
                  <c:v>83.7649572649573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05D-43D5-A01D-67233E86A0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8520840"/>
        <c:axId val="-2138525864"/>
      </c:scatterChart>
      <c:valAx>
        <c:axId val="-2138520840"/>
        <c:scaling>
          <c:orientation val="minMax"/>
          <c:max val="1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38525864"/>
        <c:crosses val="autoZero"/>
        <c:crossBetween val="midCat"/>
        <c:majorUnit val="30"/>
      </c:valAx>
      <c:valAx>
        <c:axId val="-2138525864"/>
        <c:scaling>
          <c:orientation val="minMax"/>
          <c:max val="1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38520840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1271852555749"/>
          <c:y val="0.167453493537215"/>
          <c:w val="0.76803915135608103"/>
          <c:h val="0.65979161695697197"/>
        </c:manualLayout>
      </c:layout>
      <c:scatterChart>
        <c:scatterStyle val="lineMarker"/>
        <c:varyColors val="0"/>
        <c:ser>
          <c:idx val="0"/>
          <c:order val="0"/>
          <c:tx>
            <c:v>WT CFD</c:v>
          </c:tx>
          <c:spPr>
            <a:ln w="9525" cap="rnd">
              <a:solidFill>
                <a:sysClr val="windowText" lastClr="000000"/>
              </a:solidFill>
              <a:prstDash val="lgDashDot"/>
              <a:round/>
            </a:ln>
            <a:effectLst/>
          </c:spPr>
          <c:marker>
            <c:symbol val="circ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615ITT'!$P$8:$T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979605804245868</c:v>
                  </c:pt>
                  <c:pt idx="2">
                    <c:v>8.4481320763281236</c:v>
                  </c:pt>
                  <c:pt idx="3">
                    <c:v>10.602430035243829</c:v>
                  </c:pt>
                  <c:pt idx="4">
                    <c:v>10.769317160075831</c:v>
                  </c:pt>
                </c:numCache>
              </c:numRef>
            </c:plus>
            <c:minus>
              <c:numRef>
                <c:f>'190615ITT'!$P$8:$T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1979605804245868</c:v>
                  </c:pt>
                  <c:pt idx="2">
                    <c:v>8.4481320763281236</c:v>
                  </c:pt>
                  <c:pt idx="3">
                    <c:v>10.602430035243829</c:v>
                  </c:pt>
                  <c:pt idx="4">
                    <c:v>10.769317160075831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615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615ITT'!$P$6:$T$6</c:f>
              <c:numCache>
                <c:formatCode>General</c:formatCode>
                <c:ptCount val="5"/>
                <c:pt idx="0">
                  <c:v>100</c:v>
                </c:pt>
                <c:pt idx="1">
                  <c:v>69.696463051819435</c:v>
                </c:pt>
                <c:pt idx="2">
                  <c:v>54.100955110044112</c:v>
                </c:pt>
                <c:pt idx="3">
                  <c:v>57.515272644860012</c:v>
                </c:pt>
                <c:pt idx="4">
                  <c:v>70.6557301738457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3B2-4E43-8EB5-A4F27997B66F}"/>
            </c:ext>
          </c:extLst>
        </c:ser>
        <c:ser>
          <c:idx val="1"/>
          <c:order val="1"/>
          <c:tx>
            <c:v>GIPgfp/gfp CFD</c:v>
          </c:tx>
          <c:spPr>
            <a:ln w="9525" cap="rnd">
              <a:solidFill>
                <a:sysClr val="windowText" lastClr="000000"/>
              </a:solidFill>
              <a:prstDash val="dash"/>
              <a:round/>
            </a:ln>
            <a:effectLst/>
          </c:spPr>
          <c:marker>
            <c:symbol val="triang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615ITT'!$P$19:$T$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40130040755193</c:v>
                  </c:pt>
                  <c:pt idx="2">
                    <c:v>0.91068522966890497</c:v>
                  </c:pt>
                  <c:pt idx="3">
                    <c:v>2.881063317160621</c:v>
                  </c:pt>
                  <c:pt idx="4">
                    <c:v>3.2332924710861888</c:v>
                  </c:pt>
                </c:numCache>
              </c:numRef>
            </c:plus>
            <c:minus>
              <c:numRef>
                <c:f>'190615ITT'!$P$19:$T$1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40130040755193</c:v>
                  </c:pt>
                  <c:pt idx="2">
                    <c:v>0.91068522966890497</c:v>
                  </c:pt>
                  <c:pt idx="3">
                    <c:v>2.881063317160621</c:v>
                  </c:pt>
                  <c:pt idx="4">
                    <c:v>3.2332924710861888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615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615ITT'!$P$17:$T$17</c:f>
              <c:numCache>
                <c:formatCode>General</c:formatCode>
                <c:ptCount val="5"/>
                <c:pt idx="0">
                  <c:v>100</c:v>
                </c:pt>
                <c:pt idx="1">
                  <c:v>60.050639751148793</c:v>
                </c:pt>
                <c:pt idx="2">
                  <c:v>52.918573131242773</c:v>
                </c:pt>
                <c:pt idx="3">
                  <c:v>66.454423425577303</c:v>
                </c:pt>
                <c:pt idx="4">
                  <c:v>79.2304609721182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B2-4E43-8EB5-A4F27997B66F}"/>
            </c:ext>
          </c:extLst>
        </c:ser>
        <c:ser>
          <c:idx val="2"/>
          <c:order val="2"/>
          <c:tx>
            <c:v>WT HFD</c:v>
          </c:tx>
          <c:spPr>
            <a:ln w="9525" cap="rnd">
              <a:solidFill>
                <a:sysClr val="windowText" lastClr="000000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615ITT'!$P$32:$T$3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7694936056736799</c:v>
                  </c:pt>
                  <c:pt idx="2">
                    <c:v>5.7189018177881783</c:v>
                  </c:pt>
                  <c:pt idx="3">
                    <c:v>6.022913207013687</c:v>
                  </c:pt>
                  <c:pt idx="4">
                    <c:v>8.0042231459902684</c:v>
                  </c:pt>
                </c:numCache>
              </c:numRef>
            </c:plus>
            <c:minus>
              <c:numRef>
                <c:f>'190615ITT'!$P$32:$T$3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6.7694936056736799</c:v>
                  </c:pt>
                  <c:pt idx="2">
                    <c:v>5.7189018177881783</c:v>
                  </c:pt>
                  <c:pt idx="3">
                    <c:v>6.022913207013687</c:v>
                  </c:pt>
                  <c:pt idx="4">
                    <c:v>8.0042231459902684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errBars>
            <c:errDir val="x"/>
            <c:errBarType val="both"/>
            <c:errValType val="fixedVal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190615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615ITT'!$P$30:$T$30</c:f>
              <c:numCache>
                <c:formatCode>General</c:formatCode>
                <c:ptCount val="5"/>
                <c:pt idx="0">
                  <c:v>100</c:v>
                </c:pt>
                <c:pt idx="1">
                  <c:v>67.775390523131293</c:v>
                </c:pt>
                <c:pt idx="2">
                  <c:v>62.210938179123417</c:v>
                </c:pt>
                <c:pt idx="3">
                  <c:v>74.158587814460972</c:v>
                </c:pt>
                <c:pt idx="4">
                  <c:v>84.3773687824890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B2-4E43-8EB5-A4F27997B66F}"/>
            </c:ext>
          </c:extLst>
        </c:ser>
        <c:ser>
          <c:idx val="3"/>
          <c:order val="3"/>
          <c:tx>
            <c:v>GIPgfp/gfp HFD</c:v>
          </c:tx>
          <c:spPr>
            <a:ln w="9525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>
                    <a:alpha val="94000"/>
                  </a:sys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615ITT'!$P$42:$T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3160806098991711</c:v>
                  </c:pt>
                  <c:pt idx="2">
                    <c:v>3.9095000430920002</c:v>
                  </c:pt>
                  <c:pt idx="3">
                    <c:v>2.9972783927272451</c:v>
                  </c:pt>
                  <c:pt idx="4">
                    <c:v>9.0097288133755402</c:v>
                  </c:pt>
                </c:numCache>
              </c:numRef>
            </c:plus>
            <c:minus>
              <c:numRef>
                <c:f>'190615ITT'!$P$42:$T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3160806098991711</c:v>
                  </c:pt>
                  <c:pt idx="2">
                    <c:v>3.9095000430920002</c:v>
                  </c:pt>
                  <c:pt idx="3">
                    <c:v>2.9972783927272451</c:v>
                  </c:pt>
                  <c:pt idx="4">
                    <c:v>9.009728813375540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615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615ITT'!$P$40:$T$40</c:f>
              <c:numCache>
                <c:formatCode>General</c:formatCode>
                <c:ptCount val="5"/>
                <c:pt idx="0">
                  <c:v>100</c:v>
                </c:pt>
                <c:pt idx="1">
                  <c:v>64.53058825862793</c:v>
                </c:pt>
                <c:pt idx="2">
                  <c:v>64.033958515976408</c:v>
                </c:pt>
                <c:pt idx="3">
                  <c:v>73.686432062231177</c:v>
                </c:pt>
                <c:pt idx="4">
                  <c:v>81.43724446461999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3B2-4E43-8EB5-A4F27997B6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8437992"/>
        <c:axId val="-2138442328"/>
      </c:scatterChart>
      <c:valAx>
        <c:axId val="-2138437992"/>
        <c:scaling>
          <c:orientation val="minMax"/>
          <c:max val="1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38442328"/>
        <c:crosses val="autoZero"/>
        <c:crossBetween val="midCat"/>
        <c:majorUnit val="30"/>
      </c:valAx>
      <c:valAx>
        <c:axId val="-2138442328"/>
        <c:scaling>
          <c:orientation val="minMax"/>
          <c:max val="14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38437992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9089305644944479"/>
          <c:y val="6.4741395087642331E-2"/>
          <c:w val="0.75515026246719197"/>
          <c:h val="0.74151574104925999"/>
        </c:manualLayout>
      </c:layout>
      <c:scatterChart>
        <c:scatterStyle val="lineMarker"/>
        <c:varyColors val="0"/>
        <c:ser>
          <c:idx val="0"/>
          <c:order val="0"/>
          <c:tx>
            <c:v>WT CFD</c:v>
          </c:tx>
          <c:spPr>
            <a:ln w="9525" cap="rnd">
              <a:solidFill>
                <a:sysClr val="windowText" lastClr="000000"/>
              </a:solidFill>
              <a:prstDash val="lgDashDot"/>
              <a:round/>
            </a:ln>
            <a:effectLst/>
          </c:spPr>
          <c:marker>
            <c:symbol val="circ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728ITT'!$P$9:$T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6333152323064279</c:v>
                  </c:pt>
                  <c:pt idx="2">
                    <c:v>7.7172325120584606</c:v>
                  </c:pt>
                  <c:pt idx="3">
                    <c:v>12.142640226696431</c:v>
                  </c:pt>
                  <c:pt idx="4">
                    <c:v>15.045157260356319</c:v>
                  </c:pt>
                </c:numCache>
              </c:numRef>
            </c:plus>
            <c:minus>
              <c:numRef>
                <c:f>'190728ITT'!$P$9:$T$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.6333152323064279</c:v>
                  </c:pt>
                  <c:pt idx="2">
                    <c:v>7.7172325120584606</c:v>
                  </c:pt>
                  <c:pt idx="3">
                    <c:v>12.142640226696431</c:v>
                  </c:pt>
                  <c:pt idx="4">
                    <c:v>15.045157260356319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72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728ITT'!$P$7:$T$7</c:f>
              <c:numCache>
                <c:formatCode>General</c:formatCode>
                <c:ptCount val="5"/>
                <c:pt idx="0">
                  <c:v>100</c:v>
                </c:pt>
                <c:pt idx="1">
                  <c:v>62.448125040645699</c:v>
                </c:pt>
                <c:pt idx="2">
                  <c:v>43.060044914343123</c:v>
                </c:pt>
                <c:pt idx="3">
                  <c:v>49.129223518732999</c:v>
                </c:pt>
                <c:pt idx="4">
                  <c:v>58.9601706911080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3B1-44C9-909D-B350C647639B}"/>
            </c:ext>
          </c:extLst>
        </c:ser>
        <c:ser>
          <c:idx val="1"/>
          <c:order val="1"/>
          <c:tx>
            <c:v>GIPgfp/gfp CFD</c:v>
          </c:tx>
          <c:spPr>
            <a:ln w="9525" cap="rnd">
              <a:solidFill>
                <a:sysClr val="windowText" lastClr="000000"/>
              </a:solidFill>
              <a:prstDash val="dash"/>
              <a:round/>
            </a:ln>
            <a:effectLst/>
          </c:spPr>
          <c:marker>
            <c:symbol val="triangle"/>
            <c:size val="6"/>
            <c:spPr>
              <a:noFill/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728ITT'!$P$20:$T$2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3243919621330988</c:v>
                  </c:pt>
                  <c:pt idx="2">
                    <c:v>8.9181794490206379</c:v>
                  </c:pt>
                  <c:pt idx="3">
                    <c:v>9.9372310106540453</c:v>
                  </c:pt>
                  <c:pt idx="4">
                    <c:v>15.452936734255299</c:v>
                  </c:pt>
                </c:numCache>
              </c:numRef>
            </c:plus>
            <c:minus>
              <c:numRef>
                <c:f>'190728ITT'!$P$20:$T$2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3243919621330988</c:v>
                  </c:pt>
                  <c:pt idx="2">
                    <c:v>8.9181794490206379</c:v>
                  </c:pt>
                  <c:pt idx="3">
                    <c:v>9.9372310106540453</c:v>
                  </c:pt>
                  <c:pt idx="4">
                    <c:v>15.452936734255299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72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728ITT'!$P$18:$T$18</c:f>
              <c:numCache>
                <c:formatCode>General</c:formatCode>
                <c:ptCount val="5"/>
                <c:pt idx="0">
                  <c:v>100</c:v>
                </c:pt>
                <c:pt idx="1">
                  <c:v>52.839457746278882</c:v>
                </c:pt>
                <c:pt idx="2">
                  <c:v>27.424821997976899</c:v>
                </c:pt>
                <c:pt idx="3">
                  <c:v>39.660334231242047</c:v>
                </c:pt>
                <c:pt idx="4">
                  <c:v>53.75154883543977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3B1-44C9-909D-B350C647639B}"/>
            </c:ext>
          </c:extLst>
        </c:ser>
        <c:ser>
          <c:idx val="2"/>
          <c:order val="2"/>
          <c:tx>
            <c:v>WT HFD</c:v>
          </c:tx>
          <c:spPr>
            <a:ln w="9525" cap="rnd">
              <a:solidFill>
                <a:sysClr val="windowText" lastClr="000000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728ITT'!$P$33:$T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7804688433428231</c:v>
                  </c:pt>
                  <c:pt idx="2">
                    <c:v>3.8375548573495322</c:v>
                  </c:pt>
                  <c:pt idx="3">
                    <c:v>8.965201788003121</c:v>
                  </c:pt>
                  <c:pt idx="4">
                    <c:v>6.54484974924463</c:v>
                  </c:pt>
                </c:numCache>
              </c:numRef>
            </c:plus>
            <c:minus>
              <c:numRef>
                <c:f>'190728ITT'!$P$33:$T$3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7804688433428231</c:v>
                  </c:pt>
                  <c:pt idx="2">
                    <c:v>3.8375548573495322</c:v>
                  </c:pt>
                  <c:pt idx="3">
                    <c:v>8.965201788003121</c:v>
                  </c:pt>
                  <c:pt idx="4">
                    <c:v>6.54484974924463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72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728ITT'!$P$31:$T$31</c:f>
              <c:numCache>
                <c:formatCode>General</c:formatCode>
                <c:ptCount val="5"/>
                <c:pt idx="0">
                  <c:v>100</c:v>
                </c:pt>
                <c:pt idx="1">
                  <c:v>90.67574897277045</c:v>
                </c:pt>
                <c:pt idx="2">
                  <c:v>84.623564558975602</c:v>
                </c:pt>
                <c:pt idx="3">
                  <c:v>103.88666683088751</c:v>
                </c:pt>
                <c:pt idx="4">
                  <c:v>120.00079620498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33B1-44C9-909D-B350C647639B}"/>
            </c:ext>
          </c:extLst>
        </c:ser>
        <c:ser>
          <c:idx val="3"/>
          <c:order val="3"/>
          <c:tx>
            <c:v>GIPgfp/gfp HFD</c:v>
          </c:tx>
          <c:spPr>
            <a:ln w="9525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ysClr val="windowText" lastClr="000000"/>
              </a:solidFill>
              <a:ln w="12700">
                <a:solidFill>
                  <a:sysClr val="windowText" lastClr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90728ITT'!$P$44:$T$4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940047227628249</c:v>
                  </c:pt>
                  <c:pt idx="2">
                    <c:v>10.182881601947431</c:v>
                  </c:pt>
                  <c:pt idx="3">
                    <c:v>9.1011966002296507</c:v>
                  </c:pt>
                  <c:pt idx="4">
                    <c:v>10.66900418491092</c:v>
                  </c:pt>
                </c:numCache>
              </c:numRef>
            </c:plus>
            <c:minus>
              <c:numRef>
                <c:f>'190728ITT'!$P$44:$T$4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7940047227628249</c:v>
                  </c:pt>
                  <c:pt idx="2">
                    <c:v>10.182881601947431</c:v>
                  </c:pt>
                  <c:pt idx="3">
                    <c:v>9.1011966002296507</c:v>
                  </c:pt>
                  <c:pt idx="4">
                    <c:v>10.66900418491092</c:v>
                  </c:pt>
                </c:numCache>
              </c:numRef>
            </c:minus>
            <c:spPr>
              <a:noFill/>
              <a:ln w="1270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xVal>
            <c:numRef>
              <c:f>'190728ITT'!$P$1:$T$1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90</c:v>
                </c:pt>
                <c:pt idx="4">
                  <c:v>120</c:v>
                </c:pt>
              </c:numCache>
            </c:numRef>
          </c:xVal>
          <c:yVal>
            <c:numRef>
              <c:f>'190728ITT'!$P$42:$T$42</c:f>
              <c:numCache>
                <c:formatCode>General</c:formatCode>
                <c:ptCount val="5"/>
                <c:pt idx="0">
                  <c:v>100</c:v>
                </c:pt>
                <c:pt idx="1">
                  <c:v>78.248913249900994</c:v>
                </c:pt>
                <c:pt idx="2">
                  <c:v>73.515919037525649</c:v>
                </c:pt>
                <c:pt idx="3">
                  <c:v>84.247648602797597</c:v>
                </c:pt>
                <c:pt idx="4">
                  <c:v>103.527370710096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3B1-44C9-909D-B350C64763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1080840"/>
        <c:axId val="-2120750648"/>
      </c:scatterChart>
      <c:valAx>
        <c:axId val="-2121080840"/>
        <c:scaling>
          <c:orientation val="minMax"/>
          <c:max val="1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0750648"/>
        <c:crosses val="autoZero"/>
        <c:crossBetween val="midCat"/>
        <c:majorUnit val="30"/>
      </c:valAx>
      <c:valAx>
        <c:axId val="-2120750648"/>
        <c:scaling>
          <c:orientation val="minMax"/>
          <c:max val="1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1080840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535</cdr:x>
      <cdr:y>0.55896</cdr:y>
    </cdr:from>
    <cdr:to>
      <cdr:x>0.41611</cdr:x>
      <cdr:y>0.66897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9B6AA4D1-B75C-4E98-9BBF-ECEB8BA54BE4}"/>
            </a:ext>
          </a:extLst>
        </cdr:cNvPr>
        <cdr:cNvSpPr txBox="1"/>
      </cdr:nvSpPr>
      <cdr:spPr>
        <a:xfrm xmlns:a="http://schemas.openxmlformats.org/drawingml/2006/main">
          <a:off x="647163" y="1066498"/>
          <a:ext cx="296576" cy="2098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*</a:t>
          </a:r>
        </a:p>
      </cdr:txBody>
    </cdr:sp>
  </cdr:relSizeAnchor>
  <cdr:relSizeAnchor xmlns:cdr="http://schemas.openxmlformats.org/drawingml/2006/chartDrawing">
    <cdr:from>
      <cdr:x>0.45194</cdr:x>
      <cdr:y>0.68123</cdr:y>
    </cdr:from>
    <cdr:to>
      <cdr:x>0.62208</cdr:x>
      <cdr:y>0.80728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A9F53D87-20E7-4F2F-8152-3D2CFED76276}"/>
            </a:ext>
          </a:extLst>
        </cdr:cNvPr>
        <cdr:cNvSpPr txBox="1"/>
      </cdr:nvSpPr>
      <cdr:spPr>
        <a:xfrm xmlns:a="http://schemas.openxmlformats.org/drawingml/2006/main">
          <a:off x="1025012" y="1299793"/>
          <a:ext cx="385856" cy="2405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r>
            <a:rPr lang="en-US" altLang="ja-JP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r>
            <a:rPr lang="ja-JP" altLang="en-US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6888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275" y="0"/>
            <a:ext cx="430847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92ACE9-AE48-411F-9052-DA84BD61E3DD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56075" y="850900"/>
            <a:ext cx="16271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775" y="3276600"/>
            <a:ext cx="7951788" cy="26797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888"/>
            <a:ext cx="4306888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275" y="6465888"/>
            <a:ext cx="430847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7E80A0-0227-4DD0-B1D3-22DB5800F6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377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4156075" y="850900"/>
            <a:ext cx="1627188" cy="229711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正方形</a:t>
            </a:r>
            <a:endParaRPr kumimoji="1" lang="en-US" altLang="ja-JP" dirty="0"/>
          </a:p>
          <a:p>
            <a:r>
              <a:rPr kumimoji="1" lang="ja-JP" altLang="en-US" dirty="0"/>
              <a:t>●、▲サイズ：</a:t>
            </a:r>
            <a:r>
              <a:rPr kumimoji="1" lang="en-US" altLang="ja-JP" dirty="0"/>
              <a:t>φ2.5*2.5</a:t>
            </a:r>
          </a:p>
          <a:p>
            <a:r>
              <a:rPr kumimoji="1" lang="en-US" altLang="ja-JP" dirty="0"/>
              <a:t>#: </a:t>
            </a:r>
            <a:r>
              <a:rPr kumimoji="1" lang="ja-JP" altLang="en-US" dirty="0"/>
              <a:t>フォント</a:t>
            </a:r>
            <a:r>
              <a:rPr kumimoji="1" lang="en-US" altLang="ja-JP" dirty="0"/>
              <a:t>9</a:t>
            </a:r>
            <a:r>
              <a:rPr kumimoji="1" lang="ja-JP" altLang="en-US" dirty="0"/>
              <a:t>　＊：フォント</a:t>
            </a:r>
            <a:r>
              <a:rPr kumimoji="1" lang="en-US" altLang="ja-JP" dirty="0"/>
              <a:t>1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7E80A0-0227-4DD0-B1D3-22DB5800F65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620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96484"/>
            <a:ext cx="5508149" cy="3183467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802717"/>
            <a:ext cx="4860131" cy="220768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3205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8900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86834"/>
            <a:ext cx="1397288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86834"/>
            <a:ext cx="4110861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035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820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79653"/>
            <a:ext cx="5589151" cy="3803649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119286"/>
            <a:ext cx="5589151" cy="2000249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5401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434167"/>
            <a:ext cx="2754074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434167"/>
            <a:ext cx="2754074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55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86836"/>
            <a:ext cx="5589151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41551"/>
            <a:ext cx="2741417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340100"/>
            <a:ext cx="2741417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41551"/>
            <a:ext cx="2754918" cy="1098549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340100"/>
            <a:ext cx="2754918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292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7129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18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16569"/>
            <a:ext cx="3280589" cy="6498167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036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09600"/>
            <a:ext cx="2090025" cy="21336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16569"/>
            <a:ext cx="3280589" cy="6498167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743200"/>
            <a:ext cx="2090025" cy="508211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268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86836"/>
            <a:ext cx="5589151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434167"/>
            <a:ext cx="5589151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09751-9FB1-4299-A9D8-D3A966FEBEA4}" type="datetimeFigureOut">
              <a:rPr kumimoji="1" lang="ja-JP" altLang="en-US" smtClean="0"/>
              <a:t>2022/6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475136"/>
            <a:ext cx="218705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475136"/>
            <a:ext cx="1458039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429DC-F027-4EE8-8EB9-3133081FB1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10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kumimoji="1"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2.emf"/><Relationship Id="rId7" Type="http://schemas.openxmlformats.org/officeDocument/2006/relationships/chart" Target="../charts/chart3.xml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image" Target="../media/image3.emf"/><Relationship Id="rId10" Type="http://schemas.openxmlformats.org/officeDocument/2006/relationships/image" Target="../media/image4.emf"/><Relationship Id="rId4" Type="http://schemas.openxmlformats.org/officeDocument/2006/relationships/oleObject" Target="../embeddings/oleObject4.bin"/><Relationship Id="rId9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9" name="グラフ 58">
            <a:extLst>
              <a:ext uri="{FF2B5EF4-FFF2-40B4-BE49-F238E27FC236}">
                <a16:creationId xmlns:a16="http://schemas.microsoft.com/office/drawing/2014/main" id="{5F2B1B1A-81AD-4886-97A9-C5C54761D1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8284388"/>
              </p:ext>
            </p:extLst>
          </p:nvPr>
        </p:nvGraphicFramePr>
        <p:xfrm>
          <a:off x="-83586" y="725999"/>
          <a:ext cx="3539656" cy="27262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3" name="オブジェクト 62">
            <a:extLst>
              <a:ext uri="{FF2B5EF4-FFF2-40B4-BE49-F238E27FC236}">
                <a16:creationId xmlns:a16="http://schemas.microsoft.com/office/drawing/2014/main" id="{DE86075E-1DFA-422F-8A01-E4E4C80EE3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9919771"/>
              </p:ext>
            </p:extLst>
          </p:nvPr>
        </p:nvGraphicFramePr>
        <p:xfrm>
          <a:off x="3284538" y="643818"/>
          <a:ext cx="3270250" cy="241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254907" imgH="2258936" progId="Prism9.Document">
                  <p:embed/>
                </p:oleObj>
              </mc:Choice>
              <mc:Fallback>
                <p:oleObj name="Prism 9" r:id="rId4" imgW="3254907" imgH="2258936" progId="Prism9.Document">
                  <p:embed/>
                  <p:pic>
                    <p:nvPicPr>
                      <p:cNvPr id="63" name="オブジェクト 62">
                        <a:extLst>
                          <a:ext uri="{FF2B5EF4-FFF2-40B4-BE49-F238E27FC236}">
                            <a16:creationId xmlns:a16="http://schemas.microsoft.com/office/drawing/2014/main" id="{DE86075E-1DFA-422F-8A01-E4E4C80EE3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84538" y="643818"/>
                        <a:ext cx="3270250" cy="2416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40AAD39-F51F-404A-93CF-AE66632F8B70}"/>
              </a:ext>
            </a:extLst>
          </p:cNvPr>
          <p:cNvSpPr txBox="1"/>
          <p:nvPr/>
        </p:nvSpPr>
        <p:spPr>
          <a:xfrm>
            <a:off x="-1" y="7348"/>
            <a:ext cx="3185590" cy="354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0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sz="1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71B2D2E-B848-4A26-B14B-930FCBE7428D}"/>
              </a:ext>
            </a:extLst>
          </p:cNvPr>
          <p:cNvSpPr txBox="1"/>
          <p:nvPr/>
        </p:nvSpPr>
        <p:spPr>
          <a:xfrm>
            <a:off x="-33931" y="343302"/>
            <a:ext cx="446779" cy="325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12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51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5AE7CEA-DCCE-4D63-99A9-F37936C5C8A5}"/>
              </a:ext>
            </a:extLst>
          </p:cNvPr>
          <p:cNvSpPr txBox="1"/>
          <p:nvPr/>
        </p:nvSpPr>
        <p:spPr>
          <a:xfrm>
            <a:off x="3142809" y="350175"/>
            <a:ext cx="518414" cy="325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12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51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B208341-4A76-4684-A4D8-7465684F27FB}"/>
              </a:ext>
            </a:extLst>
          </p:cNvPr>
          <p:cNvSpPr txBox="1"/>
          <p:nvPr/>
        </p:nvSpPr>
        <p:spPr>
          <a:xfrm rot="16200000">
            <a:off x="-906434" y="1770902"/>
            <a:ext cx="20693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0785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nergy intake (kcal/day/mouse)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1A7611B-94C2-479D-B279-E2630F31AA97}"/>
              </a:ext>
            </a:extLst>
          </p:cNvPr>
          <p:cNvSpPr txBox="1"/>
          <p:nvPr/>
        </p:nvSpPr>
        <p:spPr>
          <a:xfrm>
            <a:off x="1229160" y="3071928"/>
            <a:ext cx="1555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80785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ge (weeks old)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332FE356-44AA-4730-A159-E3E4952EC85B}"/>
              </a:ext>
            </a:extLst>
          </p:cNvPr>
          <p:cNvGrpSpPr/>
          <p:nvPr/>
        </p:nvGrpSpPr>
        <p:grpSpPr>
          <a:xfrm>
            <a:off x="3992001" y="2898375"/>
            <a:ext cx="2305615" cy="249777"/>
            <a:chOff x="4390395" y="4203139"/>
            <a:chExt cx="2440033" cy="264340"/>
          </a:xfrm>
        </p:grpSpPr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27D148AF-13E9-4AF1-B8E5-1414350413F9}"/>
                </a:ext>
              </a:extLst>
            </p:cNvPr>
            <p:cNvSpPr txBox="1"/>
            <p:nvPr/>
          </p:nvSpPr>
          <p:spPr>
            <a:xfrm>
              <a:off x="4390395" y="4203139"/>
              <a:ext cx="474126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4E325CAF-3D95-4519-B3D0-B9836EF6F6BC}"/>
                </a:ext>
              </a:extLst>
            </p:cNvPr>
            <p:cNvSpPr txBox="1"/>
            <p:nvPr/>
          </p:nvSpPr>
          <p:spPr>
            <a:xfrm>
              <a:off x="5310817" y="4206902"/>
              <a:ext cx="549132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C03161B-7A5D-465A-9E41-6FDC92F448C7}"/>
                </a:ext>
              </a:extLst>
            </p:cNvPr>
            <p:cNvSpPr txBox="1"/>
            <p:nvPr/>
          </p:nvSpPr>
          <p:spPr>
            <a:xfrm>
              <a:off x="6281297" y="4206072"/>
              <a:ext cx="549131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6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BF97AED-2943-4AFC-AC8E-AFC48712772B}"/>
              </a:ext>
            </a:extLst>
          </p:cNvPr>
          <p:cNvSpPr txBox="1"/>
          <p:nvPr/>
        </p:nvSpPr>
        <p:spPr>
          <a:xfrm rot="16200000">
            <a:off x="2560672" y="1394602"/>
            <a:ext cx="1496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otal GIP (</a:t>
            </a:r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DE87015-5FD8-4355-9628-D1D448ED0BE1}"/>
              </a:ext>
            </a:extLst>
          </p:cNvPr>
          <p:cNvSpPr txBox="1"/>
          <p:nvPr/>
        </p:nvSpPr>
        <p:spPr>
          <a:xfrm>
            <a:off x="4851331" y="703871"/>
            <a:ext cx="234413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FE02AA7-E116-4A1D-8CF9-30BF544D3F3A}"/>
              </a:ext>
            </a:extLst>
          </p:cNvPr>
          <p:cNvSpPr txBox="1"/>
          <p:nvPr/>
        </p:nvSpPr>
        <p:spPr>
          <a:xfrm>
            <a:off x="5746311" y="705902"/>
            <a:ext cx="387198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3E95F4BA-A588-4E33-B207-4D643C2BA65E}"/>
              </a:ext>
            </a:extLst>
          </p:cNvPr>
          <p:cNvGrpSpPr/>
          <p:nvPr/>
        </p:nvGrpSpPr>
        <p:grpSpPr>
          <a:xfrm>
            <a:off x="4774560" y="863728"/>
            <a:ext cx="406376" cy="645782"/>
            <a:chOff x="5059564" y="4032028"/>
            <a:chExt cx="372509" cy="683434"/>
          </a:xfrm>
        </p:grpSpPr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C87AFCD5-1AA3-4DFD-BF96-BE8C1373BF9A}"/>
                </a:ext>
              </a:extLst>
            </p:cNvPr>
            <p:cNvCxnSpPr/>
            <p:nvPr/>
          </p:nvCxnSpPr>
          <p:spPr>
            <a:xfrm>
              <a:off x="5059564" y="4044999"/>
              <a:ext cx="37250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59415A56-83D1-4E01-8023-78067A453C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63540" y="4040200"/>
              <a:ext cx="0" cy="937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14AB4FB3-7C25-4566-8CFE-8131B15648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31552" y="4032028"/>
              <a:ext cx="0" cy="937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512F4DA6-D73E-43FE-99BA-57746EADA79C}"/>
                </a:ext>
              </a:extLst>
            </p:cNvPr>
            <p:cNvCxnSpPr/>
            <p:nvPr/>
          </p:nvCxnSpPr>
          <p:spPr>
            <a:xfrm>
              <a:off x="5063540" y="4125785"/>
              <a:ext cx="0" cy="58967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38C42D6B-575E-4BE3-8E40-E04696ECC77B}"/>
              </a:ext>
            </a:extLst>
          </p:cNvPr>
          <p:cNvGrpSpPr/>
          <p:nvPr/>
        </p:nvGrpSpPr>
        <p:grpSpPr>
          <a:xfrm>
            <a:off x="5693953" y="865224"/>
            <a:ext cx="406375" cy="645782"/>
            <a:chOff x="5059564" y="4032028"/>
            <a:chExt cx="372509" cy="683434"/>
          </a:xfrm>
        </p:grpSpPr>
        <p:cxnSp>
          <p:nvCxnSpPr>
            <p:cNvPr id="191" name="直線コネクタ 190">
              <a:extLst>
                <a:ext uri="{FF2B5EF4-FFF2-40B4-BE49-F238E27FC236}">
                  <a16:creationId xmlns:a16="http://schemas.microsoft.com/office/drawing/2014/main" id="{5771D7DC-813B-443C-B224-864332E90732}"/>
                </a:ext>
              </a:extLst>
            </p:cNvPr>
            <p:cNvCxnSpPr/>
            <p:nvPr/>
          </p:nvCxnSpPr>
          <p:spPr>
            <a:xfrm>
              <a:off x="5059564" y="4044999"/>
              <a:ext cx="37250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3" name="直線コネクタ 192">
              <a:extLst>
                <a:ext uri="{FF2B5EF4-FFF2-40B4-BE49-F238E27FC236}">
                  <a16:creationId xmlns:a16="http://schemas.microsoft.com/office/drawing/2014/main" id="{C83C576C-9A35-473E-9443-87AA950177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63540" y="4040200"/>
              <a:ext cx="0" cy="937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9" name="直線コネクタ 208">
              <a:extLst>
                <a:ext uri="{FF2B5EF4-FFF2-40B4-BE49-F238E27FC236}">
                  <a16:creationId xmlns:a16="http://schemas.microsoft.com/office/drawing/2014/main" id="{F7796317-0EF6-4611-AFEA-D93B34C4D4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31552" y="4032028"/>
              <a:ext cx="0" cy="937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0" name="直線コネクタ 209">
              <a:extLst>
                <a:ext uri="{FF2B5EF4-FFF2-40B4-BE49-F238E27FC236}">
                  <a16:creationId xmlns:a16="http://schemas.microsoft.com/office/drawing/2014/main" id="{8C9E74F9-BBE6-4962-89E2-0F29A0AFF06A}"/>
                </a:ext>
              </a:extLst>
            </p:cNvPr>
            <p:cNvCxnSpPr/>
            <p:nvPr/>
          </p:nvCxnSpPr>
          <p:spPr>
            <a:xfrm>
              <a:off x="5063540" y="4125785"/>
              <a:ext cx="0" cy="589677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E560655-51F0-4D75-AD7D-B72CE33F8A55}"/>
              </a:ext>
            </a:extLst>
          </p:cNvPr>
          <p:cNvGrpSpPr/>
          <p:nvPr/>
        </p:nvGrpSpPr>
        <p:grpSpPr>
          <a:xfrm>
            <a:off x="3306038" y="796109"/>
            <a:ext cx="507710" cy="2206279"/>
            <a:chOff x="3725884" y="2634684"/>
            <a:chExt cx="461040" cy="2266173"/>
          </a:xfrm>
          <a:noFill/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118452EF-E90F-4536-971F-9E8C451AFAC9}"/>
                </a:ext>
              </a:extLst>
            </p:cNvPr>
            <p:cNvSpPr txBox="1"/>
            <p:nvPr/>
          </p:nvSpPr>
          <p:spPr>
            <a:xfrm>
              <a:off x="3725888" y="2634684"/>
              <a:ext cx="460648" cy="260577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785">
                <a:defRPr/>
              </a:pPr>
              <a:r>
                <a:rPr kumimoji="1" lang="en-US" altLang="ja-JP" sz="1000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400</a:t>
              </a:r>
              <a:endParaRPr kumimoji="1" lang="ja-JP" altLang="en-US" sz="10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4E39B414-83CE-416A-BAE4-A3CD375088AC}"/>
                </a:ext>
              </a:extLst>
            </p:cNvPr>
            <p:cNvSpPr txBox="1"/>
            <p:nvPr/>
          </p:nvSpPr>
          <p:spPr>
            <a:xfrm>
              <a:off x="3726276" y="3128808"/>
              <a:ext cx="460648" cy="260577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785">
                <a:defRPr/>
              </a:pPr>
              <a:r>
                <a:rPr kumimoji="1" lang="en-US" altLang="ja-JP" sz="1000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300</a:t>
              </a:r>
              <a:endParaRPr kumimoji="1" lang="ja-JP" altLang="en-US" sz="10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0942F2E4-7916-41F6-94AC-59AF664C241C}"/>
                </a:ext>
              </a:extLst>
            </p:cNvPr>
            <p:cNvSpPr txBox="1"/>
            <p:nvPr/>
          </p:nvSpPr>
          <p:spPr>
            <a:xfrm>
              <a:off x="3726274" y="3639448"/>
              <a:ext cx="460648" cy="260577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785">
                <a:defRPr/>
              </a:pPr>
              <a:r>
                <a:rPr kumimoji="1" lang="en-US" altLang="ja-JP" sz="1000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200</a:t>
              </a:r>
              <a:endParaRPr kumimoji="1" lang="ja-JP" altLang="en-US" sz="10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FF49317-0334-48D1-8CED-79C04399CDF4}"/>
                </a:ext>
              </a:extLst>
            </p:cNvPr>
            <p:cNvSpPr txBox="1"/>
            <p:nvPr/>
          </p:nvSpPr>
          <p:spPr>
            <a:xfrm>
              <a:off x="3725884" y="4137622"/>
              <a:ext cx="460648" cy="260577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785">
                <a:defRPr/>
              </a:pPr>
              <a:r>
                <a:rPr kumimoji="1" lang="en-US" altLang="ja-JP" sz="1000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100</a:t>
              </a:r>
              <a:endParaRPr kumimoji="1" lang="ja-JP" altLang="en-US" sz="10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C0F87538-DD7B-4922-A896-DA94BBDDBD0F}"/>
                </a:ext>
              </a:extLst>
            </p:cNvPr>
            <p:cNvSpPr txBox="1"/>
            <p:nvPr/>
          </p:nvSpPr>
          <p:spPr>
            <a:xfrm>
              <a:off x="3838948" y="4640281"/>
              <a:ext cx="294938" cy="260576"/>
            </a:xfrm>
            <a:prstGeom prst="rect">
              <a:avLst/>
            </a:prstGeom>
            <a:grp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785">
                <a:defRPr/>
              </a:pPr>
              <a:r>
                <a:rPr kumimoji="1" lang="en-US" altLang="ja-JP" sz="1000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0</a:t>
              </a:r>
              <a:endParaRPr kumimoji="1" lang="ja-JP" altLang="en-US" sz="1000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4108CF6E-E43F-763E-1C37-B4BE69DE3CE7}"/>
              </a:ext>
            </a:extLst>
          </p:cNvPr>
          <p:cNvGrpSpPr/>
          <p:nvPr/>
        </p:nvGrpSpPr>
        <p:grpSpPr>
          <a:xfrm>
            <a:off x="163613" y="3497510"/>
            <a:ext cx="6424478" cy="355921"/>
            <a:chOff x="118088" y="8843379"/>
            <a:chExt cx="6424478" cy="355921"/>
          </a:xfrm>
        </p:grpSpPr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id="{A175DA00-22FD-2764-B7C1-6A3455F3CC3C}"/>
                </a:ext>
              </a:extLst>
            </p:cNvPr>
            <p:cNvGrpSpPr/>
            <p:nvPr/>
          </p:nvGrpSpPr>
          <p:grpSpPr>
            <a:xfrm>
              <a:off x="118088" y="8843379"/>
              <a:ext cx="6424478" cy="355921"/>
              <a:chOff x="112941" y="2112476"/>
              <a:chExt cx="6799056" cy="376672"/>
            </a:xfrm>
          </p:grpSpPr>
          <p:grpSp>
            <p:nvGrpSpPr>
              <p:cNvPr id="90" name="グループ化 89">
                <a:extLst>
                  <a:ext uri="{FF2B5EF4-FFF2-40B4-BE49-F238E27FC236}">
                    <a16:creationId xmlns:a16="http://schemas.microsoft.com/office/drawing/2014/main" id="{4A4884D8-9B04-9804-CF4F-C77101578D3A}"/>
                  </a:ext>
                </a:extLst>
              </p:cNvPr>
              <p:cNvGrpSpPr/>
              <p:nvPr/>
            </p:nvGrpSpPr>
            <p:grpSpPr>
              <a:xfrm>
                <a:off x="112941" y="2124050"/>
                <a:ext cx="1610799" cy="282427"/>
                <a:chOff x="1442568" y="1757917"/>
                <a:chExt cx="1610799" cy="282427"/>
              </a:xfrm>
            </p:grpSpPr>
            <p:grpSp>
              <p:nvGrpSpPr>
                <p:cNvPr id="108" name="グループ化 107">
                  <a:extLst>
                    <a:ext uri="{FF2B5EF4-FFF2-40B4-BE49-F238E27FC236}">
                      <a16:creationId xmlns:a16="http://schemas.microsoft.com/office/drawing/2014/main" id="{9FA262B1-D815-DEFB-CDC2-C2019CCEDEF6}"/>
                    </a:ext>
                  </a:extLst>
                </p:cNvPr>
                <p:cNvGrpSpPr/>
                <p:nvPr/>
              </p:nvGrpSpPr>
              <p:grpSpPr>
                <a:xfrm>
                  <a:off x="1924052" y="1757917"/>
                  <a:ext cx="1129315" cy="282427"/>
                  <a:chOff x="689846" y="5008614"/>
                  <a:chExt cx="1129315" cy="282427"/>
                </a:xfrm>
              </p:grpSpPr>
              <p:sp>
                <p:nvSpPr>
                  <p:cNvPr id="112" name="正方形/長方形 111">
                    <a:extLst>
                      <a:ext uri="{FF2B5EF4-FFF2-40B4-BE49-F238E27FC236}">
                        <a16:creationId xmlns:a16="http://schemas.microsoft.com/office/drawing/2014/main" id="{8CCEB549-6ED1-1187-1DAB-27C1C7BB8956}"/>
                      </a:ext>
                    </a:extLst>
                  </p:cNvPr>
                  <p:cNvSpPr/>
                  <p:nvPr/>
                </p:nvSpPr>
                <p:spPr>
                  <a:xfrm>
                    <a:off x="689846" y="5061435"/>
                    <a:ext cx="178986" cy="178986"/>
                  </a:xfrm>
                  <a:prstGeom prst="rect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0785">
                      <a:defRPr/>
                    </a:pPr>
                    <a:endParaRPr kumimoji="1" lang="ja-JP" altLang="en-US" sz="2357" kern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3" name="テキスト ボックス 112">
                    <a:extLst>
                      <a:ext uri="{FF2B5EF4-FFF2-40B4-BE49-F238E27FC236}">
                        <a16:creationId xmlns:a16="http://schemas.microsoft.com/office/drawing/2014/main" id="{2C0F88D9-7835-6D86-6101-D1FFD447AC0F}"/>
                      </a:ext>
                    </a:extLst>
                  </p:cNvPr>
                  <p:cNvSpPr txBox="1"/>
                  <p:nvPr/>
                </p:nvSpPr>
                <p:spPr>
                  <a:xfrm>
                    <a:off x="880759" y="5008614"/>
                    <a:ext cx="938402" cy="28242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defTabSz="80785">
                      <a:defRPr/>
                    </a:pPr>
                    <a:r>
                      <a:rPr kumimoji="1" lang="en-US" altLang="ja-JP" sz="1134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rPr>
                      <a:t>WT+CFD</a:t>
                    </a:r>
                    <a:endParaRPr kumimoji="1" lang="ja-JP" altLang="en-US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09" name="グループ化 108">
                  <a:extLst>
                    <a:ext uri="{FF2B5EF4-FFF2-40B4-BE49-F238E27FC236}">
                      <a16:creationId xmlns:a16="http://schemas.microsoft.com/office/drawing/2014/main" id="{6D8F82EC-5078-6FB9-A417-99DC24C4672F}"/>
                    </a:ext>
                  </a:extLst>
                </p:cNvPr>
                <p:cNvGrpSpPr/>
                <p:nvPr/>
              </p:nvGrpSpPr>
              <p:grpSpPr>
                <a:xfrm>
                  <a:off x="1442568" y="1834347"/>
                  <a:ext cx="342769" cy="131769"/>
                  <a:chOff x="2856312" y="5187944"/>
                  <a:chExt cx="342769" cy="131769"/>
                </a:xfrm>
              </p:grpSpPr>
              <p:cxnSp>
                <p:nvCxnSpPr>
                  <p:cNvPr id="110" name="直線コネクタ 109">
                    <a:extLst>
                      <a:ext uri="{FF2B5EF4-FFF2-40B4-BE49-F238E27FC236}">
                        <a16:creationId xmlns:a16="http://schemas.microsoft.com/office/drawing/2014/main" id="{9259F01D-465A-A374-4F31-EEDAAC9E9FFB}"/>
                      </a:ext>
                    </a:extLst>
                  </p:cNvPr>
                  <p:cNvCxnSpPr/>
                  <p:nvPr/>
                </p:nvCxnSpPr>
                <p:spPr>
                  <a:xfrm>
                    <a:off x="2856312" y="5253828"/>
                    <a:ext cx="342769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lgDashDot"/>
                  </a:ln>
                  <a:effectLst/>
                </p:spPr>
              </p:cxnSp>
              <p:sp>
                <p:nvSpPr>
                  <p:cNvPr id="111" name="円/楕円 171">
                    <a:extLst>
                      <a:ext uri="{FF2B5EF4-FFF2-40B4-BE49-F238E27FC236}">
                        <a16:creationId xmlns:a16="http://schemas.microsoft.com/office/drawing/2014/main" id="{A680E79C-D5B6-CE79-3F4A-7D9402567EE1}"/>
                      </a:ext>
                    </a:extLst>
                  </p:cNvPr>
                  <p:cNvSpPr/>
                  <p:nvPr/>
                </p:nvSpPr>
                <p:spPr>
                  <a:xfrm>
                    <a:off x="2961812" y="5187944"/>
                    <a:ext cx="131769" cy="131769"/>
                  </a:xfrm>
                  <a:prstGeom prst="ellipse">
                    <a:avLst/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64017">
                      <a:defRPr/>
                    </a:pPr>
                    <a:endParaRPr lang="ja-JP" altLang="en-US" sz="992" b="1" kern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1" name="グループ化 90">
                <a:extLst>
                  <a:ext uri="{FF2B5EF4-FFF2-40B4-BE49-F238E27FC236}">
                    <a16:creationId xmlns:a16="http://schemas.microsoft.com/office/drawing/2014/main" id="{18494DA5-E4C3-8427-D019-8B575195B1D4}"/>
                  </a:ext>
                </a:extLst>
              </p:cNvPr>
              <p:cNvGrpSpPr/>
              <p:nvPr/>
            </p:nvGrpSpPr>
            <p:grpSpPr>
              <a:xfrm>
                <a:off x="1731328" y="2112476"/>
                <a:ext cx="1761294" cy="359313"/>
                <a:chOff x="1442568" y="2112476"/>
                <a:chExt cx="1761294" cy="359313"/>
              </a:xfrm>
            </p:grpSpPr>
            <p:grpSp>
              <p:nvGrpSpPr>
                <p:cNvPr id="102" name="グループ化 101">
                  <a:extLst>
                    <a:ext uri="{FF2B5EF4-FFF2-40B4-BE49-F238E27FC236}">
                      <a16:creationId xmlns:a16="http://schemas.microsoft.com/office/drawing/2014/main" id="{744B5B8A-0738-0A35-C62C-0568E5618292}"/>
                    </a:ext>
                  </a:extLst>
                </p:cNvPr>
                <p:cNvGrpSpPr/>
                <p:nvPr/>
              </p:nvGrpSpPr>
              <p:grpSpPr>
                <a:xfrm>
                  <a:off x="1924052" y="2112476"/>
                  <a:ext cx="1279810" cy="359313"/>
                  <a:chOff x="689846" y="5363173"/>
                  <a:chExt cx="1279810" cy="359313"/>
                </a:xfrm>
              </p:grpSpPr>
              <p:sp>
                <p:nvSpPr>
                  <p:cNvPr id="106" name="正方形/長方形 105">
                    <a:extLst>
                      <a:ext uri="{FF2B5EF4-FFF2-40B4-BE49-F238E27FC236}">
                        <a16:creationId xmlns:a16="http://schemas.microsoft.com/office/drawing/2014/main" id="{34754232-C346-08A6-B74A-A22EA51C2020}"/>
                      </a:ext>
                    </a:extLst>
                  </p:cNvPr>
                  <p:cNvSpPr/>
                  <p:nvPr/>
                </p:nvSpPr>
                <p:spPr>
                  <a:xfrm>
                    <a:off x="689846" y="5417374"/>
                    <a:ext cx="178986" cy="180645"/>
                  </a:xfrm>
                  <a:prstGeom prst="rect">
                    <a:avLst/>
                  </a:prstGeom>
                  <a:pattFill prst="pct10">
                    <a:fgClr>
                      <a:sysClr val="windowText" lastClr="000000"/>
                    </a:fgClr>
                    <a:bgClr>
                      <a:sysClr val="window" lastClr="FFFFFF"/>
                    </a:bgClr>
                  </a:pattFill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0785">
                      <a:defRPr/>
                    </a:pPr>
                    <a:endParaRPr kumimoji="1" lang="ja-JP" altLang="en-US" sz="2357" kern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7" name="テキスト ボックス 106">
                    <a:extLst>
                      <a:ext uri="{FF2B5EF4-FFF2-40B4-BE49-F238E27FC236}">
                        <a16:creationId xmlns:a16="http://schemas.microsoft.com/office/drawing/2014/main" id="{1B25B1B7-62E3-463A-8837-55BEDA9A3D39}"/>
                      </a:ext>
                    </a:extLst>
                  </p:cNvPr>
                  <p:cNvSpPr txBox="1"/>
                  <p:nvPr/>
                </p:nvSpPr>
                <p:spPr>
                  <a:xfrm>
                    <a:off x="880759" y="5363173"/>
                    <a:ext cx="1088897" cy="359313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defTabSz="80785">
                      <a:defRPr/>
                    </a:pPr>
                    <a:r>
                      <a:rPr kumimoji="1" lang="en-US" altLang="ja-JP" sz="1134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rPr>
                      <a:t>GIP</a:t>
                    </a:r>
                    <a:r>
                      <a:rPr kumimoji="1" lang="en-US" altLang="ja-JP" sz="1134" kern="0" baseline="30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rPr>
                      <a:t>-/-</a:t>
                    </a:r>
                    <a:r>
                      <a:rPr kumimoji="1" lang="en-US" altLang="ja-JP" sz="1134" kern="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rPr>
                      <a:t>+CFD</a:t>
                    </a:r>
                    <a:endParaRPr kumimoji="1" lang="ja-JP" altLang="en-US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  <a:p>
                    <a:pPr defTabSz="80785">
                      <a:defRPr/>
                    </a:pPr>
                    <a:endParaRPr kumimoji="1" lang="ja-JP" altLang="en-US" sz="472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03" name="グループ化 102">
                  <a:extLst>
                    <a:ext uri="{FF2B5EF4-FFF2-40B4-BE49-F238E27FC236}">
                      <a16:creationId xmlns:a16="http://schemas.microsoft.com/office/drawing/2014/main" id="{753662D2-6C5A-C671-3B8F-BB5EEF4931EE}"/>
                    </a:ext>
                  </a:extLst>
                </p:cNvPr>
                <p:cNvGrpSpPr/>
                <p:nvPr/>
              </p:nvGrpSpPr>
              <p:grpSpPr>
                <a:xfrm>
                  <a:off x="1442568" y="2191115"/>
                  <a:ext cx="342769" cy="131769"/>
                  <a:chOff x="2856312" y="5566178"/>
                  <a:chExt cx="342769" cy="131769"/>
                </a:xfrm>
              </p:grpSpPr>
              <p:cxnSp>
                <p:nvCxnSpPr>
                  <p:cNvPr id="104" name="直線コネクタ 103">
                    <a:extLst>
                      <a:ext uri="{FF2B5EF4-FFF2-40B4-BE49-F238E27FC236}">
                        <a16:creationId xmlns:a16="http://schemas.microsoft.com/office/drawing/2014/main" id="{6653EE82-7E57-3A42-9724-A2C240B44F33}"/>
                      </a:ext>
                    </a:extLst>
                  </p:cNvPr>
                  <p:cNvCxnSpPr/>
                  <p:nvPr/>
                </p:nvCxnSpPr>
                <p:spPr>
                  <a:xfrm>
                    <a:off x="2856312" y="5632062"/>
                    <a:ext cx="342769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dash"/>
                  </a:ln>
                  <a:effectLst/>
                </p:spPr>
              </p:cxnSp>
              <p:sp>
                <p:nvSpPr>
                  <p:cNvPr id="105" name="二等辺三角形 104">
                    <a:extLst>
                      <a:ext uri="{FF2B5EF4-FFF2-40B4-BE49-F238E27FC236}">
                        <a16:creationId xmlns:a16="http://schemas.microsoft.com/office/drawing/2014/main" id="{5E09E698-CB95-E317-5172-C0E13605B4BA}"/>
                      </a:ext>
                    </a:extLst>
                  </p:cNvPr>
                  <p:cNvSpPr/>
                  <p:nvPr/>
                </p:nvSpPr>
                <p:spPr>
                  <a:xfrm>
                    <a:off x="2961812" y="5566178"/>
                    <a:ext cx="131769" cy="131769"/>
                  </a:xfrm>
                  <a:prstGeom prst="triangle">
                    <a:avLst>
                      <a:gd name="adj" fmla="val 46774"/>
                    </a:avLst>
                  </a:prstGeom>
                  <a:noFill/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63996">
                      <a:defRPr/>
                    </a:pPr>
                    <a:endParaRPr lang="ja-JP" altLang="en-US" sz="318" kern="0" dirty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2" name="グループ化 91">
                <a:extLst>
                  <a:ext uri="{FF2B5EF4-FFF2-40B4-BE49-F238E27FC236}">
                    <a16:creationId xmlns:a16="http://schemas.microsoft.com/office/drawing/2014/main" id="{E1B681D5-C3C6-7B72-AD8C-876B13A664C6}"/>
                  </a:ext>
                </a:extLst>
              </p:cNvPr>
              <p:cNvGrpSpPr/>
              <p:nvPr/>
            </p:nvGrpSpPr>
            <p:grpSpPr>
              <a:xfrm>
                <a:off x="3497951" y="2129837"/>
                <a:ext cx="2059509" cy="359311"/>
                <a:chOff x="1442568" y="2521827"/>
                <a:chExt cx="2059509" cy="359311"/>
              </a:xfrm>
            </p:grpSpPr>
            <p:sp>
              <p:nvSpPr>
                <p:cNvPr id="98" name="テキスト ボックス 97">
                  <a:extLst>
                    <a:ext uri="{FF2B5EF4-FFF2-40B4-BE49-F238E27FC236}">
                      <a16:creationId xmlns:a16="http://schemas.microsoft.com/office/drawing/2014/main" id="{7931B12F-DBCF-475D-866D-03C1B5274802}"/>
                    </a:ext>
                  </a:extLst>
                </p:cNvPr>
                <p:cNvSpPr txBox="1"/>
                <p:nvPr/>
              </p:nvSpPr>
              <p:spPr>
                <a:xfrm>
                  <a:off x="2114965" y="2521827"/>
                  <a:ext cx="1387112" cy="35931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80785">
                    <a:defRPr/>
                  </a:pP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WT+HFD</a:t>
                  </a:r>
                  <a:endParaRPr kumimoji="1" lang="ja-JP" altLang="en-US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  <a:p>
                  <a:pPr defTabSz="80785">
                    <a:defRPr/>
                  </a:pPr>
                  <a:endParaRPr kumimoji="1" lang="ja-JP" altLang="en-US" sz="472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9" name="グループ化 98">
                  <a:extLst>
                    <a:ext uri="{FF2B5EF4-FFF2-40B4-BE49-F238E27FC236}">
                      <a16:creationId xmlns:a16="http://schemas.microsoft.com/office/drawing/2014/main" id="{BD2054FE-0779-DE1C-21A3-6B2F29F3C414}"/>
                    </a:ext>
                  </a:extLst>
                </p:cNvPr>
                <p:cNvGrpSpPr/>
                <p:nvPr/>
              </p:nvGrpSpPr>
              <p:grpSpPr>
                <a:xfrm>
                  <a:off x="1442568" y="2597557"/>
                  <a:ext cx="342769" cy="131769"/>
                  <a:chOff x="2856312" y="6218472"/>
                  <a:chExt cx="342769" cy="131769"/>
                </a:xfrm>
              </p:grpSpPr>
              <p:cxnSp>
                <p:nvCxnSpPr>
                  <p:cNvPr id="100" name="直線コネクタ 99">
                    <a:extLst>
                      <a:ext uri="{FF2B5EF4-FFF2-40B4-BE49-F238E27FC236}">
                        <a16:creationId xmlns:a16="http://schemas.microsoft.com/office/drawing/2014/main" id="{BD90ECD9-63DC-0508-B07B-DA7BFDBF606A}"/>
                      </a:ext>
                    </a:extLst>
                  </p:cNvPr>
                  <p:cNvCxnSpPr/>
                  <p:nvPr/>
                </p:nvCxnSpPr>
                <p:spPr>
                  <a:xfrm>
                    <a:off x="2856312" y="6278458"/>
                    <a:ext cx="342769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sp>
                <p:nvSpPr>
                  <p:cNvPr id="101" name="円/楕円 171">
                    <a:extLst>
                      <a:ext uri="{FF2B5EF4-FFF2-40B4-BE49-F238E27FC236}">
                        <a16:creationId xmlns:a16="http://schemas.microsoft.com/office/drawing/2014/main" id="{7A623E14-49FB-356D-41CF-057AAA6ED5B0}"/>
                      </a:ext>
                    </a:extLst>
                  </p:cNvPr>
                  <p:cNvSpPr/>
                  <p:nvPr/>
                </p:nvSpPr>
                <p:spPr>
                  <a:xfrm>
                    <a:off x="2961812" y="6218472"/>
                    <a:ext cx="131769" cy="131769"/>
                  </a:xfrm>
                  <a:prstGeom prst="ellipse">
                    <a:avLst/>
                  </a:prstGeom>
                  <a:solidFill>
                    <a:sysClr val="windowText" lastClr="000000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64017">
                      <a:defRPr/>
                    </a:pPr>
                    <a:endParaRPr lang="ja-JP" altLang="en-US" sz="992" b="1" kern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3" name="グループ化 92">
                <a:extLst>
                  <a:ext uri="{FF2B5EF4-FFF2-40B4-BE49-F238E27FC236}">
                    <a16:creationId xmlns:a16="http://schemas.microsoft.com/office/drawing/2014/main" id="{01CCD6FA-DE14-BBC2-22BE-691AED6F40DF}"/>
                  </a:ext>
                </a:extLst>
              </p:cNvPr>
              <p:cNvGrpSpPr/>
              <p:nvPr/>
            </p:nvGrpSpPr>
            <p:grpSpPr>
              <a:xfrm>
                <a:off x="5115447" y="2129837"/>
                <a:ext cx="1796550" cy="359311"/>
                <a:chOff x="1442568" y="2904275"/>
                <a:chExt cx="1796550" cy="359311"/>
              </a:xfrm>
            </p:grpSpPr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B0F974F0-DD6B-0217-D668-E9158E8E3FC3}"/>
                    </a:ext>
                  </a:extLst>
                </p:cNvPr>
                <p:cNvSpPr txBox="1"/>
                <p:nvPr/>
              </p:nvSpPr>
              <p:spPr>
                <a:xfrm>
                  <a:off x="2109178" y="2904275"/>
                  <a:ext cx="1129940" cy="359311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80785">
                    <a:defRPr/>
                  </a:pP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GIP</a:t>
                  </a:r>
                  <a:r>
                    <a:rPr kumimoji="1" lang="en-US" altLang="ja-JP" sz="1134" kern="0" baseline="300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-/-</a:t>
                  </a: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+HFD</a:t>
                  </a:r>
                  <a:endParaRPr kumimoji="1" lang="ja-JP" altLang="en-US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  <a:p>
                  <a:pPr defTabSz="80785">
                    <a:defRPr/>
                  </a:pPr>
                  <a:endParaRPr kumimoji="1" lang="ja-JP" altLang="en-US" sz="472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5" name="グループ化 94">
                  <a:extLst>
                    <a:ext uri="{FF2B5EF4-FFF2-40B4-BE49-F238E27FC236}">
                      <a16:creationId xmlns:a16="http://schemas.microsoft.com/office/drawing/2014/main" id="{E781AC17-1548-FA62-BE7B-2FFCEC94FB34}"/>
                    </a:ext>
                  </a:extLst>
                </p:cNvPr>
                <p:cNvGrpSpPr/>
                <p:nvPr/>
              </p:nvGrpSpPr>
              <p:grpSpPr>
                <a:xfrm>
                  <a:off x="1442568" y="2980005"/>
                  <a:ext cx="342769" cy="131769"/>
                  <a:chOff x="2856312" y="5892750"/>
                  <a:chExt cx="342769" cy="131769"/>
                </a:xfrm>
              </p:grpSpPr>
              <p:cxnSp>
                <p:nvCxnSpPr>
                  <p:cNvPr id="96" name="直線コネクタ 95">
                    <a:extLst>
                      <a:ext uri="{FF2B5EF4-FFF2-40B4-BE49-F238E27FC236}">
                        <a16:creationId xmlns:a16="http://schemas.microsoft.com/office/drawing/2014/main" id="{C3ABBEC4-0FC4-3EB9-4DDA-4C7DDD0A1FF8}"/>
                      </a:ext>
                    </a:extLst>
                  </p:cNvPr>
                  <p:cNvCxnSpPr/>
                  <p:nvPr/>
                </p:nvCxnSpPr>
                <p:spPr>
                  <a:xfrm>
                    <a:off x="2856312" y="5958634"/>
                    <a:ext cx="342769" cy="0"/>
                  </a:xfrm>
                  <a:prstGeom prst="line">
                    <a:avLst/>
                  </a:prstGeom>
                  <a:noFill/>
                  <a:ln w="9525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</p:cxnSp>
              <p:sp>
                <p:nvSpPr>
                  <p:cNvPr id="97" name="二等辺三角形 96">
                    <a:extLst>
                      <a:ext uri="{FF2B5EF4-FFF2-40B4-BE49-F238E27FC236}">
                        <a16:creationId xmlns:a16="http://schemas.microsoft.com/office/drawing/2014/main" id="{E4F3F3E4-398B-6832-D9BD-EE5345AE3EE7}"/>
                      </a:ext>
                    </a:extLst>
                  </p:cNvPr>
                  <p:cNvSpPr/>
                  <p:nvPr/>
                </p:nvSpPr>
                <p:spPr>
                  <a:xfrm>
                    <a:off x="2961812" y="5892750"/>
                    <a:ext cx="131769" cy="131769"/>
                  </a:xfrm>
                  <a:prstGeom prst="triangle">
                    <a:avLst>
                      <a:gd name="adj" fmla="val 46774"/>
                    </a:avLst>
                  </a:prstGeom>
                  <a:solidFill>
                    <a:sysClr val="windowText" lastClr="000000"/>
                  </a:solidFill>
                  <a:ln w="12700" cap="flat" cmpd="sng" algn="ctr">
                    <a:solidFill>
                      <a:sysClr val="windowText" lastClr="000000"/>
                    </a:solidFill>
                    <a:prstDash val="solid"/>
                  </a:ln>
                  <a:effectLst/>
                </p:spPr>
                <p:txBody>
                  <a:bodyPr rtlCol="0" anchor="ctr"/>
                  <a:lstStyle/>
                  <a:p>
                    <a:pPr algn="ctr" defTabSz="863996">
                      <a:defRPr/>
                    </a:pPr>
                    <a:endParaRPr lang="ja-JP" altLang="en-US" sz="318" kern="0" dirty="0">
                      <a:solidFill>
                        <a:prstClr val="white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C84EEDC0-87D1-ED5D-3EEA-E3A496A2B083}"/>
                </a:ext>
              </a:extLst>
            </p:cNvPr>
            <p:cNvSpPr/>
            <p:nvPr/>
          </p:nvSpPr>
          <p:spPr>
            <a:xfrm>
              <a:off x="3773257" y="8883080"/>
              <a:ext cx="169125" cy="169125"/>
            </a:xfrm>
            <a:prstGeom prst="rect">
              <a:avLst/>
            </a:prstGeom>
            <a:solidFill>
              <a:sysClr val="window" lastClr="FFFFFF">
                <a:lumMod val="50000"/>
              </a:sysClr>
            </a:solidFill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80785">
                <a:defRPr/>
              </a:pPr>
              <a:endParaRPr kumimoji="1" lang="ja-JP" altLang="en-US" sz="2357" kern="0">
                <a:solidFill>
                  <a:prstClr val="white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BD1A3418-8FE7-2AEB-C41C-156BF9358A47}"/>
                </a:ext>
              </a:extLst>
            </p:cNvPr>
            <p:cNvSpPr/>
            <p:nvPr/>
          </p:nvSpPr>
          <p:spPr>
            <a:xfrm>
              <a:off x="5291978" y="8879848"/>
              <a:ext cx="169125" cy="170693"/>
            </a:xfrm>
            <a:prstGeom prst="rect">
              <a:avLst/>
            </a:prstGeom>
            <a:pattFill prst="smCheck">
              <a:fgClr>
                <a:schemeClr val="bg1">
                  <a:lumMod val="50000"/>
                </a:schemeClr>
              </a:fgClr>
              <a:bgClr>
                <a:sysClr val="window" lastClr="FFFFFF"/>
              </a:bgClr>
            </a:pattFill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algn="ctr" defTabSz="80785">
                <a:defRPr/>
              </a:pPr>
              <a:endParaRPr kumimoji="1" lang="ja-JP" altLang="en-US" sz="2357" kern="0">
                <a:solidFill>
                  <a:prstClr val="white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791344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479740A4-5D7C-46F0-B530-7CD57B2A28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637253"/>
              </p:ext>
            </p:extLst>
          </p:nvPr>
        </p:nvGraphicFramePr>
        <p:xfrm>
          <a:off x="96838" y="565150"/>
          <a:ext cx="3197225" cy="3009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196925" imgH="3010354" progId="Prism9.Document">
                  <p:embed/>
                </p:oleObj>
              </mc:Choice>
              <mc:Fallback>
                <p:oleObj name="Prism 9" r:id="rId2" imgW="3196925" imgH="3010354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479740A4-5D7C-46F0-B530-7CD57B2A28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6838" y="565150"/>
                        <a:ext cx="3197225" cy="3009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2F942C60-B2D7-4A3A-94BF-E68AE9EDE334}"/>
              </a:ext>
            </a:extLst>
          </p:cNvPr>
          <p:cNvGrpSpPr/>
          <p:nvPr/>
        </p:nvGrpSpPr>
        <p:grpSpPr>
          <a:xfrm>
            <a:off x="1424100" y="620856"/>
            <a:ext cx="780362" cy="1195143"/>
            <a:chOff x="1424100" y="2863573"/>
            <a:chExt cx="780362" cy="1195143"/>
          </a:xfrm>
        </p:grpSpPr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794928A0-29B2-4F78-BA5F-0E8ED6297B84}"/>
                </a:ext>
              </a:extLst>
            </p:cNvPr>
            <p:cNvSpPr txBox="1"/>
            <p:nvPr/>
          </p:nvSpPr>
          <p:spPr>
            <a:xfrm>
              <a:off x="1823823" y="3227965"/>
              <a:ext cx="380639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6AEDAC96-F353-4C2C-AE4E-5F1C9FFF5F62}"/>
                </a:ext>
              </a:extLst>
            </p:cNvPr>
            <p:cNvSpPr txBox="1"/>
            <p:nvPr/>
          </p:nvSpPr>
          <p:spPr>
            <a:xfrm>
              <a:off x="1663601" y="3274344"/>
              <a:ext cx="304400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9546D155-8D6D-4CA2-9EC2-DB8E015F6665}"/>
                </a:ext>
              </a:extLst>
            </p:cNvPr>
            <p:cNvSpPr txBox="1"/>
            <p:nvPr/>
          </p:nvSpPr>
          <p:spPr>
            <a:xfrm>
              <a:off x="1424100" y="3234170"/>
              <a:ext cx="370188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A46E5239-963F-4089-808D-34D2A5DB5611}"/>
                </a:ext>
              </a:extLst>
            </p:cNvPr>
            <p:cNvSpPr txBox="1"/>
            <p:nvPr/>
          </p:nvSpPr>
          <p:spPr>
            <a:xfrm>
              <a:off x="1716763" y="2984378"/>
              <a:ext cx="373856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812D9A86-5B86-4530-9E7A-515AB70F4BDF}"/>
                </a:ext>
              </a:extLst>
            </p:cNvPr>
            <p:cNvSpPr txBox="1"/>
            <p:nvPr/>
          </p:nvSpPr>
          <p:spPr>
            <a:xfrm>
              <a:off x="1472203" y="3093455"/>
              <a:ext cx="217408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グループ化 130">
              <a:extLst>
                <a:ext uri="{FF2B5EF4-FFF2-40B4-BE49-F238E27FC236}">
                  <a16:creationId xmlns:a16="http://schemas.microsoft.com/office/drawing/2014/main" id="{F73120D9-E678-4E9B-8012-2E9EFB7D841B}"/>
                </a:ext>
              </a:extLst>
            </p:cNvPr>
            <p:cNvGrpSpPr/>
            <p:nvPr/>
          </p:nvGrpSpPr>
          <p:grpSpPr>
            <a:xfrm>
              <a:off x="1515444" y="3054832"/>
              <a:ext cx="554962" cy="80470"/>
              <a:chOff x="1550372" y="3793160"/>
              <a:chExt cx="587318" cy="85162"/>
            </a:xfrm>
          </p:grpSpPr>
          <p:cxnSp>
            <p:nvCxnSpPr>
              <p:cNvPr id="132" name="直線コネクタ 131">
                <a:extLst>
                  <a:ext uri="{FF2B5EF4-FFF2-40B4-BE49-F238E27FC236}">
                    <a16:creationId xmlns:a16="http://schemas.microsoft.com/office/drawing/2014/main" id="{E1D71A85-2331-4064-9DC7-8304FF8799A1}"/>
                  </a:ext>
                </a:extLst>
              </p:cNvPr>
              <p:cNvCxnSpPr/>
              <p:nvPr/>
            </p:nvCxnSpPr>
            <p:spPr>
              <a:xfrm>
                <a:off x="1550372" y="3793704"/>
                <a:ext cx="58535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33" name="直線コネクタ 132">
                <a:extLst>
                  <a:ext uri="{FF2B5EF4-FFF2-40B4-BE49-F238E27FC236}">
                    <a16:creationId xmlns:a16="http://schemas.microsoft.com/office/drawing/2014/main" id="{BDA212BA-73F1-40BE-A7D6-9619DBDB9E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52152" y="3793160"/>
                <a:ext cx="0" cy="81256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34" name="直線コネクタ 133">
                <a:extLst>
                  <a:ext uri="{FF2B5EF4-FFF2-40B4-BE49-F238E27FC236}">
                    <a16:creationId xmlns:a16="http://schemas.microsoft.com/office/drawing/2014/main" id="{3AF38586-6275-479B-A6B5-87FF69AE69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37690" y="3797066"/>
                <a:ext cx="0" cy="81256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5A8A9FA0-7D5E-44FB-9F03-210AF3058473}"/>
                </a:ext>
              </a:extLst>
            </p:cNvPr>
            <p:cNvSpPr txBox="1"/>
            <p:nvPr/>
          </p:nvSpPr>
          <p:spPr>
            <a:xfrm>
              <a:off x="1620373" y="2863573"/>
              <a:ext cx="453071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6" name="グループ化 135">
              <a:extLst>
                <a:ext uri="{FF2B5EF4-FFF2-40B4-BE49-F238E27FC236}">
                  <a16:creationId xmlns:a16="http://schemas.microsoft.com/office/drawing/2014/main" id="{8F93CE58-26E4-46AA-B868-4623CC6CC4A0}"/>
                </a:ext>
              </a:extLst>
            </p:cNvPr>
            <p:cNvGrpSpPr/>
            <p:nvPr/>
          </p:nvGrpSpPr>
          <p:grpSpPr>
            <a:xfrm>
              <a:off x="1516027" y="3420781"/>
              <a:ext cx="161594" cy="637935"/>
              <a:chOff x="1550989" y="4336896"/>
              <a:chExt cx="171015" cy="675127"/>
            </a:xfrm>
          </p:grpSpPr>
          <p:cxnSp>
            <p:nvCxnSpPr>
              <p:cNvPr id="137" name="直線コネクタ 136">
                <a:extLst>
                  <a:ext uri="{FF2B5EF4-FFF2-40B4-BE49-F238E27FC236}">
                    <a16:creationId xmlns:a16="http://schemas.microsoft.com/office/drawing/2014/main" id="{C7D0B23D-8E05-4072-8F45-1225E6BB3AC1}"/>
                  </a:ext>
                </a:extLst>
              </p:cNvPr>
              <p:cNvCxnSpPr/>
              <p:nvPr/>
            </p:nvCxnSpPr>
            <p:spPr>
              <a:xfrm>
                <a:off x="1551100" y="4338145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38" name="グループ化 137">
                <a:extLst>
                  <a:ext uri="{FF2B5EF4-FFF2-40B4-BE49-F238E27FC236}">
                    <a16:creationId xmlns:a16="http://schemas.microsoft.com/office/drawing/2014/main" id="{1A9C20FD-5A6A-4D41-B4C9-7D2D54CB5BD4}"/>
                  </a:ext>
                </a:extLst>
              </p:cNvPr>
              <p:cNvGrpSpPr/>
              <p:nvPr/>
            </p:nvGrpSpPr>
            <p:grpSpPr>
              <a:xfrm>
                <a:off x="1550989" y="4337601"/>
                <a:ext cx="0" cy="674422"/>
                <a:chOff x="1550989" y="4337601"/>
                <a:chExt cx="0" cy="674422"/>
              </a:xfrm>
            </p:grpSpPr>
            <p:cxnSp>
              <p:nvCxnSpPr>
                <p:cNvPr id="142" name="直線コネクタ 141">
                  <a:extLst>
                    <a:ext uri="{FF2B5EF4-FFF2-40B4-BE49-F238E27FC236}">
                      <a16:creationId xmlns:a16="http://schemas.microsoft.com/office/drawing/2014/main" id="{54DBECF3-E550-4969-9E48-8E15B6E3350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550989" y="4337601"/>
                  <a:ext cx="0" cy="9980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43" name="直線コネクタ 142">
                  <a:extLst>
                    <a:ext uri="{FF2B5EF4-FFF2-40B4-BE49-F238E27FC236}">
                      <a16:creationId xmlns:a16="http://schemas.microsoft.com/office/drawing/2014/main" id="{F4398B61-C140-4752-87D6-5C349CF746A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550989" y="4433196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9" name="グループ化 138">
                <a:extLst>
                  <a:ext uri="{FF2B5EF4-FFF2-40B4-BE49-F238E27FC236}">
                    <a16:creationId xmlns:a16="http://schemas.microsoft.com/office/drawing/2014/main" id="{252BA55E-7856-4CA8-B3F6-C6816165CE25}"/>
                  </a:ext>
                </a:extLst>
              </p:cNvPr>
              <p:cNvGrpSpPr/>
              <p:nvPr/>
            </p:nvGrpSpPr>
            <p:grpSpPr>
              <a:xfrm>
                <a:off x="1722004" y="4336896"/>
                <a:ext cx="0" cy="664285"/>
                <a:chOff x="1722004" y="4336896"/>
                <a:chExt cx="0" cy="664285"/>
              </a:xfrm>
            </p:grpSpPr>
            <p:cxnSp>
              <p:nvCxnSpPr>
                <p:cNvPr id="140" name="直線コネクタ 139">
                  <a:extLst>
                    <a:ext uri="{FF2B5EF4-FFF2-40B4-BE49-F238E27FC236}">
                      <a16:creationId xmlns:a16="http://schemas.microsoft.com/office/drawing/2014/main" id="{7301AB78-ED69-40BA-A62D-D9FAB4F0688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722004" y="4336896"/>
                  <a:ext cx="0" cy="9980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41" name="直線コネクタ 140">
                  <a:extLst>
                    <a:ext uri="{FF2B5EF4-FFF2-40B4-BE49-F238E27FC236}">
                      <a16:creationId xmlns:a16="http://schemas.microsoft.com/office/drawing/2014/main" id="{8D99AD71-ABD5-46A2-96B0-72A375FBF7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22004" y="4422354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44" name="グループ化 143">
              <a:extLst>
                <a:ext uri="{FF2B5EF4-FFF2-40B4-BE49-F238E27FC236}">
                  <a16:creationId xmlns:a16="http://schemas.microsoft.com/office/drawing/2014/main" id="{40E15EB4-234E-47D4-908F-2B7AF0273471}"/>
                </a:ext>
              </a:extLst>
            </p:cNvPr>
            <p:cNvGrpSpPr/>
            <p:nvPr/>
          </p:nvGrpSpPr>
          <p:grpSpPr>
            <a:xfrm>
              <a:off x="1718667" y="3418240"/>
              <a:ext cx="157298" cy="631197"/>
              <a:chOff x="1765444" y="4339100"/>
              <a:chExt cx="166469" cy="667997"/>
            </a:xfrm>
          </p:grpSpPr>
          <p:cxnSp>
            <p:nvCxnSpPr>
              <p:cNvPr id="145" name="直線コネクタ 144">
                <a:extLst>
                  <a:ext uri="{FF2B5EF4-FFF2-40B4-BE49-F238E27FC236}">
                    <a16:creationId xmlns:a16="http://schemas.microsoft.com/office/drawing/2014/main" id="{EC6A8B13-697A-42C5-98D5-969727D11E81}"/>
                  </a:ext>
                </a:extLst>
              </p:cNvPr>
              <p:cNvCxnSpPr/>
              <p:nvPr/>
            </p:nvCxnSpPr>
            <p:spPr>
              <a:xfrm>
                <a:off x="1765444" y="4344557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46" name="直線コネクタ 145">
                <a:extLst>
                  <a:ext uri="{FF2B5EF4-FFF2-40B4-BE49-F238E27FC236}">
                    <a16:creationId xmlns:a16="http://schemas.microsoft.com/office/drawing/2014/main" id="{8E3EE40E-A96F-4041-945C-B2E49B3FBA2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65950" y="4339805"/>
                <a:ext cx="0" cy="99808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47" name="直線コネクタ 146">
                <a:extLst>
                  <a:ext uri="{FF2B5EF4-FFF2-40B4-BE49-F238E27FC236}">
                    <a16:creationId xmlns:a16="http://schemas.microsoft.com/office/drawing/2014/main" id="{20EF5780-CCD0-494E-B052-66F2187CA37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66272" y="4427558"/>
                <a:ext cx="0" cy="578827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48" name="グループ化 147">
                <a:extLst>
                  <a:ext uri="{FF2B5EF4-FFF2-40B4-BE49-F238E27FC236}">
                    <a16:creationId xmlns:a16="http://schemas.microsoft.com/office/drawing/2014/main" id="{F37432A9-9CDA-4D54-9F01-4063F3A758A4}"/>
                  </a:ext>
                </a:extLst>
              </p:cNvPr>
              <p:cNvGrpSpPr/>
              <p:nvPr/>
            </p:nvGrpSpPr>
            <p:grpSpPr>
              <a:xfrm>
                <a:off x="1930958" y="4339100"/>
                <a:ext cx="0" cy="667997"/>
                <a:chOff x="1930958" y="4339100"/>
                <a:chExt cx="0" cy="667997"/>
              </a:xfrm>
            </p:grpSpPr>
            <p:cxnSp>
              <p:nvCxnSpPr>
                <p:cNvPr id="149" name="直線コネクタ 148">
                  <a:extLst>
                    <a:ext uri="{FF2B5EF4-FFF2-40B4-BE49-F238E27FC236}">
                      <a16:creationId xmlns:a16="http://schemas.microsoft.com/office/drawing/2014/main" id="{02A3372C-1FE2-4330-A121-BB2B5298C4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30958" y="4339100"/>
                  <a:ext cx="0" cy="9980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50" name="直線コネクタ 149">
                  <a:extLst>
                    <a:ext uri="{FF2B5EF4-FFF2-40B4-BE49-F238E27FC236}">
                      <a16:creationId xmlns:a16="http://schemas.microsoft.com/office/drawing/2014/main" id="{1FF8C193-9E43-4338-8B01-439B9CB497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30958" y="4428270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51" name="グループ化 150">
              <a:extLst>
                <a:ext uri="{FF2B5EF4-FFF2-40B4-BE49-F238E27FC236}">
                  <a16:creationId xmlns:a16="http://schemas.microsoft.com/office/drawing/2014/main" id="{63E4FC10-19DE-4784-81A5-FF90DACC29BD}"/>
                </a:ext>
              </a:extLst>
            </p:cNvPr>
            <p:cNvGrpSpPr/>
            <p:nvPr/>
          </p:nvGrpSpPr>
          <p:grpSpPr>
            <a:xfrm>
              <a:off x="1924383" y="3415847"/>
              <a:ext cx="161099" cy="626920"/>
              <a:chOff x="1983154" y="4336565"/>
              <a:chExt cx="170492" cy="663470"/>
            </a:xfrm>
          </p:grpSpPr>
          <p:cxnSp>
            <p:nvCxnSpPr>
              <p:cNvPr id="152" name="直線コネクタ 151">
                <a:extLst>
                  <a:ext uri="{FF2B5EF4-FFF2-40B4-BE49-F238E27FC236}">
                    <a16:creationId xmlns:a16="http://schemas.microsoft.com/office/drawing/2014/main" id="{CD05394D-3AE3-43B8-A7D5-D9CBE49A6533}"/>
                  </a:ext>
                </a:extLst>
              </p:cNvPr>
              <p:cNvCxnSpPr/>
              <p:nvPr/>
            </p:nvCxnSpPr>
            <p:spPr>
              <a:xfrm>
                <a:off x="1983631" y="4342022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53" name="グループ化 152">
                <a:extLst>
                  <a:ext uri="{FF2B5EF4-FFF2-40B4-BE49-F238E27FC236}">
                    <a16:creationId xmlns:a16="http://schemas.microsoft.com/office/drawing/2014/main" id="{D8560868-EF83-428F-94D1-D5568C1319FE}"/>
                  </a:ext>
                </a:extLst>
              </p:cNvPr>
              <p:cNvGrpSpPr/>
              <p:nvPr/>
            </p:nvGrpSpPr>
            <p:grpSpPr>
              <a:xfrm>
                <a:off x="1983154" y="4337270"/>
                <a:ext cx="0" cy="662765"/>
                <a:chOff x="1983154" y="4337270"/>
                <a:chExt cx="0" cy="662765"/>
              </a:xfrm>
            </p:grpSpPr>
            <p:cxnSp>
              <p:nvCxnSpPr>
                <p:cNvPr id="157" name="直線コネクタ 156">
                  <a:extLst>
                    <a:ext uri="{FF2B5EF4-FFF2-40B4-BE49-F238E27FC236}">
                      <a16:creationId xmlns:a16="http://schemas.microsoft.com/office/drawing/2014/main" id="{5A5E22C8-E59D-4F4F-AB98-EE9F8C62050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983154" y="4337270"/>
                  <a:ext cx="0" cy="9980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58" name="直線コネクタ 157">
                  <a:extLst>
                    <a:ext uri="{FF2B5EF4-FFF2-40B4-BE49-F238E27FC236}">
                      <a16:creationId xmlns:a16="http://schemas.microsoft.com/office/drawing/2014/main" id="{6E11633D-B381-4606-B13F-25AB12DBC5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83154" y="4421208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54" name="グループ化 153">
                <a:extLst>
                  <a:ext uri="{FF2B5EF4-FFF2-40B4-BE49-F238E27FC236}">
                    <a16:creationId xmlns:a16="http://schemas.microsoft.com/office/drawing/2014/main" id="{3F78026D-ECB4-4C2C-B1C5-F227DE4B97B9}"/>
                  </a:ext>
                </a:extLst>
              </p:cNvPr>
              <p:cNvGrpSpPr/>
              <p:nvPr/>
            </p:nvGrpSpPr>
            <p:grpSpPr>
              <a:xfrm>
                <a:off x="2153646" y="4336565"/>
                <a:ext cx="0" cy="663470"/>
                <a:chOff x="2153646" y="4336565"/>
                <a:chExt cx="0" cy="663470"/>
              </a:xfrm>
            </p:grpSpPr>
            <p:cxnSp>
              <p:nvCxnSpPr>
                <p:cNvPr id="155" name="直線コネクタ 154">
                  <a:extLst>
                    <a:ext uri="{FF2B5EF4-FFF2-40B4-BE49-F238E27FC236}">
                      <a16:creationId xmlns:a16="http://schemas.microsoft.com/office/drawing/2014/main" id="{CEF4C874-E30B-4E96-B0D8-A0B7B745AEF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153646" y="4336565"/>
                  <a:ext cx="0" cy="99808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56" name="直線コネクタ 155">
                  <a:extLst>
                    <a:ext uri="{FF2B5EF4-FFF2-40B4-BE49-F238E27FC236}">
                      <a16:creationId xmlns:a16="http://schemas.microsoft.com/office/drawing/2014/main" id="{3A273E6A-7F12-46E3-9D44-43597D1E77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53646" y="4421208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aphicFrame>
        <p:nvGraphicFramePr>
          <p:cNvPr id="14" name="オブジェクト 13">
            <a:extLst>
              <a:ext uri="{FF2B5EF4-FFF2-40B4-BE49-F238E27FC236}">
                <a16:creationId xmlns:a16="http://schemas.microsoft.com/office/drawing/2014/main" id="{43FA05EA-1C7D-4E33-B876-BB4DCF71EE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237218"/>
              </p:ext>
            </p:extLst>
          </p:nvPr>
        </p:nvGraphicFramePr>
        <p:xfrm>
          <a:off x="3319463" y="581025"/>
          <a:ext cx="3152775" cy="2965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152988" imgH="2966068" progId="Prism9.Document">
                  <p:embed/>
                </p:oleObj>
              </mc:Choice>
              <mc:Fallback>
                <p:oleObj name="Prism 9" r:id="rId4" imgW="3152988" imgH="2966068" progId="Prism9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43FA05EA-1C7D-4E33-B876-BB4DCF71EE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19463" y="581025"/>
                        <a:ext cx="3152775" cy="2965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23DC4F0-8D48-46D1-B800-74942B2D763B}"/>
              </a:ext>
            </a:extLst>
          </p:cNvPr>
          <p:cNvSpPr txBox="1"/>
          <p:nvPr/>
        </p:nvSpPr>
        <p:spPr>
          <a:xfrm>
            <a:off x="949437" y="449807"/>
            <a:ext cx="1885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bcutaneous fat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6D9084E7-507F-4F6D-A21B-CE6C319F8A7E}"/>
              </a:ext>
            </a:extLst>
          </p:cNvPr>
          <p:cNvSpPr txBox="1"/>
          <p:nvPr/>
        </p:nvSpPr>
        <p:spPr>
          <a:xfrm>
            <a:off x="4256291" y="457914"/>
            <a:ext cx="1371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Visceral fat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F539EFAB-9E8E-4C66-BEF5-FAC722C27A9D}"/>
              </a:ext>
            </a:extLst>
          </p:cNvPr>
          <p:cNvSpPr txBox="1"/>
          <p:nvPr/>
        </p:nvSpPr>
        <p:spPr>
          <a:xfrm>
            <a:off x="562923" y="2668404"/>
            <a:ext cx="72106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F25E241A-00AE-4903-B344-D364E2672901}"/>
              </a:ext>
            </a:extLst>
          </p:cNvPr>
          <p:cNvSpPr txBox="1"/>
          <p:nvPr/>
        </p:nvSpPr>
        <p:spPr>
          <a:xfrm>
            <a:off x="1437456" y="2663826"/>
            <a:ext cx="758280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C83CBD8D-EFB1-48D6-A132-2F8B8E2C63A2}"/>
              </a:ext>
            </a:extLst>
          </p:cNvPr>
          <p:cNvSpPr txBox="1"/>
          <p:nvPr/>
        </p:nvSpPr>
        <p:spPr>
          <a:xfrm>
            <a:off x="2334733" y="2663865"/>
            <a:ext cx="758280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6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1DE6A036-683F-4A49-BE00-4859E6117FD6}"/>
              </a:ext>
            </a:extLst>
          </p:cNvPr>
          <p:cNvSpPr txBox="1"/>
          <p:nvPr/>
        </p:nvSpPr>
        <p:spPr>
          <a:xfrm>
            <a:off x="3733316" y="2635364"/>
            <a:ext cx="7210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6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13731B09-211C-46AA-B119-920088981AE3}"/>
              </a:ext>
            </a:extLst>
          </p:cNvPr>
          <p:cNvSpPr txBox="1"/>
          <p:nvPr/>
        </p:nvSpPr>
        <p:spPr>
          <a:xfrm>
            <a:off x="4602490" y="2636573"/>
            <a:ext cx="758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EC486060-464D-496B-BDDC-02FE94B8A1B6}"/>
              </a:ext>
            </a:extLst>
          </p:cNvPr>
          <p:cNvSpPr txBox="1"/>
          <p:nvPr/>
        </p:nvSpPr>
        <p:spPr>
          <a:xfrm>
            <a:off x="5525729" y="2635058"/>
            <a:ext cx="758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6w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82C9F92-121D-485C-9303-B005E2F6BD18}"/>
              </a:ext>
            </a:extLst>
          </p:cNvPr>
          <p:cNvSpPr txBox="1"/>
          <p:nvPr/>
        </p:nvSpPr>
        <p:spPr>
          <a:xfrm rot="10800000">
            <a:off x="-13028" y="1286440"/>
            <a:ext cx="338554" cy="88160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at mass (g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57FF2304-51B8-4BC5-A99B-3D0F691828EE}"/>
              </a:ext>
            </a:extLst>
          </p:cNvPr>
          <p:cNvSpPr txBox="1"/>
          <p:nvPr/>
        </p:nvSpPr>
        <p:spPr>
          <a:xfrm rot="10800000">
            <a:off x="3168322" y="1241990"/>
            <a:ext cx="338554" cy="88160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at mass (g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E5DDCF1E-A801-40CD-987B-F2B370AC85EA}"/>
              </a:ext>
            </a:extLst>
          </p:cNvPr>
          <p:cNvSpPr txBox="1"/>
          <p:nvPr/>
        </p:nvSpPr>
        <p:spPr>
          <a:xfrm>
            <a:off x="6157927" y="6785688"/>
            <a:ext cx="306353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7971981-FCDD-48E2-9B3E-6D2FF9A27863}"/>
              </a:ext>
            </a:extLst>
          </p:cNvPr>
          <p:cNvSpPr txBox="1"/>
          <p:nvPr/>
        </p:nvSpPr>
        <p:spPr>
          <a:xfrm>
            <a:off x="-27905" y="332204"/>
            <a:ext cx="465820" cy="325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12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51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C0E15406-7314-48CD-97E4-92D4DEFC0AD1}"/>
              </a:ext>
            </a:extLst>
          </p:cNvPr>
          <p:cNvGrpSpPr/>
          <p:nvPr/>
        </p:nvGrpSpPr>
        <p:grpSpPr>
          <a:xfrm>
            <a:off x="135763" y="700558"/>
            <a:ext cx="363902" cy="2042135"/>
            <a:chOff x="32596" y="7239600"/>
            <a:chExt cx="385119" cy="2161195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0E2FB071-D6E4-4066-BCA3-0F705DC00A91}"/>
                </a:ext>
              </a:extLst>
            </p:cNvPr>
            <p:cNvSpPr txBox="1"/>
            <p:nvPr/>
          </p:nvSpPr>
          <p:spPr>
            <a:xfrm>
              <a:off x="111256" y="7622204"/>
              <a:ext cx="189874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F43FFC63-B79C-4F00-AA9E-077228AEB6BF}"/>
                </a:ext>
              </a:extLst>
            </p:cNvPr>
            <p:cNvSpPr txBox="1"/>
            <p:nvPr/>
          </p:nvSpPr>
          <p:spPr>
            <a:xfrm>
              <a:off x="105834" y="8003640"/>
              <a:ext cx="212963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2BC15BA1-D002-46EA-BAF7-B880E1108AC4}"/>
                </a:ext>
              </a:extLst>
            </p:cNvPr>
            <p:cNvSpPr txBox="1"/>
            <p:nvPr/>
          </p:nvSpPr>
          <p:spPr>
            <a:xfrm>
              <a:off x="104298" y="9140218"/>
              <a:ext cx="183536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9E463A93-7B1D-4DC8-96B1-98FCD95DC0CA}"/>
                </a:ext>
              </a:extLst>
            </p:cNvPr>
            <p:cNvSpPr txBox="1"/>
            <p:nvPr/>
          </p:nvSpPr>
          <p:spPr>
            <a:xfrm>
              <a:off x="32596" y="7239600"/>
              <a:ext cx="385119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EC4D076A-96B9-46CF-800E-2DE40FB3AAFE}"/>
                </a:ext>
              </a:extLst>
            </p:cNvPr>
            <p:cNvSpPr txBox="1"/>
            <p:nvPr/>
          </p:nvSpPr>
          <p:spPr>
            <a:xfrm>
              <a:off x="117380" y="8392607"/>
              <a:ext cx="167725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6A7C0DA3-77F0-4A08-82CA-AFF6F0B6D977}"/>
                </a:ext>
              </a:extLst>
            </p:cNvPr>
            <p:cNvSpPr txBox="1"/>
            <p:nvPr/>
          </p:nvSpPr>
          <p:spPr>
            <a:xfrm>
              <a:off x="152996" y="8780632"/>
              <a:ext cx="93098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BDDA5A7C-A1B8-4CA1-B4B4-38A1DF5DB667}"/>
              </a:ext>
            </a:extLst>
          </p:cNvPr>
          <p:cNvGrpSpPr/>
          <p:nvPr/>
        </p:nvGrpSpPr>
        <p:grpSpPr>
          <a:xfrm>
            <a:off x="3293493" y="679893"/>
            <a:ext cx="370243" cy="2032942"/>
            <a:chOff x="-11854" y="7613190"/>
            <a:chExt cx="391830" cy="2151459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779DA796-16B7-4C39-A2D8-03A5567D1EF8}"/>
                </a:ext>
              </a:extLst>
            </p:cNvPr>
            <p:cNvSpPr txBox="1"/>
            <p:nvPr/>
          </p:nvSpPr>
          <p:spPr>
            <a:xfrm>
              <a:off x="68385" y="7995431"/>
              <a:ext cx="189873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40E80206-B842-49D4-80EB-552E7DA596AE}"/>
                </a:ext>
              </a:extLst>
            </p:cNvPr>
            <p:cNvSpPr txBox="1"/>
            <p:nvPr/>
          </p:nvSpPr>
          <p:spPr>
            <a:xfrm>
              <a:off x="63560" y="8373155"/>
              <a:ext cx="212963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9FFC7B1D-EA7A-4558-B3C1-A08E7FF306DD}"/>
                </a:ext>
              </a:extLst>
            </p:cNvPr>
            <p:cNvSpPr txBox="1"/>
            <p:nvPr/>
          </p:nvSpPr>
          <p:spPr>
            <a:xfrm>
              <a:off x="74722" y="9504074"/>
              <a:ext cx="183535" cy="2605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A6B78073-44F1-40B9-B906-B0C60AF061C0}"/>
                </a:ext>
              </a:extLst>
            </p:cNvPr>
            <p:cNvSpPr txBox="1"/>
            <p:nvPr/>
          </p:nvSpPr>
          <p:spPr>
            <a:xfrm>
              <a:off x="-11854" y="7613190"/>
              <a:ext cx="391830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31D50027-C87D-42B8-96E3-0278F1D71B32}"/>
                </a:ext>
              </a:extLst>
            </p:cNvPr>
            <p:cNvSpPr txBox="1"/>
            <p:nvPr/>
          </p:nvSpPr>
          <p:spPr>
            <a:xfrm>
              <a:off x="68385" y="8765295"/>
              <a:ext cx="167725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8F4C26B4-470D-4EB9-9DA4-922CD27C4F03}"/>
                </a:ext>
              </a:extLst>
            </p:cNvPr>
            <p:cNvSpPr txBox="1"/>
            <p:nvPr/>
          </p:nvSpPr>
          <p:spPr>
            <a:xfrm>
              <a:off x="110721" y="9150157"/>
              <a:ext cx="93098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11C59E2-C639-4E53-9DD4-4ABCB12F05BF}"/>
              </a:ext>
            </a:extLst>
          </p:cNvPr>
          <p:cNvGrpSpPr/>
          <p:nvPr/>
        </p:nvGrpSpPr>
        <p:grpSpPr>
          <a:xfrm>
            <a:off x="1521084" y="932860"/>
            <a:ext cx="550377" cy="138322"/>
            <a:chOff x="1521084" y="2950092"/>
            <a:chExt cx="550377" cy="138322"/>
          </a:xfrm>
        </p:grpSpPr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id="{9645B497-9EA3-4CFB-9CB8-91145034492C}"/>
                </a:ext>
              </a:extLst>
            </p:cNvPr>
            <p:cNvGrpSpPr/>
            <p:nvPr/>
          </p:nvGrpSpPr>
          <p:grpSpPr>
            <a:xfrm>
              <a:off x="1521084" y="3017629"/>
              <a:ext cx="353707" cy="70785"/>
              <a:chOff x="1550373" y="4091344"/>
              <a:chExt cx="374329" cy="74912"/>
            </a:xfrm>
          </p:grpSpPr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5E745FF7-32E8-4369-9CC7-5FD93AFAB0C4}"/>
                  </a:ext>
                </a:extLst>
              </p:cNvPr>
              <p:cNvCxnSpPr/>
              <p:nvPr/>
            </p:nvCxnSpPr>
            <p:spPr>
              <a:xfrm>
                <a:off x="1550373" y="4096621"/>
                <a:ext cx="369928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89" name="直線コネクタ 88">
                <a:extLst>
                  <a:ext uri="{FF2B5EF4-FFF2-40B4-BE49-F238E27FC236}">
                    <a16:creationId xmlns:a16="http://schemas.microsoft.com/office/drawing/2014/main" id="{3B6AE6B4-88F3-4B5A-A9FF-A170E9062C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551498" y="4091869"/>
                <a:ext cx="0" cy="7438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90" name="直線コネクタ 89">
                <a:extLst>
                  <a:ext uri="{FF2B5EF4-FFF2-40B4-BE49-F238E27FC236}">
                    <a16:creationId xmlns:a16="http://schemas.microsoft.com/office/drawing/2014/main" id="{A4910A64-FC33-453E-B3E3-76D0EC0C8FC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24702" y="4091344"/>
                <a:ext cx="0" cy="7438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93" name="グループ化 92">
              <a:extLst>
                <a:ext uri="{FF2B5EF4-FFF2-40B4-BE49-F238E27FC236}">
                  <a16:creationId xmlns:a16="http://schemas.microsoft.com/office/drawing/2014/main" id="{CA57CF14-362F-47AA-A03F-95A15CC99C59}"/>
                </a:ext>
              </a:extLst>
            </p:cNvPr>
            <p:cNvGrpSpPr/>
            <p:nvPr/>
          </p:nvGrpSpPr>
          <p:grpSpPr>
            <a:xfrm>
              <a:off x="1699849" y="2950092"/>
              <a:ext cx="371612" cy="55491"/>
              <a:chOff x="1745609" y="3958350"/>
              <a:chExt cx="393278" cy="58726"/>
            </a:xfrm>
          </p:grpSpPr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D0FDD32D-C0EC-4BCE-AEC8-2E1EF785A125}"/>
                  </a:ext>
                </a:extLst>
              </p:cNvPr>
              <p:cNvCxnSpPr/>
              <p:nvPr/>
            </p:nvCxnSpPr>
            <p:spPr>
              <a:xfrm>
                <a:off x="1745609" y="3967583"/>
                <a:ext cx="393278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B78363D4-B338-476D-8D0B-3174D3FAA6F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751285" y="3958350"/>
                <a:ext cx="0" cy="54632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96" name="直線コネクタ 95">
                <a:extLst>
                  <a:ext uri="{FF2B5EF4-FFF2-40B4-BE49-F238E27FC236}">
                    <a16:creationId xmlns:a16="http://schemas.microsoft.com/office/drawing/2014/main" id="{6537F87B-5619-45C8-AE70-D31BB908A34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35778" y="3962445"/>
                <a:ext cx="0" cy="54631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D3B3CA3-D47F-467A-A75C-E38D99451850}"/>
              </a:ext>
            </a:extLst>
          </p:cNvPr>
          <p:cNvSpPr txBox="1"/>
          <p:nvPr/>
        </p:nvSpPr>
        <p:spPr>
          <a:xfrm>
            <a:off x="2578469" y="639401"/>
            <a:ext cx="292779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" name="グループ化 99">
            <a:extLst>
              <a:ext uri="{FF2B5EF4-FFF2-40B4-BE49-F238E27FC236}">
                <a16:creationId xmlns:a16="http://schemas.microsoft.com/office/drawing/2014/main" id="{61C8B504-737B-445D-97F5-E8EE7A68EB34}"/>
              </a:ext>
            </a:extLst>
          </p:cNvPr>
          <p:cNvGrpSpPr/>
          <p:nvPr/>
        </p:nvGrpSpPr>
        <p:grpSpPr>
          <a:xfrm>
            <a:off x="2870151" y="1109165"/>
            <a:ext cx="157298" cy="106221"/>
            <a:chOff x="7234373" y="3099470"/>
            <a:chExt cx="372508" cy="93759"/>
          </a:xfrm>
        </p:grpSpPr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69816F23-D334-43E0-8D6A-747F612D4018}"/>
                </a:ext>
              </a:extLst>
            </p:cNvPr>
            <p:cNvCxnSpPr/>
            <p:nvPr/>
          </p:nvCxnSpPr>
          <p:spPr>
            <a:xfrm>
              <a:off x="7234373" y="3104322"/>
              <a:ext cx="372508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2" name="直線コネクタ 101">
              <a:extLst>
                <a:ext uri="{FF2B5EF4-FFF2-40B4-BE49-F238E27FC236}">
                  <a16:creationId xmlns:a16="http://schemas.microsoft.com/office/drawing/2014/main" id="{9C9C2ACF-5594-4735-B3D9-FB19B10342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34373" y="3099472"/>
              <a:ext cx="0" cy="9375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9568EA5F-A83A-4450-BCEA-FABA64BBC2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04844" y="3099470"/>
              <a:ext cx="0" cy="9375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0D21FDCF-C1AD-4D83-8099-03CC0510AE8C}"/>
              </a:ext>
            </a:extLst>
          </p:cNvPr>
          <p:cNvGrpSpPr/>
          <p:nvPr/>
        </p:nvGrpSpPr>
        <p:grpSpPr>
          <a:xfrm>
            <a:off x="2664394" y="1109337"/>
            <a:ext cx="159532" cy="397006"/>
            <a:chOff x="2714573" y="3459404"/>
            <a:chExt cx="168833" cy="420152"/>
          </a:xfrm>
        </p:grpSpPr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A0335A4B-7834-45EC-8058-D3F575A765FB}"/>
                </a:ext>
              </a:extLst>
            </p:cNvPr>
            <p:cNvGrpSpPr/>
            <p:nvPr/>
          </p:nvGrpSpPr>
          <p:grpSpPr>
            <a:xfrm>
              <a:off x="2714573" y="3464080"/>
              <a:ext cx="166469" cy="415476"/>
              <a:chOff x="2704293" y="4301039"/>
              <a:chExt cx="166469" cy="690456"/>
            </a:xfrm>
          </p:grpSpPr>
          <p:cxnSp>
            <p:nvCxnSpPr>
              <p:cNvPr id="107" name="直線コネクタ 106">
                <a:extLst>
                  <a:ext uri="{FF2B5EF4-FFF2-40B4-BE49-F238E27FC236}">
                    <a16:creationId xmlns:a16="http://schemas.microsoft.com/office/drawing/2014/main" id="{196B0F4F-4950-4FEB-AFA4-4018A35EAA0F}"/>
                  </a:ext>
                </a:extLst>
              </p:cNvPr>
              <p:cNvCxnSpPr/>
              <p:nvPr/>
            </p:nvCxnSpPr>
            <p:spPr>
              <a:xfrm>
                <a:off x="2704293" y="4301943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08" name="グループ化 107">
                <a:extLst>
                  <a:ext uri="{FF2B5EF4-FFF2-40B4-BE49-F238E27FC236}">
                    <a16:creationId xmlns:a16="http://schemas.microsoft.com/office/drawing/2014/main" id="{B1A39F34-AF36-4FC8-84DD-B0FA384F1809}"/>
                  </a:ext>
                </a:extLst>
              </p:cNvPr>
              <p:cNvGrpSpPr/>
              <p:nvPr/>
            </p:nvGrpSpPr>
            <p:grpSpPr>
              <a:xfrm>
                <a:off x="2705435" y="4301039"/>
                <a:ext cx="0" cy="690456"/>
                <a:chOff x="2705435" y="4301039"/>
                <a:chExt cx="0" cy="690456"/>
              </a:xfrm>
            </p:grpSpPr>
            <p:cxnSp>
              <p:nvCxnSpPr>
                <p:cNvPr id="109" name="直線コネクタ 108">
                  <a:extLst>
                    <a:ext uri="{FF2B5EF4-FFF2-40B4-BE49-F238E27FC236}">
                      <a16:creationId xmlns:a16="http://schemas.microsoft.com/office/drawing/2014/main" id="{6CC33558-5725-4262-A586-5D8D2710B25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705435" y="4301039"/>
                  <a:ext cx="0" cy="112411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10" name="直線コネクタ 109">
                  <a:extLst>
                    <a:ext uri="{FF2B5EF4-FFF2-40B4-BE49-F238E27FC236}">
                      <a16:creationId xmlns:a16="http://schemas.microsoft.com/office/drawing/2014/main" id="{387E96BA-C3C6-4FC6-8DE4-3AF00930E7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705435" y="4412668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51D1843A-90AA-4F57-B4DC-B2A0C454BD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83406" y="3459404"/>
              <a:ext cx="0" cy="112412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11" name="グループ化 110">
            <a:extLst>
              <a:ext uri="{FF2B5EF4-FFF2-40B4-BE49-F238E27FC236}">
                <a16:creationId xmlns:a16="http://schemas.microsoft.com/office/drawing/2014/main" id="{3FF09DD4-2AE7-4558-B4FC-6C7F64DFC238}"/>
              </a:ext>
            </a:extLst>
          </p:cNvPr>
          <p:cNvGrpSpPr/>
          <p:nvPr/>
        </p:nvGrpSpPr>
        <p:grpSpPr>
          <a:xfrm>
            <a:off x="2457590" y="957390"/>
            <a:ext cx="351822" cy="58084"/>
            <a:chOff x="2489222" y="3893661"/>
            <a:chExt cx="372334" cy="84905"/>
          </a:xfrm>
        </p:grpSpPr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D34C1560-2808-4AD6-A19B-097E510DC351}"/>
                </a:ext>
              </a:extLst>
            </p:cNvPr>
            <p:cNvCxnSpPr/>
            <p:nvPr/>
          </p:nvCxnSpPr>
          <p:spPr>
            <a:xfrm>
              <a:off x="2489222" y="3898678"/>
              <a:ext cx="369927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ABAE1152-98E0-41BA-B80F-39817A9FED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90347" y="3893661"/>
              <a:ext cx="0" cy="83781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52ED855F-324D-423A-B27E-91DE6EC6B51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61556" y="3894786"/>
              <a:ext cx="0" cy="8378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B6E14430-2115-4C68-93AD-BDF1D86E5E4A}"/>
              </a:ext>
            </a:extLst>
          </p:cNvPr>
          <p:cNvSpPr txBox="1"/>
          <p:nvPr/>
        </p:nvSpPr>
        <p:spPr>
          <a:xfrm>
            <a:off x="2300261" y="922904"/>
            <a:ext cx="368886" cy="237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45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kumimoji="1" lang="en-US" altLang="ja-JP" sz="945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kumimoji="1" lang="ja-JP" altLang="en-US" sz="94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CCAF12B2-BCD3-446A-8D21-770347DFDFE1}"/>
              </a:ext>
            </a:extLst>
          </p:cNvPr>
          <p:cNvSpPr txBox="1"/>
          <p:nvPr/>
        </p:nvSpPr>
        <p:spPr>
          <a:xfrm>
            <a:off x="2585420" y="963724"/>
            <a:ext cx="335393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708F1A6B-3E6F-4D5E-AC0B-F88080069EEC}"/>
              </a:ext>
            </a:extLst>
          </p:cNvPr>
          <p:cNvSpPr txBox="1"/>
          <p:nvPr/>
        </p:nvSpPr>
        <p:spPr>
          <a:xfrm>
            <a:off x="2695764" y="756914"/>
            <a:ext cx="292778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FC1DBE63-7FC7-46E9-B179-6D1AF3238947}"/>
              </a:ext>
            </a:extLst>
          </p:cNvPr>
          <p:cNvGrpSpPr/>
          <p:nvPr/>
        </p:nvGrpSpPr>
        <p:grpSpPr>
          <a:xfrm>
            <a:off x="4595650" y="705946"/>
            <a:ext cx="800494" cy="729280"/>
            <a:chOff x="4595650" y="2725442"/>
            <a:chExt cx="800494" cy="729280"/>
          </a:xfrm>
        </p:grpSpPr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A71F2AFE-8FC2-43EC-BF18-738F1860C17F}"/>
                </a:ext>
              </a:extLst>
            </p:cNvPr>
            <p:cNvSpPr txBox="1"/>
            <p:nvPr/>
          </p:nvSpPr>
          <p:spPr>
            <a:xfrm>
              <a:off x="4874661" y="3202473"/>
              <a:ext cx="217462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BBB34028-E500-459F-BBF8-311A5D402B4A}"/>
                </a:ext>
              </a:extLst>
            </p:cNvPr>
            <p:cNvSpPr txBox="1"/>
            <p:nvPr/>
          </p:nvSpPr>
          <p:spPr>
            <a:xfrm>
              <a:off x="5025956" y="3148913"/>
              <a:ext cx="370188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416E4B79-CE0B-4CD2-A53F-F7205DD3ECB4}"/>
                </a:ext>
              </a:extLst>
            </p:cNvPr>
            <p:cNvSpPr txBox="1"/>
            <p:nvPr/>
          </p:nvSpPr>
          <p:spPr>
            <a:xfrm>
              <a:off x="4595650" y="3150019"/>
              <a:ext cx="386907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D87BAA23-C9E9-4799-AD66-94727BC7FAD3}"/>
                </a:ext>
              </a:extLst>
            </p:cNvPr>
            <p:cNvSpPr txBox="1"/>
            <p:nvPr/>
          </p:nvSpPr>
          <p:spPr>
            <a:xfrm>
              <a:off x="4801044" y="2725442"/>
              <a:ext cx="394787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C6408DC5-FF45-46C0-B194-F78ED6FF3BA5}"/>
                </a:ext>
              </a:extLst>
            </p:cNvPr>
            <p:cNvSpPr txBox="1"/>
            <p:nvPr/>
          </p:nvSpPr>
          <p:spPr>
            <a:xfrm>
              <a:off x="4893640" y="2864575"/>
              <a:ext cx="414614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9998C601-5381-4E30-A4F6-679844840147}"/>
                </a:ext>
              </a:extLst>
            </p:cNvPr>
            <p:cNvSpPr txBox="1"/>
            <p:nvPr/>
          </p:nvSpPr>
          <p:spPr>
            <a:xfrm>
              <a:off x="4682008" y="3005629"/>
              <a:ext cx="248684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E49398AC-52BE-4389-A3F0-116374C87444}"/>
              </a:ext>
            </a:extLst>
          </p:cNvPr>
          <p:cNvGrpSpPr/>
          <p:nvPr/>
        </p:nvGrpSpPr>
        <p:grpSpPr>
          <a:xfrm>
            <a:off x="5518242" y="753414"/>
            <a:ext cx="748034" cy="653191"/>
            <a:chOff x="5518242" y="2758248"/>
            <a:chExt cx="748034" cy="653191"/>
          </a:xfrm>
        </p:grpSpPr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77B9EA15-DF13-4606-997E-C4EB810F3AD7}"/>
                </a:ext>
              </a:extLst>
            </p:cNvPr>
            <p:cNvSpPr txBox="1"/>
            <p:nvPr/>
          </p:nvSpPr>
          <p:spPr>
            <a:xfrm>
              <a:off x="5526854" y="3118328"/>
              <a:ext cx="361595" cy="2377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45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kumimoji="1" lang="en-US" altLang="ja-JP" sz="945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kumimoji="1" lang="ja-JP" altLang="en-US" sz="94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1AF4F80E-3BE2-48FB-8015-AE17482806C8}"/>
                </a:ext>
              </a:extLst>
            </p:cNvPr>
            <p:cNvSpPr txBox="1"/>
            <p:nvPr/>
          </p:nvSpPr>
          <p:spPr>
            <a:xfrm>
              <a:off x="5989345" y="3158628"/>
              <a:ext cx="276931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7EACA907-FF8A-4377-A61C-E5FE300019E7}"/>
                </a:ext>
              </a:extLst>
            </p:cNvPr>
            <p:cNvSpPr txBox="1"/>
            <p:nvPr/>
          </p:nvSpPr>
          <p:spPr>
            <a:xfrm>
              <a:off x="5518242" y="2983158"/>
              <a:ext cx="370207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4D1F2E47-132A-4141-A214-408E4356BFCE}"/>
                </a:ext>
              </a:extLst>
            </p:cNvPr>
            <p:cNvSpPr txBox="1"/>
            <p:nvPr/>
          </p:nvSpPr>
          <p:spPr>
            <a:xfrm>
              <a:off x="5754961" y="3159190"/>
              <a:ext cx="383799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D5452335-ACA2-466F-8BE7-59D4FB841701}"/>
                </a:ext>
              </a:extLst>
            </p:cNvPr>
            <p:cNvSpPr txBox="1"/>
            <p:nvPr/>
          </p:nvSpPr>
          <p:spPr>
            <a:xfrm>
              <a:off x="5823680" y="2894894"/>
              <a:ext cx="304728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DCDC54A8-B54A-49EA-BE2E-28626C7D6F48}"/>
                </a:ext>
              </a:extLst>
            </p:cNvPr>
            <p:cNvSpPr txBox="1"/>
            <p:nvPr/>
          </p:nvSpPr>
          <p:spPr>
            <a:xfrm>
              <a:off x="5736332" y="2758248"/>
              <a:ext cx="304730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39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kumimoji="1" lang="ja-JP" altLang="en-US" sz="103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70B6BB28-20BB-4EAD-9BA1-08EC818FB6C2}"/>
              </a:ext>
            </a:extLst>
          </p:cNvPr>
          <p:cNvSpPr txBox="1"/>
          <p:nvPr/>
        </p:nvSpPr>
        <p:spPr>
          <a:xfrm>
            <a:off x="2358491" y="814999"/>
            <a:ext cx="337575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id="{4EBE82D2-8287-4BC8-9BF8-40ED54F33D09}"/>
              </a:ext>
            </a:extLst>
          </p:cNvPr>
          <p:cNvGrpSpPr/>
          <p:nvPr/>
        </p:nvGrpSpPr>
        <p:grpSpPr>
          <a:xfrm>
            <a:off x="2464834" y="804972"/>
            <a:ext cx="553111" cy="52401"/>
            <a:chOff x="2489221" y="3469210"/>
            <a:chExt cx="585359" cy="92159"/>
          </a:xfrm>
        </p:grpSpPr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B6D9C2A0-C45C-4EAE-BEDE-7C954443D27C}"/>
                </a:ext>
              </a:extLst>
            </p:cNvPr>
            <p:cNvCxnSpPr/>
            <p:nvPr/>
          </p:nvCxnSpPr>
          <p:spPr>
            <a:xfrm>
              <a:off x="2489221" y="3469852"/>
              <a:ext cx="585359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5B4254D2-D6CB-4219-B077-EAE37CAB7BC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95481" y="3469850"/>
              <a:ext cx="0" cy="91519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E1C36A7B-7517-410F-98BB-FB8DF41F726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69611" y="3469210"/>
              <a:ext cx="0" cy="91517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1A3EBD0E-A564-4A97-B9A3-44ED7ADE2F97}"/>
              </a:ext>
            </a:extLst>
          </p:cNvPr>
          <p:cNvGrpSpPr/>
          <p:nvPr/>
        </p:nvGrpSpPr>
        <p:grpSpPr>
          <a:xfrm>
            <a:off x="2653656" y="896531"/>
            <a:ext cx="371612" cy="39464"/>
            <a:chOff x="2684458" y="3647046"/>
            <a:chExt cx="393278" cy="69413"/>
          </a:xfrm>
        </p:grpSpPr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3B426B3E-671B-4B80-9AB0-5B622227971D}"/>
                </a:ext>
              </a:extLst>
            </p:cNvPr>
            <p:cNvCxnSpPr/>
            <p:nvPr/>
          </p:nvCxnSpPr>
          <p:spPr>
            <a:xfrm>
              <a:off x="2684458" y="3647482"/>
              <a:ext cx="393278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8307BF80-EE28-4092-9830-F3D51B5DD9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86470" y="3654926"/>
              <a:ext cx="0" cy="61533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5FA12A95-2D69-4BC9-A44F-BB948390DD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75619" y="3647046"/>
              <a:ext cx="0" cy="61531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45279A5-F496-4F1F-B9CC-FE66AE8FC266}"/>
              </a:ext>
            </a:extLst>
          </p:cNvPr>
          <p:cNvSpPr txBox="1"/>
          <p:nvPr/>
        </p:nvSpPr>
        <p:spPr>
          <a:xfrm>
            <a:off x="2873764" y="960718"/>
            <a:ext cx="95252" cy="252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39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id="{1951010A-CB30-4C51-9E29-754E1880784C}"/>
              </a:ext>
            </a:extLst>
          </p:cNvPr>
          <p:cNvGrpSpPr/>
          <p:nvPr/>
        </p:nvGrpSpPr>
        <p:grpSpPr>
          <a:xfrm>
            <a:off x="2442406" y="1103957"/>
            <a:ext cx="158107" cy="392862"/>
            <a:chOff x="2489949" y="4318266"/>
            <a:chExt cx="167325" cy="690938"/>
          </a:xfrm>
        </p:grpSpPr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CA0590B5-9B6E-4DBE-8FD3-A60D6E05506F}"/>
                </a:ext>
              </a:extLst>
            </p:cNvPr>
            <p:cNvCxnSpPr/>
            <p:nvPr/>
          </p:nvCxnSpPr>
          <p:spPr>
            <a:xfrm>
              <a:off x="2489949" y="4330939"/>
              <a:ext cx="166469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grpSp>
          <p:nvGrpSpPr>
            <p:cNvPr id="171" name="グループ化 170">
              <a:extLst>
                <a:ext uri="{FF2B5EF4-FFF2-40B4-BE49-F238E27FC236}">
                  <a16:creationId xmlns:a16="http://schemas.microsoft.com/office/drawing/2014/main" id="{DCA6E499-D77F-4B80-9281-9590DBA6F1E9}"/>
                </a:ext>
              </a:extLst>
            </p:cNvPr>
            <p:cNvGrpSpPr/>
            <p:nvPr/>
          </p:nvGrpSpPr>
          <p:grpSpPr>
            <a:xfrm>
              <a:off x="2490313" y="4322591"/>
              <a:ext cx="0" cy="683794"/>
              <a:chOff x="2490313" y="4322591"/>
              <a:chExt cx="0" cy="683794"/>
            </a:xfrm>
          </p:grpSpPr>
          <p:cxnSp>
            <p:nvCxnSpPr>
              <p:cNvPr id="175" name="直線コネクタ 174">
                <a:extLst>
                  <a:ext uri="{FF2B5EF4-FFF2-40B4-BE49-F238E27FC236}">
                    <a16:creationId xmlns:a16="http://schemas.microsoft.com/office/drawing/2014/main" id="{2AB1A0BB-730B-4888-9391-F8DF15CDFE7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0313" y="4322591"/>
                <a:ext cx="0" cy="112412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76" name="直線コネクタ 175">
                <a:extLst>
                  <a:ext uri="{FF2B5EF4-FFF2-40B4-BE49-F238E27FC236}">
                    <a16:creationId xmlns:a16="http://schemas.microsoft.com/office/drawing/2014/main" id="{B9E979E6-D360-4FCE-802D-49BA738176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90313" y="4427558"/>
                <a:ext cx="0" cy="578827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72" name="グループ化 171">
              <a:extLst>
                <a:ext uri="{FF2B5EF4-FFF2-40B4-BE49-F238E27FC236}">
                  <a16:creationId xmlns:a16="http://schemas.microsoft.com/office/drawing/2014/main" id="{3739EC71-7AE7-41C3-8EB7-FA48DBA15DF7}"/>
                </a:ext>
              </a:extLst>
            </p:cNvPr>
            <p:cNvGrpSpPr/>
            <p:nvPr/>
          </p:nvGrpSpPr>
          <p:grpSpPr>
            <a:xfrm>
              <a:off x="2657274" y="4318266"/>
              <a:ext cx="0" cy="690938"/>
              <a:chOff x="2660805" y="4321797"/>
              <a:chExt cx="0" cy="690938"/>
            </a:xfrm>
          </p:grpSpPr>
          <p:cxnSp>
            <p:nvCxnSpPr>
              <p:cNvPr id="173" name="直線コネクタ 172">
                <a:extLst>
                  <a:ext uri="{FF2B5EF4-FFF2-40B4-BE49-F238E27FC236}">
                    <a16:creationId xmlns:a16="http://schemas.microsoft.com/office/drawing/2014/main" id="{5164C481-B337-46E3-887C-2AD7097D5A2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660805" y="4321797"/>
                <a:ext cx="0" cy="112412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74" name="直線コネクタ 173">
                <a:extLst>
                  <a:ext uri="{FF2B5EF4-FFF2-40B4-BE49-F238E27FC236}">
                    <a16:creationId xmlns:a16="http://schemas.microsoft.com/office/drawing/2014/main" id="{F1B8E3D8-A7D7-4054-B0D8-64F51980CC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60805" y="4433908"/>
                <a:ext cx="0" cy="578827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7" name="グループ化 176">
            <a:extLst>
              <a:ext uri="{FF2B5EF4-FFF2-40B4-BE49-F238E27FC236}">
                <a16:creationId xmlns:a16="http://schemas.microsoft.com/office/drawing/2014/main" id="{27E44219-90A1-4649-969B-CE532731F62B}"/>
              </a:ext>
            </a:extLst>
          </p:cNvPr>
          <p:cNvGrpSpPr/>
          <p:nvPr/>
        </p:nvGrpSpPr>
        <p:grpSpPr>
          <a:xfrm>
            <a:off x="5592362" y="889505"/>
            <a:ext cx="591559" cy="1213715"/>
            <a:chOff x="5922332" y="3924646"/>
            <a:chExt cx="626049" cy="1560392"/>
          </a:xfrm>
        </p:grpSpPr>
        <p:grpSp>
          <p:nvGrpSpPr>
            <p:cNvPr id="178" name="グループ化 177">
              <a:extLst>
                <a:ext uri="{FF2B5EF4-FFF2-40B4-BE49-F238E27FC236}">
                  <a16:creationId xmlns:a16="http://schemas.microsoft.com/office/drawing/2014/main" id="{F0C27C68-ABC8-4AC6-A36D-3815FD2C4B89}"/>
                </a:ext>
              </a:extLst>
            </p:cNvPr>
            <p:cNvGrpSpPr/>
            <p:nvPr/>
          </p:nvGrpSpPr>
          <p:grpSpPr>
            <a:xfrm>
              <a:off x="6378342" y="4456453"/>
              <a:ext cx="170039" cy="113206"/>
              <a:chOff x="7114083" y="3349826"/>
              <a:chExt cx="380497" cy="94419"/>
            </a:xfrm>
          </p:grpSpPr>
          <p:cxnSp>
            <p:nvCxnSpPr>
              <p:cNvPr id="205" name="直線コネクタ 204">
                <a:extLst>
                  <a:ext uri="{FF2B5EF4-FFF2-40B4-BE49-F238E27FC236}">
                    <a16:creationId xmlns:a16="http://schemas.microsoft.com/office/drawing/2014/main" id="{AB55E278-70A8-4EAA-874E-B688AB3F5B94}"/>
                  </a:ext>
                </a:extLst>
              </p:cNvPr>
              <p:cNvCxnSpPr/>
              <p:nvPr/>
            </p:nvCxnSpPr>
            <p:spPr>
              <a:xfrm>
                <a:off x="7114083" y="3355027"/>
                <a:ext cx="37250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6" name="直線コネクタ 205">
                <a:extLst>
                  <a:ext uri="{FF2B5EF4-FFF2-40B4-BE49-F238E27FC236}">
                    <a16:creationId xmlns:a16="http://schemas.microsoft.com/office/drawing/2014/main" id="{3792055C-B08A-4FE5-8646-713B048A591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115216" y="3350488"/>
                <a:ext cx="0" cy="9375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7" name="直線コネクタ 206">
                <a:extLst>
                  <a:ext uri="{FF2B5EF4-FFF2-40B4-BE49-F238E27FC236}">
                    <a16:creationId xmlns:a16="http://schemas.microsoft.com/office/drawing/2014/main" id="{C63FC6F2-A6A7-47EA-AC74-D87B65EE62C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494580" y="3349826"/>
                <a:ext cx="0" cy="9375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79" name="グループ化 178">
              <a:extLst>
                <a:ext uri="{FF2B5EF4-FFF2-40B4-BE49-F238E27FC236}">
                  <a16:creationId xmlns:a16="http://schemas.microsoft.com/office/drawing/2014/main" id="{FD301DEA-F03A-46E0-A055-5CB928AF651F}"/>
                </a:ext>
              </a:extLst>
            </p:cNvPr>
            <p:cNvGrpSpPr/>
            <p:nvPr/>
          </p:nvGrpSpPr>
          <p:grpSpPr>
            <a:xfrm>
              <a:off x="5922332" y="4229883"/>
              <a:ext cx="369927" cy="84372"/>
              <a:chOff x="7114083" y="3349826"/>
              <a:chExt cx="372509" cy="94419"/>
            </a:xfrm>
          </p:grpSpPr>
          <p:cxnSp>
            <p:nvCxnSpPr>
              <p:cNvPr id="202" name="直線コネクタ 201">
                <a:extLst>
                  <a:ext uri="{FF2B5EF4-FFF2-40B4-BE49-F238E27FC236}">
                    <a16:creationId xmlns:a16="http://schemas.microsoft.com/office/drawing/2014/main" id="{C17D842A-1F26-4E52-BF70-E0D946C5F7D9}"/>
                  </a:ext>
                </a:extLst>
              </p:cNvPr>
              <p:cNvCxnSpPr/>
              <p:nvPr/>
            </p:nvCxnSpPr>
            <p:spPr>
              <a:xfrm>
                <a:off x="7114083" y="3350488"/>
                <a:ext cx="37250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3" name="直線コネクタ 202">
                <a:extLst>
                  <a:ext uri="{FF2B5EF4-FFF2-40B4-BE49-F238E27FC236}">
                    <a16:creationId xmlns:a16="http://schemas.microsoft.com/office/drawing/2014/main" id="{6B9F3FDF-5BC7-4761-9CF7-A79BEB16CF1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115216" y="3350488"/>
                <a:ext cx="0" cy="9375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4" name="直線コネクタ 203">
                <a:extLst>
                  <a:ext uri="{FF2B5EF4-FFF2-40B4-BE49-F238E27FC236}">
                    <a16:creationId xmlns:a16="http://schemas.microsoft.com/office/drawing/2014/main" id="{E779332D-8B97-459D-8DA0-5DDE8D86A2C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481047" y="3349826"/>
                <a:ext cx="0" cy="9375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80" name="グループ化 179">
              <a:extLst>
                <a:ext uri="{FF2B5EF4-FFF2-40B4-BE49-F238E27FC236}">
                  <a16:creationId xmlns:a16="http://schemas.microsoft.com/office/drawing/2014/main" id="{270E71E1-1575-4C2C-8C85-B0590D8FDF32}"/>
                </a:ext>
              </a:extLst>
            </p:cNvPr>
            <p:cNvGrpSpPr/>
            <p:nvPr/>
          </p:nvGrpSpPr>
          <p:grpSpPr>
            <a:xfrm>
              <a:off x="5922338" y="3924646"/>
              <a:ext cx="585359" cy="97604"/>
              <a:chOff x="5922338" y="3924646"/>
              <a:chExt cx="585359" cy="97604"/>
            </a:xfrm>
          </p:grpSpPr>
          <p:cxnSp>
            <p:nvCxnSpPr>
              <p:cNvPr id="199" name="直線コネクタ 198">
                <a:extLst>
                  <a:ext uri="{FF2B5EF4-FFF2-40B4-BE49-F238E27FC236}">
                    <a16:creationId xmlns:a16="http://schemas.microsoft.com/office/drawing/2014/main" id="{E596B058-4712-404E-86D0-B2716CA8E57A}"/>
                  </a:ext>
                </a:extLst>
              </p:cNvPr>
              <p:cNvCxnSpPr/>
              <p:nvPr/>
            </p:nvCxnSpPr>
            <p:spPr>
              <a:xfrm>
                <a:off x="5922338" y="3930733"/>
                <a:ext cx="58535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0" name="直線コネクタ 199">
                <a:extLst>
                  <a:ext uri="{FF2B5EF4-FFF2-40B4-BE49-F238E27FC236}">
                    <a16:creationId xmlns:a16="http://schemas.microsoft.com/office/drawing/2014/main" id="{E7400DDB-F0DA-4D8C-BDBC-0C41E1AF57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924118" y="3930733"/>
                <a:ext cx="0" cy="9151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01" name="直線コネクタ 200">
                <a:extLst>
                  <a:ext uri="{FF2B5EF4-FFF2-40B4-BE49-F238E27FC236}">
                    <a16:creationId xmlns:a16="http://schemas.microsoft.com/office/drawing/2014/main" id="{D726D60D-6E77-459B-AD77-7BDE0B7C6BD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05989" y="3924646"/>
                <a:ext cx="0" cy="9151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81" name="グループ化 180">
              <a:extLst>
                <a:ext uri="{FF2B5EF4-FFF2-40B4-BE49-F238E27FC236}">
                  <a16:creationId xmlns:a16="http://schemas.microsoft.com/office/drawing/2014/main" id="{37464CDB-EFEB-435B-A5E8-00D7F876223A}"/>
                </a:ext>
              </a:extLst>
            </p:cNvPr>
            <p:cNvGrpSpPr/>
            <p:nvPr/>
          </p:nvGrpSpPr>
          <p:grpSpPr>
            <a:xfrm>
              <a:off x="6117575" y="4098485"/>
              <a:ext cx="393278" cy="67406"/>
              <a:chOff x="6117575" y="4098485"/>
              <a:chExt cx="393278" cy="67406"/>
            </a:xfrm>
          </p:grpSpPr>
          <p:cxnSp>
            <p:nvCxnSpPr>
              <p:cNvPr id="196" name="直線コネクタ 195">
                <a:extLst>
                  <a:ext uri="{FF2B5EF4-FFF2-40B4-BE49-F238E27FC236}">
                    <a16:creationId xmlns:a16="http://schemas.microsoft.com/office/drawing/2014/main" id="{359EAA59-584F-40A7-98D1-286250341D8F}"/>
                  </a:ext>
                </a:extLst>
              </p:cNvPr>
              <p:cNvCxnSpPr/>
              <p:nvPr/>
            </p:nvCxnSpPr>
            <p:spPr>
              <a:xfrm>
                <a:off x="6117575" y="4104362"/>
                <a:ext cx="393278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97" name="直線コネクタ 196">
                <a:extLst>
                  <a:ext uri="{FF2B5EF4-FFF2-40B4-BE49-F238E27FC236}">
                    <a16:creationId xmlns:a16="http://schemas.microsoft.com/office/drawing/2014/main" id="{286EC8D0-42EE-4E4D-AAEF-8FB66023234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123251" y="4104360"/>
                <a:ext cx="0" cy="61531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98" name="直線コネクタ 197">
                <a:extLst>
                  <a:ext uri="{FF2B5EF4-FFF2-40B4-BE49-F238E27FC236}">
                    <a16:creationId xmlns:a16="http://schemas.microsoft.com/office/drawing/2014/main" id="{37BB7171-1B9C-4C41-A963-915E9A5171D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09506" y="4098485"/>
                <a:ext cx="0" cy="61529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id="{C35B29D9-5481-4AC5-8FBC-DE20BBBDC242}"/>
                </a:ext>
              </a:extLst>
            </p:cNvPr>
            <p:cNvGrpSpPr/>
            <p:nvPr/>
          </p:nvGrpSpPr>
          <p:grpSpPr>
            <a:xfrm>
              <a:off x="6173802" y="4459308"/>
              <a:ext cx="170039" cy="1020587"/>
              <a:chOff x="6137410" y="4459308"/>
              <a:chExt cx="170039" cy="1020587"/>
            </a:xfrm>
          </p:grpSpPr>
          <p:cxnSp>
            <p:nvCxnSpPr>
              <p:cNvPr id="191" name="直線コネクタ 190">
                <a:extLst>
                  <a:ext uri="{FF2B5EF4-FFF2-40B4-BE49-F238E27FC236}">
                    <a16:creationId xmlns:a16="http://schemas.microsoft.com/office/drawing/2014/main" id="{C718CE3E-4DF2-41E2-B1FD-52225BB36AF4}"/>
                  </a:ext>
                </a:extLst>
              </p:cNvPr>
              <p:cNvCxnSpPr/>
              <p:nvPr/>
            </p:nvCxnSpPr>
            <p:spPr>
              <a:xfrm>
                <a:off x="6137410" y="4465545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92" name="直線コネクタ 191">
                <a:extLst>
                  <a:ext uri="{FF2B5EF4-FFF2-40B4-BE49-F238E27FC236}">
                    <a16:creationId xmlns:a16="http://schemas.microsoft.com/office/drawing/2014/main" id="{3721515A-F472-4B61-9594-428C0EEBCC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307449" y="4459308"/>
                <a:ext cx="0" cy="112412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93" name="グループ化 192">
                <a:extLst>
                  <a:ext uri="{FF2B5EF4-FFF2-40B4-BE49-F238E27FC236}">
                    <a16:creationId xmlns:a16="http://schemas.microsoft.com/office/drawing/2014/main" id="{92258050-E28A-4F11-8725-7152182FAE8C}"/>
                  </a:ext>
                </a:extLst>
              </p:cNvPr>
              <p:cNvGrpSpPr/>
              <p:nvPr/>
            </p:nvGrpSpPr>
            <p:grpSpPr>
              <a:xfrm>
                <a:off x="6142003" y="4468130"/>
                <a:ext cx="1943" cy="1011765"/>
                <a:chOff x="6151101" y="4468130"/>
                <a:chExt cx="1943" cy="1011765"/>
              </a:xfrm>
            </p:grpSpPr>
            <p:cxnSp>
              <p:nvCxnSpPr>
                <p:cNvPr id="194" name="直線コネクタ 193">
                  <a:extLst>
                    <a:ext uri="{FF2B5EF4-FFF2-40B4-BE49-F238E27FC236}">
                      <a16:creationId xmlns:a16="http://schemas.microsoft.com/office/drawing/2014/main" id="{D5D4CD1C-632B-4A38-BAB8-B92FEE685D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151101" y="4468130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95" name="直線コネクタ 194">
                  <a:extLst>
                    <a:ext uri="{FF2B5EF4-FFF2-40B4-BE49-F238E27FC236}">
                      <a16:creationId xmlns:a16="http://schemas.microsoft.com/office/drawing/2014/main" id="{A96E2334-5D34-43B7-B36B-9FB41BD6FAF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53044" y="4536321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30AA18BC-10B4-4296-949F-83600FA13C9C}"/>
                </a:ext>
              </a:extLst>
            </p:cNvPr>
            <p:cNvGrpSpPr/>
            <p:nvPr/>
          </p:nvGrpSpPr>
          <p:grpSpPr>
            <a:xfrm>
              <a:off x="5963896" y="4461325"/>
              <a:ext cx="170491" cy="1023713"/>
              <a:chOff x="5922955" y="4465874"/>
              <a:chExt cx="170491" cy="1023713"/>
            </a:xfrm>
          </p:grpSpPr>
          <p:cxnSp>
            <p:nvCxnSpPr>
              <p:cNvPr id="184" name="直線コネクタ 183">
                <a:extLst>
                  <a:ext uri="{FF2B5EF4-FFF2-40B4-BE49-F238E27FC236}">
                    <a16:creationId xmlns:a16="http://schemas.microsoft.com/office/drawing/2014/main" id="{A9E4E6A1-C6D0-42FD-B959-7B34655673FC}"/>
                  </a:ext>
                </a:extLst>
              </p:cNvPr>
              <p:cNvCxnSpPr/>
              <p:nvPr/>
            </p:nvCxnSpPr>
            <p:spPr>
              <a:xfrm>
                <a:off x="5923066" y="4473335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185" name="グループ化 184">
                <a:extLst>
                  <a:ext uri="{FF2B5EF4-FFF2-40B4-BE49-F238E27FC236}">
                    <a16:creationId xmlns:a16="http://schemas.microsoft.com/office/drawing/2014/main" id="{A0A0B3C0-7E73-4CA9-B3E0-4500E8572C16}"/>
                  </a:ext>
                </a:extLst>
              </p:cNvPr>
              <p:cNvGrpSpPr/>
              <p:nvPr/>
            </p:nvGrpSpPr>
            <p:grpSpPr>
              <a:xfrm>
                <a:off x="5922955" y="4465874"/>
                <a:ext cx="0" cy="1023713"/>
                <a:chOff x="5922955" y="4465874"/>
                <a:chExt cx="0" cy="1023713"/>
              </a:xfrm>
            </p:grpSpPr>
            <p:cxnSp>
              <p:nvCxnSpPr>
                <p:cNvPr id="189" name="直線コネクタ 188">
                  <a:extLst>
                    <a:ext uri="{FF2B5EF4-FFF2-40B4-BE49-F238E27FC236}">
                      <a16:creationId xmlns:a16="http://schemas.microsoft.com/office/drawing/2014/main" id="{FBF023EC-7C7A-4737-8D75-21B008595C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922955" y="4465874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90" name="直線コネクタ 189">
                  <a:extLst>
                    <a:ext uri="{FF2B5EF4-FFF2-40B4-BE49-F238E27FC236}">
                      <a16:creationId xmlns:a16="http://schemas.microsoft.com/office/drawing/2014/main" id="{4AD2AE4E-FF74-4872-BCDB-25692FAAB1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22955" y="4546013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6" name="グループ化 185">
                <a:extLst>
                  <a:ext uri="{FF2B5EF4-FFF2-40B4-BE49-F238E27FC236}">
                    <a16:creationId xmlns:a16="http://schemas.microsoft.com/office/drawing/2014/main" id="{0589C789-9CE5-40B9-8C43-03EE097767A7}"/>
                  </a:ext>
                </a:extLst>
              </p:cNvPr>
              <p:cNvGrpSpPr/>
              <p:nvPr/>
            </p:nvGrpSpPr>
            <p:grpSpPr>
              <a:xfrm>
                <a:off x="6093446" y="4467089"/>
                <a:ext cx="0" cy="1017173"/>
                <a:chOff x="6093446" y="4457991"/>
                <a:chExt cx="0" cy="1017173"/>
              </a:xfrm>
            </p:grpSpPr>
            <p:cxnSp>
              <p:nvCxnSpPr>
                <p:cNvPr id="187" name="直線コネクタ 186">
                  <a:extLst>
                    <a:ext uri="{FF2B5EF4-FFF2-40B4-BE49-F238E27FC236}">
                      <a16:creationId xmlns:a16="http://schemas.microsoft.com/office/drawing/2014/main" id="{9134506B-E985-4E65-8713-FA9A2CC4AD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6093446" y="4457991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188" name="直線コネクタ 187">
                  <a:extLst>
                    <a:ext uri="{FF2B5EF4-FFF2-40B4-BE49-F238E27FC236}">
                      <a16:creationId xmlns:a16="http://schemas.microsoft.com/office/drawing/2014/main" id="{718DA89D-E277-4418-A03A-BE6D2E10DB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93446" y="4531590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0BBD7018-C59B-41E8-9814-40381BA54735}"/>
              </a:ext>
            </a:extLst>
          </p:cNvPr>
          <p:cNvGrpSpPr/>
          <p:nvPr/>
        </p:nvGrpSpPr>
        <p:grpSpPr>
          <a:xfrm>
            <a:off x="4698184" y="903075"/>
            <a:ext cx="764842" cy="1225291"/>
            <a:chOff x="4698184" y="2924142"/>
            <a:chExt cx="764842" cy="1225291"/>
          </a:xfrm>
        </p:grpSpPr>
        <p:grpSp>
          <p:nvGrpSpPr>
            <p:cNvPr id="208" name="グループ化 207">
              <a:extLst>
                <a:ext uri="{FF2B5EF4-FFF2-40B4-BE49-F238E27FC236}">
                  <a16:creationId xmlns:a16="http://schemas.microsoft.com/office/drawing/2014/main" id="{F289020B-467A-4FB3-A79D-95F308DCE6B5}"/>
                </a:ext>
              </a:extLst>
            </p:cNvPr>
            <p:cNvGrpSpPr/>
            <p:nvPr/>
          </p:nvGrpSpPr>
          <p:grpSpPr>
            <a:xfrm>
              <a:off x="4701485" y="3158738"/>
              <a:ext cx="353286" cy="65235"/>
              <a:chOff x="4958975" y="4236805"/>
              <a:chExt cx="373884" cy="84372"/>
            </a:xfrm>
          </p:grpSpPr>
          <p:cxnSp>
            <p:nvCxnSpPr>
              <p:cNvPr id="209" name="直線コネクタ 208">
                <a:extLst>
                  <a:ext uri="{FF2B5EF4-FFF2-40B4-BE49-F238E27FC236}">
                    <a16:creationId xmlns:a16="http://schemas.microsoft.com/office/drawing/2014/main" id="{2BB20E88-D61F-441A-9D58-2C32B1487D7A}"/>
                  </a:ext>
                </a:extLst>
              </p:cNvPr>
              <p:cNvCxnSpPr/>
              <p:nvPr/>
            </p:nvCxnSpPr>
            <p:spPr>
              <a:xfrm>
                <a:off x="4958975" y="4243205"/>
                <a:ext cx="369927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0" name="直線コネクタ 209">
                <a:extLst>
                  <a:ext uri="{FF2B5EF4-FFF2-40B4-BE49-F238E27FC236}">
                    <a16:creationId xmlns:a16="http://schemas.microsoft.com/office/drawing/2014/main" id="{2503DD9E-93D8-47DB-88F2-086AD8B0609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960100" y="4237397"/>
                <a:ext cx="0" cy="8378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1" name="直線コネクタ 210">
                <a:extLst>
                  <a:ext uri="{FF2B5EF4-FFF2-40B4-BE49-F238E27FC236}">
                    <a16:creationId xmlns:a16="http://schemas.microsoft.com/office/drawing/2014/main" id="{D000738A-2435-47ED-BE0E-28CA63CEC87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32859" y="4236805"/>
                <a:ext cx="0" cy="8378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212" name="グループ化 211">
              <a:extLst>
                <a:ext uri="{FF2B5EF4-FFF2-40B4-BE49-F238E27FC236}">
                  <a16:creationId xmlns:a16="http://schemas.microsoft.com/office/drawing/2014/main" id="{AEBFC169-DB1C-4212-B234-C5724D2F0B7C}"/>
                </a:ext>
              </a:extLst>
            </p:cNvPr>
            <p:cNvGrpSpPr/>
            <p:nvPr/>
          </p:nvGrpSpPr>
          <p:grpSpPr>
            <a:xfrm>
              <a:off x="4698184" y="2924142"/>
              <a:ext cx="553111" cy="71259"/>
              <a:chOff x="4940860" y="3237432"/>
              <a:chExt cx="585359" cy="75413"/>
            </a:xfrm>
          </p:grpSpPr>
          <p:cxnSp>
            <p:nvCxnSpPr>
              <p:cNvPr id="213" name="直線コネクタ 212">
                <a:extLst>
                  <a:ext uri="{FF2B5EF4-FFF2-40B4-BE49-F238E27FC236}">
                    <a16:creationId xmlns:a16="http://schemas.microsoft.com/office/drawing/2014/main" id="{B72F168D-5D3D-436E-8047-B1E17E1BFAF1}"/>
                  </a:ext>
                </a:extLst>
              </p:cNvPr>
              <p:cNvCxnSpPr/>
              <p:nvPr/>
            </p:nvCxnSpPr>
            <p:spPr>
              <a:xfrm>
                <a:off x="4940860" y="3237961"/>
                <a:ext cx="58535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4" name="直線コネクタ 213">
                <a:extLst>
                  <a:ext uri="{FF2B5EF4-FFF2-40B4-BE49-F238E27FC236}">
                    <a16:creationId xmlns:a16="http://schemas.microsoft.com/office/drawing/2014/main" id="{E528DD6F-C161-4A2F-B58F-2D26F4882BB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947664" y="3237961"/>
                <a:ext cx="0" cy="74884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5" name="直線コネクタ 214">
                <a:extLst>
                  <a:ext uri="{FF2B5EF4-FFF2-40B4-BE49-F238E27FC236}">
                    <a16:creationId xmlns:a16="http://schemas.microsoft.com/office/drawing/2014/main" id="{4F13CE0E-0656-4442-9277-40001CB0423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24445" y="3237432"/>
                <a:ext cx="0" cy="74884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216" name="グループ化 215">
              <a:extLst>
                <a:ext uri="{FF2B5EF4-FFF2-40B4-BE49-F238E27FC236}">
                  <a16:creationId xmlns:a16="http://schemas.microsoft.com/office/drawing/2014/main" id="{57BDA0F1-02EC-43A7-A46E-92B8C0D574CC}"/>
                </a:ext>
              </a:extLst>
            </p:cNvPr>
            <p:cNvGrpSpPr/>
            <p:nvPr/>
          </p:nvGrpSpPr>
          <p:grpSpPr>
            <a:xfrm>
              <a:off x="4895831" y="3056655"/>
              <a:ext cx="371612" cy="47909"/>
              <a:chOff x="5127631" y="3373186"/>
              <a:chExt cx="393278" cy="50702"/>
            </a:xfrm>
          </p:grpSpPr>
          <p:cxnSp>
            <p:nvCxnSpPr>
              <p:cNvPr id="217" name="直線コネクタ 216">
                <a:extLst>
                  <a:ext uri="{FF2B5EF4-FFF2-40B4-BE49-F238E27FC236}">
                    <a16:creationId xmlns:a16="http://schemas.microsoft.com/office/drawing/2014/main" id="{CBFA0591-FD0C-4EA1-A867-667A890CD219}"/>
                  </a:ext>
                </a:extLst>
              </p:cNvPr>
              <p:cNvCxnSpPr/>
              <p:nvPr/>
            </p:nvCxnSpPr>
            <p:spPr>
              <a:xfrm>
                <a:off x="5127631" y="3373541"/>
                <a:ext cx="393278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8" name="直線コネクタ 217">
                <a:extLst>
                  <a:ext uri="{FF2B5EF4-FFF2-40B4-BE49-F238E27FC236}">
                    <a16:creationId xmlns:a16="http://schemas.microsoft.com/office/drawing/2014/main" id="{D36236AC-5DDF-4ABC-BE70-5223C6E6EBD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29371" y="3373541"/>
                <a:ext cx="0" cy="5034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219" name="直線コネクタ 218">
                <a:extLst>
                  <a:ext uri="{FF2B5EF4-FFF2-40B4-BE49-F238E27FC236}">
                    <a16:creationId xmlns:a16="http://schemas.microsoft.com/office/drawing/2014/main" id="{1196224F-03C9-4134-96D5-A22410C2B41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15852" y="3373186"/>
                <a:ext cx="0" cy="50347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220" name="グループ化 219">
              <a:extLst>
                <a:ext uri="{FF2B5EF4-FFF2-40B4-BE49-F238E27FC236}">
                  <a16:creationId xmlns:a16="http://schemas.microsoft.com/office/drawing/2014/main" id="{2302AE2B-1E53-4AAB-9268-B27896F6F697}"/>
                </a:ext>
              </a:extLst>
            </p:cNvPr>
            <p:cNvGrpSpPr/>
            <p:nvPr/>
          </p:nvGrpSpPr>
          <p:grpSpPr>
            <a:xfrm>
              <a:off x="4718005" y="3343766"/>
              <a:ext cx="200755" cy="801729"/>
              <a:chOff x="4992896" y="4465159"/>
              <a:chExt cx="212460" cy="1036927"/>
            </a:xfrm>
          </p:grpSpPr>
          <p:cxnSp>
            <p:nvCxnSpPr>
              <p:cNvPr id="221" name="直線コネクタ 220">
                <a:extLst>
                  <a:ext uri="{FF2B5EF4-FFF2-40B4-BE49-F238E27FC236}">
                    <a16:creationId xmlns:a16="http://schemas.microsoft.com/office/drawing/2014/main" id="{2748431F-B4FE-41A0-B6E1-9DFD28656CBF}"/>
                  </a:ext>
                </a:extLst>
              </p:cNvPr>
              <p:cNvCxnSpPr/>
              <p:nvPr/>
            </p:nvCxnSpPr>
            <p:spPr>
              <a:xfrm>
                <a:off x="4996094" y="4471299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22" name="グループ化 221">
                <a:extLst>
                  <a:ext uri="{FF2B5EF4-FFF2-40B4-BE49-F238E27FC236}">
                    <a16:creationId xmlns:a16="http://schemas.microsoft.com/office/drawing/2014/main" id="{C91D35E6-0D44-4537-870E-8D2BCBA9D3A6}"/>
                  </a:ext>
                </a:extLst>
              </p:cNvPr>
              <p:cNvGrpSpPr/>
              <p:nvPr/>
            </p:nvGrpSpPr>
            <p:grpSpPr>
              <a:xfrm>
                <a:off x="4992896" y="4465159"/>
                <a:ext cx="0" cy="1036927"/>
                <a:chOff x="4956504" y="4469708"/>
                <a:chExt cx="0" cy="1036927"/>
              </a:xfrm>
            </p:grpSpPr>
            <p:cxnSp>
              <p:nvCxnSpPr>
                <p:cNvPr id="226" name="直線コネクタ 225">
                  <a:extLst>
                    <a:ext uri="{FF2B5EF4-FFF2-40B4-BE49-F238E27FC236}">
                      <a16:creationId xmlns:a16="http://schemas.microsoft.com/office/drawing/2014/main" id="{C2CD7E50-B249-4DDF-BA96-1F90FFA8CB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4956504" y="4469708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27" name="直線コネクタ 226">
                  <a:extLst>
                    <a:ext uri="{FF2B5EF4-FFF2-40B4-BE49-F238E27FC236}">
                      <a16:creationId xmlns:a16="http://schemas.microsoft.com/office/drawing/2014/main" id="{1738196C-D8A7-4A7D-8B57-721C5F07B1E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956504" y="4563061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447FF933-934B-4D48-BD57-958ECA143850}"/>
                  </a:ext>
                </a:extLst>
              </p:cNvPr>
              <p:cNvGrpSpPr/>
              <p:nvPr/>
            </p:nvGrpSpPr>
            <p:grpSpPr>
              <a:xfrm>
                <a:off x="5159637" y="4468914"/>
                <a:ext cx="45719" cy="1028569"/>
                <a:chOff x="5107473" y="4468914"/>
                <a:chExt cx="0" cy="1047561"/>
              </a:xfrm>
            </p:grpSpPr>
            <p:cxnSp>
              <p:nvCxnSpPr>
                <p:cNvPr id="224" name="直線コネクタ 223">
                  <a:extLst>
                    <a:ext uri="{FF2B5EF4-FFF2-40B4-BE49-F238E27FC236}">
                      <a16:creationId xmlns:a16="http://schemas.microsoft.com/office/drawing/2014/main" id="{D0FDE8DB-AB3E-4047-A85B-3851B06C55B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107473" y="4468914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AF32EC24-C1D4-4C07-8F5E-391F69910A5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07473" y="4572901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28" name="グループ化 227">
              <a:extLst>
                <a:ext uri="{FF2B5EF4-FFF2-40B4-BE49-F238E27FC236}">
                  <a16:creationId xmlns:a16="http://schemas.microsoft.com/office/drawing/2014/main" id="{5CF55629-4B63-4EE1-846B-B05AF48C3FCF}"/>
                </a:ext>
              </a:extLst>
            </p:cNvPr>
            <p:cNvGrpSpPr/>
            <p:nvPr/>
          </p:nvGrpSpPr>
          <p:grpSpPr>
            <a:xfrm>
              <a:off x="4919037" y="3348159"/>
              <a:ext cx="160670" cy="801274"/>
              <a:chOff x="5174046" y="4471396"/>
              <a:chExt cx="170038" cy="1036337"/>
            </a:xfrm>
          </p:grpSpPr>
          <p:cxnSp>
            <p:nvCxnSpPr>
              <p:cNvPr id="229" name="直線コネクタ 228">
                <a:extLst>
                  <a:ext uri="{FF2B5EF4-FFF2-40B4-BE49-F238E27FC236}">
                    <a16:creationId xmlns:a16="http://schemas.microsoft.com/office/drawing/2014/main" id="{98BCC1D7-C8F4-47D6-8767-9310B0AE2B1F}"/>
                  </a:ext>
                </a:extLst>
              </p:cNvPr>
              <p:cNvCxnSpPr/>
              <p:nvPr/>
            </p:nvCxnSpPr>
            <p:spPr>
              <a:xfrm>
                <a:off x="5174046" y="4473187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30" name="グループ化 229">
                <a:extLst>
                  <a:ext uri="{FF2B5EF4-FFF2-40B4-BE49-F238E27FC236}">
                    <a16:creationId xmlns:a16="http://schemas.microsoft.com/office/drawing/2014/main" id="{79C1273E-AACD-408D-B421-0D740C515C04}"/>
                  </a:ext>
                </a:extLst>
              </p:cNvPr>
              <p:cNvGrpSpPr/>
              <p:nvPr/>
            </p:nvGrpSpPr>
            <p:grpSpPr>
              <a:xfrm>
                <a:off x="5175067" y="4472190"/>
                <a:ext cx="0" cy="1035543"/>
                <a:chOff x="5175067" y="4472190"/>
                <a:chExt cx="0" cy="1035543"/>
              </a:xfrm>
            </p:grpSpPr>
            <p:cxnSp>
              <p:nvCxnSpPr>
                <p:cNvPr id="234" name="直線コネクタ 233">
                  <a:extLst>
                    <a:ext uri="{FF2B5EF4-FFF2-40B4-BE49-F238E27FC236}">
                      <a16:creationId xmlns:a16="http://schemas.microsoft.com/office/drawing/2014/main" id="{F201C1E1-8204-4E54-B538-864FDFA6CA6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175067" y="4472190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35" name="直線コネクタ 234">
                  <a:extLst>
                    <a:ext uri="{FF2B5EF4-FFF2-40B4-BE49-F238E27FC236}">
                      <a16:creationId xmlns:a16="http://schemas.microsoft.com/office/drawing/2014/main" id="{653D934A-614B-42A5-B99B-ECF9A050529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75067" y="4564159"/>
                  <a:ext cx="0" cy="943574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1" name="グループ化 230">
                <a:extLst>
                  <a:ext uri="{FF2B5EF4-FFF2-40B4-BE49-F238E27FC236}">
                    <a16:creationId xmlns:a16="http://schemas.microsoft.com/office/drawing/2014/main" id="{BD7AAC2F-EDF0-426D-BC9F-E5EB44119606}"/>
                  </a:ext>
                </a:extLst>
              </p:cNvPr>
              <p:cNvGrpSpPr/>
              <p:nvPr/>
            </p:nvGrpSpPr>
            <p:grpSpPr>
              <a:xfrm>
                <a:off x="5344084" y="4471396"/>
                <a:ext cx="0" cy="682401"/>
                <a:chOff x="5344084" y="4471396"/>
                <a:chExt cx="0" cy="682401"/>
              </a:xfrm>
            </p:grpSpPr>
            <p:cxnSp>
              <p:nvCxnSpPr>
                <p:cNvPr id="232" name="直線コネクタ 231">
                  <a:extLst>
                    <a:ext uri="{FF2B5EF4-FFF2-40B4-BE49-F238E27FC236}">
                      <a16:creationId xmlns:a16="http://schemas.microsoft.com/office/drawing/2014/main" id="{C4BB9A7B-9851-4DEF-B241-2A9538AD9B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344084" y="4471396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33" name="直線コネクタ 232">
                  <a:extLst>
                    <a:ext uri="{FF2B5EF4-FFF2-40B4-BE49-F238E27FC236}">
                      <a16:creationId xmlns:a16="http://schemas.microsoft.com/office/drawing/2014/main" id="{4471F46E-2D7C-4536-8CC3-DF12FA7072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44084" y="4574970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36" name="グループ化 235">
              <a:extLst>
                <a:ext uri="{FF2B5EF4-FFF2-40B4-BE49-F238E27FC236}">
                  <a16:creationId xmlns:a16="http://schemas.microsoft.com/office/drawing/2014/main" id="{16916383-7CBB-4E06-93E6-754F432A9DB2}"/>
                </a:ext>
              </a:extLst>
            </p:cNvPr>
            <p:cNvGrpSpPr/>
            <p:nvPr/>
          </p:nvGrpSpPr>
          <p:grpSpPr>
            <a:xfrm>
              <a:off x="5124977" y="3345700"/>
              <a:ext cx="338049" cy="536127"/>
              <a:chOff x="5392233" y="4462191"/>
              <a:chExt cx="357758" cy="693407"/>
            </a:xfrm>
          </p:grpSpPr>
          <p:cxnSp>
            <p:nvCxnSpPr>
              <p:cNvPr id="237" name="直線コネクタ 236">
                <a:extLst>
                  <a:ext uri="{FF2B5EF4-FFF2-40B4-BE49-F238E27FC236}">
                    <a16:creationId xmlns:a16="http://schemas.microsoft.com/office/drawing/2014/main" id="{919ABBA4-390E-439A-A221-CCEC51AAD506}"/>
                  </a:ext>
                </a:extLst>
              </p:cNvPr>
              <p:cNvCxnSpPr/>
              <p:nvPr/>
            </p:nvCxnSpPr>
            <p:spPr>
              <a:xfrm>
                <a:off x="5392233" y="4463650"/>
                <a:ext cx="166469" cy="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grpSp>
            <p:nvGrpSpPr>
              <p:cNvPr id="238" name="グループ化 237">
                <a:extLst>
                  <a:ext uri="{FF2B5EF4-FFF2-40B4-BE49-F238E27FC236}">
                    <a16:creationId xmlns:a16="http://schemas.microsoft.com/office/drawing/2014/main" id="{8C87E553-BE4A-4702-9F52-1770AB405D5F}"/>
                  </a:ext>
                </a:extLst>
              </p:cNvPr>
              <p:cNvGrpSpPr/>
              <p:nvPr/>
            </p:nvGrpSpPr>
            <p:grpSpPr>
              <a:xfrm>
                <a:off x="5395750" y="4462985"/>
                <a:ext cx="0" cy="692613"/>
                <a:chOff x="5395750" y="4462985"/>
                <a:chExt cx="0" cy="692613"/>
              </a:xfrm>
            </p:grpSpPr>
            <p:cxnSp>
              <p:nvCxnSpPr>
                <p:cNvPr id="242" name="直線コネクタ 241">
                  <a:extLst>
                    <a:ext uri="{FF2B5EF4-FFF2-40B4-BE49-F238E27FC236}">
                      <a16:creationId xmlns:a16="http://schemas.microsoft.com/office/drawing/2014/main" id="{CE27D859-B15C-440C-952C-0F8F7BFB73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395750" y="4462985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43" name="直線コネクタ 242">
                  <a:extLst>
                    <a:ext uri="{FF2B5EF4-FFF2-40B4-BE49-F238E27FC236}">
                      <a16:creationId xmlns:a16="http://schemas.microsoft.com/office/drawing/2014/main" id="{6114E9DA-73DB-43DB-A7AF-CAF3A2DA682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95750" y="4576771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9" name="グループ化 238">
                <a:extLst>
                  <a:ext uri="{FF2B5EF4-FFF2-40B4-BE49-F238E27FC236}">
                    <a16:creationId xmlns:a16="http://schemas.microsoft.com/office/drawing/2014/main" id="{01202F9E-6D7E-4015-8659-0B0FC693F2E5}"/>
                  </a:ext>
                </a:extLst>
              </p:cNvPr>
              <p:cNvGrpSpPr/>
              <p:nvPr/>
            </p:nvGrpSpPr>
            <p:grpSpPr>
              <a:xfrm>
                <a:off x="5559416" y="4462191"/>
                <a:ext cx="190575" cy="693407"/>
                <a:chOff x="5564734" y="4462191"/>
                <a:chExt cx="0" cy="678905"/>
              </a:xfrm>
            </p:grpSpPr>
            <p:cxnSp>
              <p:nvCxnSpPr>
                <p:cNvPr id="240" name="直線コネクタ 239">
                  <a:extLst>
                    <a:ext uri="{FF2B5EF4-FFF2-40B4-BE49-F238E27FC236}">
                      <a16:creationId xmlns:a16="http://schemas.microsoft.com/office/drawing/2014/main" id="{C90873D0-CA03-4055-9AD9-73BDBCBA8C2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564734" y="4462191"/>
                  <a:ext cx="0" cy="112412"/>
                </a:xfrm>
                <a:prstGeom prst="lin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cxnSp>
              <p:nvCxnSpPr>
                <p:cNvPr id="241" name="直線コネクタ 240">
                  <a:extLst>
                    <a:ext uri="{FF2B5EF4-FFF2-40B4-BE49-F238E27FC236}">
                      <a16:creationId xmlns:a16="http://schemas.microsoft.com/office/drawing/2014/main" id="{9C9A1CD5-7E80-4DAC-A687-58C648E55D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64734" y="4562269"/>
                  <a:ext cx="0" cy="578827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F0CF4719-2BD6-466E-A43F-62130D8BC1CA}"/>
              </a:ext>
            </a:extLst>
          </p:cNvPr>
          <p:cNvSpPr txBox="1"/>
          <p:nvPr/>
        </p:nvSpPr>
        <p:spPr>
          <a:xfrm>
            <a:off x="-31126" y="5268840"/>
            <a:ext cx="465820" cy="3250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512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51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2BAD0D5F-698B-47BE-8A62-13307E0C43BF}"/>
              </a:ext>
            </a:extLst>
          </p:cNvPr>
          <p:cNvGrpSpPr/>
          <p:nvPr/>
        </p:nvGrpSpPr>
        <p:grpSpPr>
          <a:xfrm>
            <a:off x="-70596" y="5381143"/>
            <a:ext cx="6725574" cy="2291649"/>
            <a:chOff x="-70596" y="6876784"/>
            <a:chExt cx="6725574" cy="2291649"/>
          </a:xfrm>
        </p:grpSpPr>
        <p:grpSp>
          <p:nvGrpSpPr>
            <p:cNvPr id="335" name="グループ化 334">
              <a:extLst>
                <a:ext uri="{FF2B5EF4-FFF2-40B4-BE49-F238E27FC236}">
                  <a16:creationId xmlns:a16="http://schemas.microsoft.com/office/drawing/2014/main" id="{6087E67E-DCFA-41DF-BD33-506B314479F5}"/>
                </a:ext>
              </a:extLst>
            </p:cNvPr>
            <p:cNvGrpSpPr/>
            <p:nvPr/>
          </p:nvGrpSpPr>
          <p:grpSpPr>
            <a:xfrm>
              <a:off x="-70596" y="6876784"/>
              <a:ext cx="6725574" cy="2270868"/>
              <a:chOff x="-74705" y="7045094"/>
              <a:chExt cx="7117701" cy="2403277"/>
            </a:xfrm>
          </p:grpSpPr>
          <p:graphicFrame>
            <p:nvGraphicFramePr>
              <p:cNvPr id="310" name="グラフ 309">
                <a:extLst>
                  <a:ext uri="{FF2B5EF4-FFF2-40B4-BE49-F238E27FC236}">
                    <a16:creationId xmlns:a16="http://schemas.microsoft.com/office/drawing/2014/main" id="{457CC273-673C-44CD-B16E-91DDF2DA872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09209261"/>
                  </p:ext>
                </p:extLst>
              </p:nvPr>
            </p:nvGraphicFramePr>
            <p:xfrm>
              <a:off x="-74705" y="7243954"/>
              <a:ext cx="2590728" cy="217164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312" name="グラフ 311">
                <a:extLst>
                  <a:ext uri="{FF2B5EF4-FFF2-40B4-BE49-F238E27FC236}">
                    <a16:creationId xmlns:a16="http://schemas.microsoft.com/office/drawing/2014/main" id="{9F1AC9FC-7749-4293-B63B-D16203C22F9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94428220"/>
                  </p:ext>
                </p:extLst>
              </p:nvPr>
            </p:nvGraphicFramePr>
            <p:xfrm>
              <a:off x="2348362" y="7045094"/>
              <a:ext cx="2362134" cy="240023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grpSp>
            <p:nvGrpSpPr>
              <p:cNvPr id="316" name="グループ化 315">
                <a:extLst>
                  <a:ext uri="{FF2B5EF4-FFF2-40B4-BE49-F238E27FC236}">
                    <a16:creationId xmlns:a16="http://schemas.microsoft.com/office/drawing/2014/main" id="{957027D6-A571-4710-AAED-7049F8C13142}"/>
                  </a:ext>
                </a:extLst>
              </p:cNvPr>
              <p:cNvGrpSpPr/>
              <p:nvPr/>
            </p:nvGrpSpPr>
            <p:grpSpPr>
              <a:xfrm>
                <a:off x="4528115" y="7276726"/>
                <a:ext cx="2514881" cy="2171645"/>
                <a:chOff x="4543634" y="857834"/>
                <a:chExt cx="2391264" cy="3294214"/>
              </a:xfrm>
            </p:grpSpPr>
            <p:graphicFrame>
              <p:nvGraphicFramePr>
                <p:cNvPr id="317" name="グラフ 316">
                  <a:extLst>
                    <a:ext uri="{FF2B5EF4-FFF2-40B4-BE49-F238E27FC236}">
                      <a16:creationId xmlns:a16="http://schemas.microsoft.com/office/drawing/2014/main" id="{C336573A-A797-44E4-B96B-A6C0FB6B686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396152"/>
                    </p:ext>
                  </p:extLst>
                </p:nvPr>
              </p:nvGraphicFramePr>
              <p:xfrm>
                <a:off x="4543634" y="857834"/>
                <a:ext cx="2282253" cy="329421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324" name="テキスト ボックス 323">
                  <a:extLst>
                    <a:ext uri="{FF2B5EF4-FFF2-40B4-BE49-F238E27FC236}">
                      <a16:creationId xmlns:a16="http://schemas.microsoft.com/office/drawing/2014/main" id="{8C930EE4-EA0F-46E7-AA73-BAD509F210A4}"/>
                    </a:ext>
                  </a:extLst>
                </p:cNvPr>
                <p:cNvSpPr txBox="1"/>
                <p:nvPr/>
              </p:nvSpPr>
              <p:spPr>
                <a:xfrm>
                  <a:off x="6454113" y="2878876"/>
                  <a:ext cx="243546" cy="345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8" name="テキスト ボックス 317">
                  <a:extLst>
                    <a:ext uri="{FF2B5EF4-FFF2-40B4-BE49-F238E27FC236}">
                      <a16:creationId xmlns:a16="http://schemas.microsoft.com/office/drawing/2014/main" id="{E6299970-8DFF-4A5C-8FD6-F7FE304F3CA9}"/>
                    </a:ext>
                  </a:extLst>
                </p:cNvPr>
                <p:cNvSpPr txBox="1"/>
                <p:nvPr/>
              </p:nvSpPr>
              <p:spPr>
                <a:xfrm>
                  <a:off x="5301323" y="2225098"/>
                  <a:ext cx="354918" cy="4049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kumimoji="1" lang="ja-JP" altLang="en-US" sz="1039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9" name="テキスト ボックス 318">
                  <a:extLst>
                    <a:ext uri="{FF2B5EF4-FFF2-40B4-BE49-F238E27FC236}">
                      <a16:creationId xmlns:a16="http://schemas.microsoft.com/office/drawing/2014/main" id="{81214348-47AB-4A3F-985B-9F2CDB56F133}"/>
                    </a:ext>
                  </a:extLst>
                </p:cNvPr>
                <p:cNvSpPr txBox="1"/>
                <p:nvPr/>
              </p:nvSpPr>
              <p:spPr>
                <a:xfrm>
                  <a:off x="5607427" y="2391040"/>
                  <a:ext cx="288163" cy="4049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kumimoji="1" lang="ja-JP" altLang="en-US" sz="1039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0" name="テキスト ボックス 319">
                  <a:extLst>
                    <a:ext uri="{FF2B5EF4-FFF2-40B4-BE49-F238E27FC236}">
                      <a16:creationId xmlns:a16="http://schemas.microsoft.com/office/drawing/2014/main" id="{DA17E77D-D290-4D76-9E1A-8080F7762EF0}"/>
                    </a:ext>
                  </a:extLst>
                </p:cNvPr>
                <p:cNvSpPr txBox="1"/>
                <p:nvPr/>
              </p:nvSpPr>
              <p:spPr>
                <a:xfrm>
                  <a:off x="5592665" y="3220332"/>
                  <a:ext cx="375684" cy="345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#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1" name="テキスト ボックス 320">
                  <a:extLst>
                    <a:ext uri="{FF2B5EF4-FFF2-40B4-BE49-F238E27FC236}">
                      <a16:creationId xmlns:a16="http://schemas.microsoft.com/office/drawing/2014/main" id="{D4438DE3-0440-4269-8FA0-455E9FE862C4}"/>
                    </a:ext>
                  </a:extLst>
                </p:cNvPr>
                <p:cNvSpPr txBox="1"/>
                <p:nvPr/>
              </p:nvSpPr>
              <p:spPr>
                <a:xfrm>
                  <a:off x="6002268" y="2904091"/>
                  <a:ext cx="359583" cy="4049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kumimoji="1" lang="ja-JP" altLang="en-US" sz="1039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2" name="テキスト ボックス 321">
                  <a:extLst>
                    <a:ext uri="{FF2B5EF4-FFF2-40B4-BE49-F238E27FC236}">
                      <a16:creationId xmlns:a16="http://schemas.microsoft.com/office/drawing/2014/main" id="{8DEB6222-7ADD-43B9-9F1C-FCB2653DACC0}"/>
                    </a:ext>
                  </a:extLst>
                </p:cNvPr>
                <p:cNvSpPr txBox="1"/>
                <p:nvPr/>
              </p:nvSpPr>
              <p:spPr>
                <a:xfrm>
                  <a:off x="6046567" y="3006621"/>
                  <a:ext cx="255188" cy="3458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3" name="テキスト ボックス 322">
                  <a:extLst>
                    <a:ext uri="{FF2B5EF4-FFF2-40B4-BE49-F238E27FC236}">
                      <a16:creationId xmlns:a16="http://schemas.microsoft.com/office/drawing/2014/main" id="{9E59C51E-3543-4C51-99EA-898F592455FA}"/>
                    </a:ext>
                  </a:extLst>
                </p:cNvPr>
                <p:cNvSpPr txBox="1"/>
                <p:nvPr/>
              </p:nvSpPr>
              <p:spPr>
                <a:xfrm>
                  <a:off x="6430177" y="1967786"/>
                  <a:ext cx="504721" cy="4049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  <a:endParaRPr kumimoji="1" lang="ja-JP" altLang="en-US" sz="1039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26" name="テキスト ボックス 325">
                <a:extLst>
                  <a:ext uri="{FF2B5EF4-FFF2-40B4-BE49-F238E27FC236}">
                    <a16:creationId xmlns:a16="http://schemas.microsoft.com/office/drawing/2014/main" id="{7468074E-BBBE-430F-86E6-FF1F90B19DB7}"/>
                  </a:ext>
                </a:extLst>
              </p:cNvPr>
              <p:cNvSpPr txBox="1"/>
              <p:nvPr/>
            </p:nvSpPr>
            <p:spPr>
              <a:xfrm>
                <a:off x="6071218" y="8157698"/>
                <a:ext cx="303059" cy="2669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kumimoji="1" lang="ja-JP" altLang="en-US" sz="103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13" name="テキスト ボックス 312">
              <a:extLst>
                <a:ext uri="{FF2B5EF4-FFF2-40B4-BE49-F238E27FC236}">
                  <a16:creationId xmlns:a16="http://schemas.microsoft.com/office/drawing/2014/main" id="{B30C3127-EF2A-4DAB-9379-0492D5DFC3D1}"/>
                </a:ext>
              </a:extLst>
            </p:cNvPr>
            <p:cNvSpPr txBox="1"/>
            <p:nvPr/>
          </p:nvSpPr>
          <p:spPr>
            <a:xfrm>
              <a:off x="957981" y="8920391"/>
              <a:ext cx="11087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86399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kumimoji="1" lang="en-US" altLang="ja-JP" sz="10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ime (min)  </a:t>
              </a:r>
              <a:endParaRPr kumimoji="1" lang="ja-JP" altLang="en-US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15" name="テキスト ボックス 314">
              <a:extLst>
                <a:ext uri="{FF2B5EF4-FFF2-40B4-BE49-F238E27FC236}">
                  <a16:creationId xmlns:a16="http://schemas.microsoft.com/office/drawing/2014/main" id="{AF00F3DA-525D-4473-A590-A604BFE0CD25}"/>
                </a:ext>
              </a:extLst>
            </p:cNvPr>
            <p:cNvSpPr txBox="1"/>
            <p:nvPr/>
          </p:nvSpPr>
          <p:spPr>
            <a:xfrm>
              <a:off x="3033064" y="8922212"/>
              <a:ext cx="11087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86399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kumimoji="1" lang="en-US" altLang="ja-JP" sz="10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ime (min)  </a:t>
              </a:r>
              <a:endParaRPr kumimoji="1" lang="ja-JP" altLang="en-US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id="{C42157E7-59F6-4C58-820B-78B7C04CC899}"/>
                </a:ext>
              </a:extLst>
            </p:cNvPr>
            <p:cNvSpPr txBox="1"/>
            <p:nvPr/>
          </p:nvSpPr>
          <p:spPr>
            <a:xfrm>
              <a:off x="5119179" y="8920168"/>
              <a:ext cx="11087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86399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kumimoji="1" lang="en-US" altLang="ja-JP" sz="100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Time (min)  </a:t>
              </a:r>
              <a:endParaRPr kumimoji="1" lang="ja-JP" altLang="en-US" sz="10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endParaRPr>
            </a:p>
          </p:txBody>
        </p: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445E95F7-A992-43C9-A4DC-0FD6489A00EE}"/>
                </a:ext>
              </a:extLst>
            </p:cNvPr>
            <p:cNvGrpSpPr/>
            <p:nvPr/>
          </p:nvGrpSpPr>
          <p:grpSpPr>
            <a:xfrm>
              <a:off x="1009108" y="7182910"/>
              <a:ext cx="4764342" cy="265525"/>
              <a:chOff x="1034508" y="6941610"/>
              <a:chExt cx="4764342" cy="265525"/>
            </a:xfrm>
          </p:grpSpPr>
          <p:sp>
            <p:nvSpPr>
              <p:cNvPr id="329" name="テキスト ボックス 328">
                <a:extLst>
                  <a:ext uri="{FF2B5EF4-FFF2-40B4-BE49-F238E27FC236}">
                    <a16:creationId xmlns:a16="http://schemas.microsoft.com/office/drawing/2014/main" id="{F48B1F4C-F20E-4896-B865-09791633F24B}"/>
                  </a:ext>
                </a:extLst>
              </p:cNvPr>
              <p:cNvSpPr txBox="1"/>
              <p:nvPr/>
            </p:nvSpPr>
            <p:spPr>
              <a:xfrm>
                <a:off x="1034508" y="6941610"/>
                <a:ext cx="6512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w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テキスト ボックス 329">
                <a:extLst>
                  <a:ext uri="{FF2B5EF4-FFF2-40B4-BE49-F238E27FC236}">
                    <a16:creationId xmlns:a16="http://schemas.microsoft.com/office/drawing/2014/main" id="{80C37408-2E90-4141-9156-91C18310FF04}"/>
                  </a:ext>
                </a:extLst>
              </p:cNvPr>
              <p:cNvSpPr txBox="1"/>
              <p:nvPr/>
            </p:nvSpPr>
            <p:spPr>
              <a:xfrm>
                <a:off x="3069040" y="6960914"/>
                <a:ext cx="6512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w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テキスト ボックス 330">
                <a:extLst>
                  <a:ext uri="{FF2B5EF4-FFF2-40B4-BE49-F238E27FC236}">
                    <a16:creationId xmlns:a16="http://schemas.microsoft.com/office/drawing/2014/main" id="{62A92DFD-0FFB-43A1-9C97-3795A9CB9A23}"/>
                  </a:ext>
                </a:extLst>
              </p:cNvPr>
              <p:cNvSpPr txBox="1"/>
              <p:nvPr/>
            </p:nvSpPr>
            <p:spPr>
              <a:xfrm>
                <a:off x="5147646" y="6941610"/>
                <a:ext cx="6512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w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81E1A789-A9CB-4489-8586-F4F62ACFC8CA}"/>
              </a:ext>
            </a:extLst>
          </p:cNvPr>
          <p:cNvSpPr txBox="1"/>
          <p:nvPr/>
        </p:nvSpPr>
        <p:spPr>
          <a:xfrm>
            <a:off x="0" y="3030"/>
            <a:ext cx="3282496" cy="3540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70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sz="1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662B65A-16C4-400D-A0CB-52FFC116330C}"/>
              </a:ext>
            </a:extLst>
          </p:cNvPr>
          <p:cNvSpPr txBox="1"/>
          <p:nvPr/>
        </p:nvSpPr>
        <p:spPr>
          <a:xfrm rot="10800000">
            <a:off x="-46168" y="5657083"/>
            <a:ext cx="338554" cy="153222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lucose (% of baseline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0824828D-FBE9-4E7F-8FFD-F7569357FB80}"/>
              </a:ext>
            </a:extLst>
          </p:cNvPr>
          <p:cNvGrpSpPr/>
          <p:nvPr/>
        </p:nvGrpSpPr>
        <p:grpSpPr>
          <a:xfrm>
            <a:off x="-20769" y="2986470"/>
            <a:ext cx="3594232" cy="2330450"/>
            <a:chOff x="-20769" y="4733925"/>
            <a:chExt cx="3594232" cy="2330450"/>
          </a:xfrm>
        </p:grpSpPr>
        <p:graphicFrame>
          <p:nvGraphicFramePr>
            <p:cNvPr id="21" name="オブジェクト 20">
              <a:extLst>
                <a:ext uri="{FF2B5EF4-FFF2-40B4-BE49-F238E27FC236}">
                  <a16:creationId xmlns:a16="http://schemas.microsoft.com/office/drawing/2014/main" id="{9EF3C641-2977-42C9-8C08-20C8A5349B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8427663"/>
                </p:ext>
              </p:extLst>
            </p:nvPr>
          </p:nvGraphicFramePr>
          <p:xfrm>
            <a:off x="165100" y="4733925"/>
            <a:ext cx="3408363" cy="2330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9" imgW="3448660" imgH="2357949" progId="Prism9.Document">
                    <p:embed/>
                  </p:oleObj>
                </mc:Choice>
                <mc:Fallback>
                  <p:oleObj name="Prism 9" r:id="rId9" imgW="3448660" imgH="2357949" progId="Prism9.Document">
                    <p:embed/>
                    <p:pic>
                      <p:nvPicPr>
                        <p:cNvPr id="21" name="オブジェクト 20">
                          <a:extLst>
                            <a:ext uri="{FF2B5EF4-FFF2-40B4-BE49-F238E27FC236}">
                              <a16:creationId xmlns:a16="http://schemas.microsoft.com/office/drawing/2014/main" id="{9EF3C641-2977-42C9-8C08-20C8A5349B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65100" y="4733925"/>
                          <a:ext cx="3408363" cy="2330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93" name="テキスト ボックス 292">
              <a:extLst>
                <a:ext uri="{FF2B5EF4-FFF2-40B4-BE49-F238E27FC236}">
                  <a16:creationId xmlns:a16="http://schemas.microsoft.com/office/drawing/2014/main" id="{64770CB7-E295-475B-AD11-39E45A3BAF4A}"/>
                </a:ext>
              </a:extLst>
            </p:cNvPr>
            <p:cNvSpPr txBox="1"/>
            <p:nvPr/>
          </p:nvSpPr>
          <p:spPr>
            <a:xfrm rot="10800000">
              <a:off x="-20769" y="5344696"/>
              <a:ext cx="338554" cy="88160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Fat mass (g)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2" name="グループ化 341">
            <a:extLst>
              <a:ext uri="{FF2B5EF4-FFF2-40B4-BE49-F238E27FC236}">
                <a16:creationId xmlns:a16="http://schemas.microsoft.com/office/drawing/2014/main" id="{058FBC7D-674A-4FFA-91F0-4BE39E58BD8E}"/>
              </a:ext>
            </a:extLst>
          </p:cNvPr>
          <p:cNvGrpSpPr/>
          <p:nvPr/>
        </p:nvGrpSpPr>
        <p:grpSpPr>
          <a:xfrm>
            <a:off x="4222401" y="3278481"/>
            <a:ext cx="1962450" cy="1476000"/>
            <a:chOff x="208362" y="5012988"/>
            <a:chExt cx="2076870" cy="1438946"/>
          </a:xfrm>
        </p:grpSpPr>
        <p:grpSp>
          <p:nvGrpSpPr>
            <p:cNvPr id="343" name="グループ化 342">
              <a:extLst>
                <a:ext uri="{FF2B5EF4-FFF2-40B4-BE49-F238E27FC236}">
                  <a16:creationId xmlns:a16="http://schemas.microsoft.com/office/drawing/2014/main" id="{11A48598-D45B-46F1-9F1E-943186BE9E44}"/>
                </a:ext>
              </a:extLst>
            </p:cNvPr>
            <p:cNvGrpSpPr/>
            <p:nvPr/>
          </p:nvGrpSpPr>
          <p:grpSpPr>
            <a:xfrm>
              <a:off x="689846" y="5771111"/>
              <a:ext cx="1595386" cy="621437"/>
              <a:chOff x="689846" y="5771111"/>
              <a:chExt cx="1595386" cy="621437"/>
            </a:xfrm>
          </p:grpSpPr>
          <p:sp>
            <p:nvSpPr>
              <p:cNvPr id="366" name="正方形/長方形 365">
                <a:extLst>
                  <a:ext uri="{FF2B5EF4-FFF2-40B4-BE49-F238E27FC236}">
                    <a16:creationId xmlns:a16="http://schemas.microsoft.com/office/drawing/2014/main" id="{F01C4297-5460-4CBB-AA18-B1A28D0C6589}"/>
                  </a:ext>
                </a:extLst>
              </p:cNvPr>
              <p:cNvSpPr/>
              <p:nvPr/>
            </p:nvSpPr>
            <p:spPr>
              <a:xfrm>
                <a:off x="689846" y="6211903"/>
                <a:ext cx="178986" cy="180645"/>
              </a:xfrm>
              <a:prstGeom prst="rect">
                <a:avLst/>
              </a:prstGeom>
              <a:pattFill prst="smCheck">
                <a:fgClr>
                  <a:schemeClr val="bg1">
                    <a:lumMod val="50000"/>
                  </a:schemeClr>
                </a:fgClr>
                <a:bgClr>
                  <a:sysClr val="window" lastClr="FFFFFF"/>
                </a:bgClr>
              </a:pattFill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  <p:txBody>
              <a:bodyPr rtlCol="0" anchor="ctr"/>
              <a:lstStyle/>
              <a:p>
                <a:pPr algn="ctr" defTabSz="80785">
                  <a:defRPr/>
                </a:pPr>
                <a:endParaRPr kumimoji="1" lang="ja-JP" altLang="en-US" sz="2357" kern="0">
                  <a:solidFill>
                    <a:prstClr val="white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367" name="テキスト ボックス 366">
                <a:extLst>
                  <a:ext uri="{FF2B5EF4-FFF2-40B4-BE49-F238E27FC236}">
                    <a16:creationId xmlns:a16="http://schemas.microsoft.com/office/drawing/2014/main" id="{278922E1-5EEA-44F5-A625-0A58D2B944C7}"/>
                  </a:ext>
                </a:extLst>
              </p:cNvPr>
              <p:cNvSpPr txBox="1"/>
              <p:nvPr/>
            </p:nvSpPr>
            <p:spPr>
              <a:xfrm>
                <a:off x="898120" y="5771111"/>
                <a:ext cx="1387112" cy="35931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80785">
                  <a:defRPr/>
                </a:pPr>
                <a:r>
                  <a:rPr kumimoji="1" lang="en-US" altLang="ja-JP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rPr>
                  <a:t>WT+HFD</a:t>
                </a:r>
                <a:endParaRPr kumimoji="1" lang="ja-JP" altLang="en-US" sz="1134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  <a:p>
                <a:pPr defTabSz="80785">
                  <a:defRPr/>
                </a:pPr>
                <a:endParaRPr kumimoji="1" lang="ja-JP" altLang="en-US" sz="472" kern="0" dirty="0">
                  <a:solidFill>
                    <a:prstClr val="black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44" name="グループ化 343">
              <a:extLst>
                <a:ext uri="{FF2B5EF4-FFF2-40B4-BE49-F238E27FC236}">
                  <a16:creationId xmlns:a16="http://schemas.microsoft.com/office/drawing/2014/main" id="{A34BAB21-C9E1-435C-93E5-50B621438265}"/>
                </a:ext>
              </a:extLst>
            </p:cNvPr>
            <p:cNvGrpSpPr/>
            <p:nvPr/>
          </p:nvGrpSpPr>
          <p:grpSpPr>
            <a:xfrm>
              <a:off x="208362" y="5012988"/>
              <a:ext cx="1819698" cy="1438946"/>
              <a:chOff x="208362" y="5012988"/>
              <a:chExt cx="1819698" cy="1438946"/>
            </a:xfrm>
          </p:grpSpPr>
          <p:grpSp>
            <p:nvGrpSpPr>
              <p:cNvPr id="345" name="グループ化 344">
                <a:extLst>
                  <a:ext uri="{FF2B5EF4-FFF2-40B4-BE49-F238E27FC236}">
                    <a16:creationId xmlns:a16="http://schemas.microsoft.com/office/drawing/2014/main" id="{CB0C4E69-BC35-4E0D-AEF6-FBD7442FD155}"/>
                  </a:ext>
                </a:extLst>
              </p:cNvPr>
              <p:cNvGrpSpPr/>
              <p:nvPr/>
            </p:nvGrpSpPr>
            <p:grpSpPr>
              <a:xfrm>
                <a:off x="689846" y="5012988"/>
                <a:ext cx="1210951" cy="282428"/>
                <a:chOff x="689846" y="5012988"/>
                <a:chExt cx="1210951" cy="282428"/>
              </a:xfrm>
            </p:grpSpPr>
            <p:sp>
              <p:nvSpPr>
                <p:cNvPr id="364" name="正方形/長方形 363">
                  <a:extLst>
                    <a:ext uri="{FF2B5EF4-FFF2-40B4-BE49-F238E27FC236}">
                      <a16:creationId xmlns:a16="http://schemas.microsoft.com/office/drawing/2014/main" id="{8D75638E-DB47-4A14-874A-93CEE5F2452C}"/>
                    </a:ext>
                  </a:extLst>
                </p:cNvPr>
                <p:cNvSpPr/>
                <p:nvPr/>
              </p:nvSpPr>
              <p:spPr>
                <a:xfrm>
                  <a:off x="689846" y="5061435"/>
                  <a:ext cx="178986" cy="178986"/>
                </a:xfrm>
                <a:prstGeom prst="rect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0785">
                    <a:defRPr/>
                  </a:pPr>
                  <a:endParaRPr kumimoji="1" lang="ja-JP" altLang="en-US" sz="2357" kern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5" name="テキスト ボックス 364">
                  <a:extLst>
                    <a:ext uri="{FF2B5EF4-FFF2-40B4-BE49-F238E27FC236}">
                      <a16:creationId xmlns:a16="http://schemas.microsoft.com/office/drawing/2014/main" id="{4E1E13F8-86D1-44B5-80BB-D11E00B7A220}"/>
                    </a:ext>
                  </a:extLst>
                </p:cNvPr>
                <p:cNvSpPr txBox="1"/>
                <p:nvPr/>
              </p:nvSpPr>
              <p:spPr>
                <a:xfrm>
                  <a:off x="898120" y="5012988"/>
                  <a:ext cx="1002677" cy="282428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80785">
                    <a:defRPr/>
                  </a:pP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WT+CFD</a:t>
                  </a:r>
                  <a:endParaRPr kumimoji="1" lang="ja-JP" altLang="en-US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6" name="グループ化 345">
                <a:extLst>
                  <a:ext uri="{FF2B5EF4-FFF2-40B4-BE49-F238E27FC236}">
                    <a16:creationId xmlns:a16="http://schemas.microsoft.com/office/drawing/2014/main" id="{91AB8084-F17A-4D75-8F62-77274A0DAAC8}"/>
                  </a:ext>
                </a:extLst>
              </p:cNvPr>
              <p:cNvGrpSpPr/>
              <p:nvPr/>
            </p:nvGrpSpPr>
            <p:grpSpPr>
              <a:xfrm>
                <a:off x="689846" y="5368489"/>
                <a:ext cx="1297171" cy="359313"/>
                <a:chOff x="689846" y="5368489"/>
                <a:chExt cx="1297171" cy="359313"/>
              </a:xfrm>
            </p:grpSpPr>
            <p:sp>
              <p:nvSpPr>
                <p:cNvPr id="362" name="正方形/長方形 361">
                  <a:extLst>
                    <a:ext uri="{FF2B5EF4-FFF2-40B4-BE49-F238E27FC236}">
                      <a16:creationId xmlns:a16="http://schemas.microsoft.com/office/drawing/2014/main" id="{5A30D70C-BE6C-419D-B499-FFEA2221C338}"/>
                    </a:ext>
                  </a:extLst>
                </p:cNvPr>
                <p:cNvSpPr/>
                <p:nvPr/>
              </p:nvSpPr>
              <p:spPr>
                <a:xfrm>
                  <a:off x="689846" y="5417374"/>
                  <a:ext cx="178986" cy="180645"/>
                </a:xfrm>
                <a:prstGeom prst="rect">
                  <a:avLst/>
                </a:prstGeom>
                <a:pattFill prst="pct10">
                  <a:fgClr>
                    <a:sysClr val="windowText" lastClr="000000"/>
                  </a:fgClr>
                  <a:bgClr>
                    <a:sysClr val="window" lastClr="FFFFFF"/>
                  </a:bgClr>
                </a:pattFill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0785">
                    <a:defRPr/>
                  </a:pPr>
                  <a:endParaRPr kumimoji="1" lang="ja-JP" altLang="en-US" sz="2357" kern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3" name="テキスト ボックス 362">
                  <a:extLst>
                    <a:ext uri="{FF2B5EF4-FFF2-40B4-BE49-F238E27FC236}">
                      <a16:creationId xmlns:a16="http://schemas.microsoft.com/office/drawing/2014/main" id="{AE7D64B9-2D96-47E9-8F4B-396AFD17F93A}"/>
                    </a:ext>
                  </a:extLst>
                </p:cNvPr>
                <p:cNvSpPr txBox="1"/>
                <p:nvPr/>
              </p:nvSpPr>
              <p:spPr>
                <a:xfrm>
                  <a:off x="898120" y="5368489"/>
                  <a:ext cx="1088897" cy="359313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80785">
                    <a:defRPr/>
                  </a:pP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GIP</a:t>
                  </a:r>
                  <a:r>
                    <a:rPr kumimoji="1" lang="en-US" altLang="ja-JP" sz="1134" kern="0" baseline="300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-/-</a:t>
                  </a: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+CFD</a:t>
                  </a:r>
                  <a:endParaRPr kumimoji="1" lang="ja-JP" altLang="en-US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  <a:p>
                  <a:pPr defTabSz="80785">
                    <a:defRPr/>
                  </a:pPr>
                  <a:endParaRPr kumimoji="1" lang="ja-JP" altLang="en-US" sz="472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7" name="グループ化 346">
                <a:extLst>
                  <a:ext uri="{FF2B5EF4-FFF2-40B4-BE49-F238E27FC236}">
                    <a16:creationId xmlns:a16="http://schemas.microsoft.com/office/drawing/2014/main" id="{72D25A38-271A-431F-ABBC-CAE8C4CD4689}"/>
                  </a:ext>
                </a:extLst>
              </p:cNvPr>
              <p:cNvGrpSpPr/>
              <p:nvPr/>
            </p:nvGrpSpPr>
            <p:grpSpPr>
              <a:xfrm>
                <a:off x="689846" y="5813690"/>
                <a:ext cx="1338214" cy="638244"/>
                <a:chOff x="689846" y="5813690"/>
                <a:chExt cx="1338214" cy="638244"/>
              </a:xfrm>
            </p:grpSpPr>
            <p:sp>
              <p:nvSpPr>
                <p:cNvPr id="360" name="正方形/長方形 359">
                  <a:extLst>
                    <a:ext uri="{FF2B5EF4-FFF2-40B4-BE49-F238E27FC236}">
                      <a16:creationId xmlns:a16="http://schemas.microsoft.com/office/drawing/2014/main" id="{6C1B70FE-CFCD-4BF8-AA30-3FE5DD863F83}"/>
                    </a:ext>
                  </a:extLst>
                </p:cNvPr>
                <p:cNvSpPr/>
                <p:nvPr/>
              </p:nvSpPr>
              <p:spPr>
                <a:xfrm>
                  <a:off x="689846" y="5813690"/>
                  <a:ext cx="178986" cy="178986"/>
                </a:xfrm>
                <a:prstGeom prst="rect">
                  <a:avLst/>
                </a:prstGeom>
                <a:solidFill>
                  <a:sysClr val="window" lastClr="FFFFFF">
                    <a:lumMod val="50000"/>
                  </a:sysClr>
                </a:solidFill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0785">
                    <a:defRPr/>
                  </a:pPr>
                  <a:endParaRPr kumimoji="1" lang="ja-JP" altLang="en-US" sz="2357" kern="0" dirty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テキスト ボックス 360">
                  <a:extLst>
                    <a:ext uri="{FF2B5EF4-FFF2-40B4-BE49-F238E27FC236}">
                      <a16:creationId xmlns:a16="http://schemas.microsoft.com/office/drawing/2014/main" id="{15AF5AC0-486B-4074-A938-524F4CA77AA1}"/>
                    </a:ext>
                  </a:extLst>
                </p:cNvPr>
                <p:cNvSpPr txBox="1"/>
                <p:nvPr/>
              </p:nvSpPr>
              <p:spPr>
                <a:xfrm>
                  <a:off x="898120" y="6169507"/>
                  <a:ext cx="1129940" cy="282427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80785">
                    <a:defRPr/>
                  </a:pP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GIP</a:t>
                  </a:r>
                  <a:r>
                    <a:rPr kumimoji="1" lang="en-US" altLang="ja-JP" sz="1134" kern="0" baseline="3000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-/-</a:t>
                  </a:r>
                  <a:r>
                    <a:rPr kumimoji="1" lang="en-US" altLang="ja-JP" sz="1134" kern="0" dirty="0">
                      <a:solidFill>
                        <a:prstClr val="black"/>
                      </a:solidFill>
                      <a:latin typeface="Arial" panose="020B0604020202020204" pitchFamily="34" charset="0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+HFD</a:t>
                  </a:r>
                  <a:endParaRPr kumimoji="1" lang="ja-JP" altLang="en-US" sz="1134" kern="0" dirty="0">
                    <a:solidFill>
                      <a:prstClr val="black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8" name="グループ化 347">
                <a:extLst>
                  <a:ext uri="{FF2B5EF4-FFF2-40B4-BE49-F238E27FC236}">
                    <a16:creationId xmlns:a16="http://schemas.microsoft.com/office/drawing/2014/main" id="{8E6135CE-CB48-4CB4-B213-85792ED272CF}"/>
                  </a:ext>
                </a:extLst>
              </p:cNvPr>
              <p:cNvGrpSpPr/>
              <p:nvPr/>
            </p:nvGrpSpPr>
            <p:grpSpPr>
              <a:xfrm>
                <a:off x="208362" y="5085044"/>
                <a:ext cx="342769" cy="131769"/>
                <a:chOff x="2856312" y="5187944"/>
                <a:chExt cx="342769" cy="131769"/>
              </a:xfrm>
            </p:grpSpPr>
            <p:cxnSp>
              <p:nvCxnSpPr>
                <p:cNvPr id="358" name="直線コネクタ 357">
                  <a:extLst>
                    <a:ext uri="{FF2B5EF4-FFF2-40B4-BE49-F238E27FC236}">
                      <a16:creationId xmlns:a16="http://schemas.microsoft.com/office/drawing/2014/main" id="{3B4E301F-5C8E-4D23-AD45-32783921FAEC}"/>
                    </a:ext>
                  </a:extLst>
                </p:cNvPr>
                <p:cNvCxnSpPr/>
                <p:nvPr/>
              </p:nvCxnSpPr>
              <p:spPr>
                <a:xfrm>
                  <a:off x="2856312" y="5253828"/>
                  <a:ext cx="342769" cy="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lgDashDot"/>
                </a:ln>
                <a:effectLst/>
              </p:spPr>
            </p:cxnSp>
            <p:sp>
              <p:nvSpPr>
                <p:cNvPr id="359" name="円/楕円 171">
                  <a:extLst>
                    <a:ext uri="{FF2B5EF4-FFF2-40B4-BE49-F238E27FC236}">
                      <a16:creationId xmlns:a16="http://schemas.microsoft.com/office/drawing/2014/main" id="{B170ACA0-1ED5-46D7-A41D-C0133057C342}"/>
                    </a:ext>
                  </a:extLst>
                </p:cNvPr>
                <p:cNvSpPr/>
                <p:nvPr/>
              </p:nvSpPr>
              <p:spPr>
                <a:xfrm>
                  <a:off x="2961812" y="5187944"/>
                  <a:ext cx="131769" cy="131769"/>
                </a:xfrm>
                <a:prstGeom prst="ellipse">
                  <a:avLst/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64017">
                    <a:defRPr/>
                  </a:pPr>
                  <a:endParaRPr lang="ja-JP" altLang="en-US" sz="992" b="1" kern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9" name="グループ化 348">
                <a:extLst>
                  <a:ext uri="{FF2B5EF4-FFF2-40B4-BE49-F238E27FC236}">
                    <a16:creationId xmlns:a16="http://schemas.microsoft.com/office/drawing/2014/main" id="{9BC83054-8E87-4D4C-8D36-0167F05BB861}"/>
                  </a:ext>
                </a:extLst>
              </p:cNvPr>
              <p:cNvGrpSpPr/>
              <p:nvPr/>
            </p:nvGrpSpPr>
            <p:grpSpPr>
              <a:xfrm>
                <a:off x="208362" y="5441812"/>
                <a:ext cx="342769" cy="131769"/>
                <a:chOff x="2856312" y="5566178"/>
                <a:chExt cx="342769" cy="131769"/>
              </a:xfrm>
            </p:grpSpPr>
            <p:cxnSp>
              <p:nvCxnSpPr>
                <p:cNvPr id="356" name="直線コネクタ 355">
                  <a:extLst>
                    <a:ext uri="{FF2B5EF4-FFF2-40B4-BE49-F238E27FC236}">
                      <a16:creationId xmlns:a16="http://schemas.microsoft.com/office/drawing/2014/main" id="{791F58A1-7EEE-4209-B28D-C2BC408147BC}"/>
                    </a:ext>
                  </a:extLst>
                </p:cNvPr>
                <p:cNvCxnSpPr/>
                <p:nvPr/>
              </p:nvCxnSpPr>
              <p:spPr>
                <a:xfrm>
                  <a:off x="2856312" y="5632062"/>
                  <a:ext cx="342769" cy="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dash"/>
                </a:ln>
                <a:effectLst/>
              </p:spPr>
            </p:cxnSp>
            <p:sp>
              <p:nvSpPr>
                <p:cNvPr id="357" name="二等辺三角形 356">
                  <a:extLst>
                    <a:ext uri="{FF2B5EF4-FFF2-40B4-BE49-F238E27FC236}">
                      <a16:creationId xmlns:a16="http://schemas.microsoft.com/office/drawing/2014/main" id="{85594435-5BE7-46F0-8824-FA10A4E95FA7}"/>
                    </a:ext>
                  </a:extLst>
                </p:cNvPr>
                <p:cNvSpPr/>
                <p:nvPr/>
              </p:nvSpPr>
              <p:spPr>
                <a:xfrm>
                  <a:off x="2961812" y="5566178"/>
                  <a:ext cx="131769" cy="131769"/>
                </a:xfrm>
                <a:prstGeom prst="triangle">
                  <a:avLst>
                    <a:gd name="adj" fmla="val 46774"/>
                  </a:avLst>
                </a:prstGeom>
                <a:noFill/>
                <a:ln w="12700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63996">
                    <a:defRPr/>
                  </a:pPr>
                  <a:endParaRPr lang="ja-JP" altLang="en-US" sz="318" kern="0" dirty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0" name="グループ化 349">
                <a:extLst>
                  <a:ext uri="{FF2B5EF4-FFF2-40B4-BE49-F238E27FC236}">
                    <a16:creationId xmlns:a16="http://schemas.microsoft.com/office/drawing/2014/main" id="{502D66DC-98CB-4861-AF20-B7D4E1EE9476}"/>
                  </a:ext>
                </a:extLst>
              </p:cNvPr>
              <p:cNvGrpSpPr/>
              <p:nvPr/>
            </p:nvGrpSpPr>
            <p:grpSpPr>
              <a:xfrm>
                <a:off x="208362" y="5848254"/>
                <a:ext cx="342769" cy="131769"/>
                <a:chOff x="2856312" y="6218472"/>
                <a:chExt cx="342769" cy="131769"/>
              </a:xfrm>
            </p:grpSpPr>
            <p:cxnSp>
              <p:nvCxnSpPr>
                <p:cNvPr id="354" name="直線コネクタ 353">
                  <a:extLst>
                    <a:ext uri="{FF2B5EF4-FFF2-40B4-BE49-F238E27FC236}">
                      <a16:creationId xmlns:a16="http://schemas.microsoft.com/office/drawing/2014/main" id="{CD3EFCAB-288C-48CA-9A5D-2E38F6712FED}"/>
                    </a:ext>
                  </a:extLst>
                </p:cNvPr>
                <p:cNvCxnSpPr/>
                <p:nvPr/>
              </p:nvCxnSpPr>
              <p:spPr>
                <a:xfrm>
                  <a:off x="2856312" y="6278458"/>
                  <a:ext cx="342769" cy="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355" name="円/楕円 171">
                  <a:extLst>
                    <a:ext uri="{FF2B5EF4-FFF2-40B4-BE49-F238E27FC236}">
                      <a16:creationId xmlns:a16="http://schemas.microsoft.com/office/drawing/2014/main" id="{5775FF26-C5A6-4177-B078-F9728A56AD13}"/>
                    </a:ext>
                  </a:extLst>
                </p:cNvPr>
                <p:cNvSpPr/>
                <p:nvPr/>
              </p:nvSpPr>
              <p:spPr>
                <a:xfrm>
                  <a:off x="2961812" y="6218472"/>
                  <a:ext cx="131769" cy="131769"/>
                </a:xfrm>
                <a:prstGeom prst="ellipse">
                  <a:avLst/>
                </a:prstGeom>
                <a:solidFill>
                  <a:sysClr val="windowText" lastClr="000000"/>
                </a:solidFill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64017">
                    <a:defRPr/>
                  </a:pPr>
                  <a:endParaRPr lang="ja-JP" altLang="en-US" sz="992" b="1" kern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51" name="グループ化 350">
                <a:extLst>
                  <a:ext uri="{FF2B5EF4-FFF2-40B4-BE49-F238E27FC236}">
                    <a16:creationId xmlns:a16="http://schemas.microsoft.com/office/drawing/2014/main" id="{889B17CA-72DF-4001-9110-DC0ECCDEB5D4}"/>
                  </a:ext>
                </a:extLst>
              </p:cNvPr>
              <p:cNvGrpSpPr/>
              <p:nvPr/>
            </p:nvGrpSpPr>
            <p:grpSpPr>
              <a:xfrm>
                <a:off x="208362" y="6230702"/>
                <a:ext cx="342769" cy="131769"/>
                <a:chOff x="2856312" y="5892750"/>
                <a:chExt cx="342769" cy="131769"/>
              </a:xfrm>
            </p:grpSpPr>
            <p:cxnSp>
              <p:nvCxnSpPr>
                <p:cNvPr id="352" name="直線コネクタ 351">
                  <a:extLst>
                    <a:ext uri="{FF2B5EF4-FFF2-40B4-BE49-F238E27FC236}">
                      <a16:creationId xmlns:a16="http://schemas.microsoft.com/office/drawing/2014/main" id="{F6D9517C-E5F8-4691-B10B-A702E5806EF5}"/>
                    </a:ext>
                  </a:extLst>
                </p:cNvPr>
                <p:cNvCxnSpPr/>
                <p:nvPr/>
              </p:nvCxnSpPr>
              <p:spPr>
                <a:xfrm>
                  <a:off x="2856312" y="5958634"/>
                  <a:ext cx="342769" cy="0"/>
                </a:xfrm>
                <a:prstGeom prst="line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</p:cxnSp>
            <p:sp>
              <p:nvSpPr>
                <p:cNvPr id="353" name="二等辺三角形 352">
                  <a:extLst>
                    <a:ext uri="{FF2B5EF4-FFF2-40B4-BE49-F238E27FC236}">
                      <a16:creationId xmlns:a16="http://schemas.microsoft.com/office/drawing/2014/main" id="{7D9AB0D1-CADC-4CEC-81FB-EEC636F800F0}"/>
                    </a:ext>
                  </a:extLst>
                </p:cNvPr>
                <p:cNvSpPr/>
                <p:nvPr/>
              </p:nvSpPr>
              <p:spPr>
                <a:xfrm>
                  <a:off x="2961812" y="5892750"/>
                  <a:ext cx="131769" cy="131769"/>
                </a:xfrm>
                <a:prstGeom prst="triangle">
                  <a:avLst>
                    <a:gd name="adj" fmla="val 46774"/>
                  </a:avLst>
                </a:prstGeom>
                <a:solidFill>
                  <a:sysClr val="windowText" lastClr="000000"/>
                </a:solidFill>
                <a:ln w="9525" cap="flat" cmpd="sng" algn="ctr">
                  <a:solidFill>
                    <a:sysClr val="windowText" lastClr="000000"/>
                  </a:solidFill>
                  <a:prstDash val="solid"/>
                </a:ln>
                <a:effectLst/>
              </p:spPr>
              <p:txBody>
                <a:bodyPr rtlCol="0" anchor="ctr"/>
                <a:lstStyle/>
                <a:p>
                  <a:pPr algn="ctr" defTabSz="863996">
                    <a:defRPr/>
                  </a:pPr>
                  <a:endParaRPr lang="ja-JP" altLang="en-US" sz="318" kern="0" dirty="0">
                    <a:solidFill>
                      <a:prstClr val="white"/>
                    </a:solidFill>
                    <a:latin typeface="Arial" panose="020B0604020202020204" pitchFamily="34" charset="0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334" name="グループ化 333">
            <a:extLst>
              <a:ext uri="{FF2B5EF4-FFF2-40B4-BE49-F238E27FC236}">
                <a16:creationId xmlns:a16="http://schemas.microsoft.com/office/drawing/2014/main" id="{FE3052A9-6C58-45DE-9983-AE275A4AAB71}"/>
              </a:ext>
            </a:extLst>
          </p:cNvPr>
          <p:cNvGrpSpPr/>
          <p:nvPr/>
        </p:nvGrpSpPr>
        <p:grpSpPr>
          <a:xfrm>
            <a:off x="171663" y="2900420"/>
            <a:ext cx="2980302" cy="2376931"/>
            <a:chOff x="126223" y="4632841"/>
            <a:chExt cx="3154068" cy="2515508"/>
          </a:xfrm>
        </p:grpSpPr>
        <p:grpSp>
          <p:nvGrpSpPr>
            <p:cNvPr id="333" name="グループ化 332">
              <a:extLst>
                <a:ext uri="{FF2B5EF4-FFF2-40B4-BE49-F238E27FC236}">
                  <a16:creationId xmlns:a16="http://schemas.microsoft.com/office/drawing/2014/main" id="{2C772EA1-D691-4087-9F0A-55B967D6A655}"/>
                </a:ext>
              </a:extLst>
            </p:cNvPr>
            <p:cNvGrpSpPr/>
            <p:nvPr/>
          </p:nvGrpSpPr>
          <p:grpSpPr>
            <a:xfrm>
              <a:off x="126223" y="4632841"/>
              <a:ext cx="2927096" cy="2330373"/>
              <a:chOff x="126223" y="4728091"/>
              <a:chExt cx="2927096" cy="2330373"/>
            </a:xfrm>
          </p:grpSpPr>
          <p:grpSp>
            <p:nvGrpSpPr>
              <p:cNvPr id="251" name="グループ化 250">
                <a:extLst>
                  <a:ext uri="{FF2B5EF4-FFF2-40B4-BE49-F238E27FC236}">
                    <a16:creationId xmlns:a16="http://schemas.microsoft.com/office/drawing/2014/main" id="{7595B278-6BE7-4588-9D9A-3687385346A2}"/>
                  </a:ext>
                </a:extLst>
              </p:cNvPr>
              <p:cNvGrpSpPr/>
              <p:nvPr/>
            </p:nvGrpSpPr>
            <p:grpSpPr>
              <a:xfrm>
                <a:off x="126223" y="4903323"/>
                <a:ext cx="409806" cy="2155141"/>
                <a:chOff x="81058" y="7215517"/>
                <a:chExt cx="409806" cy="2155141"/>
              </a:xfrm>
            </p:grpSpPr>
            <p:sp>
              <p:nvSpPr>
                <p:cNvPr id="252" name="テキスト ボックス 251">
                  <a:extLst>
                    <a:ext uri="{FF2B5EF4-FFF2-40B4-BE49-F238E27FC236}">
                      <a16:creationId xmlns:a16="http://schemas.microsoft.com/office/drawing/2014/main" id="{E15ABFD8-7855-4052-8455-E533D3277FF7}"/>
                    </a:ext>
                  </a:extLst>
                </p:cNvPr>
                <p:cNvSpPr txBox="1"/>
                <p:nvPr/>
              </p:nvSpPr>
              <p:spPr>
                <a:xfrm>
                  <a:off x="85075" y="7607430"/>
                  <a:ext cx="405303" cy="260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テキスト ボックス 252">
                  <a:extLst>
                    <a:ext uri="{FF2B5EF4-FFF2-40B4-BE49-F238E27FC236}">
                      <a16:creationId xmlns:a16="http://schemas.microsoft.com/office/drawing/2014/main" id="{A6316EBF-C813-4432-AFC8-43B451C8AFDD}"/>
                    </a:ext>
                  </a:extLst>
                </p:cNvPr>
                <p:cNvSpPr txBox="1"/>
                <p:nvPr/>
              </p:nvSpPr>
              <p:spPr>
                <a:xfrm>
                  <a:off x="81058" y="8002908"/>
                  <a:ext cx="409806" cy="260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4" name="テキスト ボックス 253">
                  <a:extLst>
                    <a:ext uri="{FF2B5EF4-FFF2-40B4-BE49-F238E27FC236}">
                      <a16:creationId xmlns:a16="http://schemas.microsoft.com/office/drawing/2014/main" id="{BF9F5BDA-594D-41DC-B4EB-CE6F78043EC8}"/>
                    </a:ext>
                  </a:extLst>
                </p:cNvPr>
                <p:cNvSpPr txBox="1"/>
                <p:nvPr/>
              </p:nvSpPr>
              <p:spPr>
                <a:xfrm>
                  <a:off x="158568" y="9110081"/>
                  <a:ext cx="183536" cy="260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5" name="テキスト ボックス 254">
                  <a:extLst>
                    <a:ext uri="{FF2B5EF4-FFF2-40B4-BE49-F238E27FC236}">
                      <a16:creationId xmlns:a16="http://schemas.microsoft.com/office/drawing/2014/main" id="{496B1E95-50E8-4D2F-BDCA-9E11E6B79173}"/>
                    </a:ext>
                  </a:extLst>
                </p:cNvPr>
                <p:cNvSpPr txBox="1"/>
                <p:nvPr/>
              </p:nvSpPr>
              <p:spPr>
                <a:xfrm>
                  <a:off x="87892" y="7215517"/>
                  <a:ext cx="397738" cy="2605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6" name="テキスト ボックス 255">
                  <a:extLst>
                    <a:ext uri="{FF2B5EF4-FFF2-40B4-BE49-F238E27FC236}">
                      <a16:creationId xmlns:a16="http://schemas.microsoft.com/office/drawing/2014/main" id="{3AE7FCCC-5CFA-4717-96DC-6D9449945C94}"/>
                    </a:ext>
                  </a:extLst>
                </p:cNvPr>
                <p:cNvSpPr txBox="1"/>
                <p:nvPr/>
              </p:nvSpPr>
              <p:spPr>
                <a:xfrm>
                  <a:off x="83845" y="8370690"/>
                  <a:ext cx="398953" cy="260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7" name="テキスト ボックス 256">
                  <a:extLst>
                    <a:ext uri="{FF2B5EF4-FFF2-40B4-BE49-F238E27FC236}">
                      <a16:creationId xmlns:a16="http://schemas.microsoft.com/office/drawing/2014/main" id="{91E102AA-4A16-4DAF-9185-C11E0AA78FE4}"/>
                    </a:ext>
                  </a:extLst>
                </p:cNvPr>
                <p:cNvSpPr txBox="1"/>
                <p:nvPr/>
              </p:nvSpPr>
              <p:spPr>
                <a:xfrm>
                  <a:off x="192543" y="8752652"/>
                  <a:ext cx="93098" cy="2605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kumimoji="1"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59" name="テキスト ボックス 258">
                <a:extLst>
                  <a:ext uri="{FF2B5EF4-FFF2-40B4-BE49-F238E27FC236}">
                    <a16:creationId xmlns:a16="http://schemas.microsoft.com/office/drawing/2014/main" id="{7DD2F3ED-8B91-4128-9C72-07C531084913}"/>
                  </a:ext>
                </a:extLst>
              </p:cNvPr>
              <p:cNvSpPr txBox="1"/>
              <p:nvPr/>
            </p:nvSpPr>
            <p:spPr>
              <a:xfrm>
                <a:off x="1231218" y="4728091"/>
                <a:ext cx="1822101" cy="2605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an body mass</a:t>
                </a:r>
                <a:endParaRPr kumimoji="1" lang="ja-JP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7" name="テキスト ボックス 306">
              <a:extLst>
                <a:ext uri="{FF2B5EF4-FFF2-40B4-BE49-F238E27FC236}">
                  <a16:creationId xmlns:a16="http://schemas.microsoft.com/office/drawing/2014/main" id="{CE9AC16A-15DA-4164-84D4-EB0D0D1F3D2C}"/>
                </a:ext>
              </a:extLst>
            </p:cNvPr>
            <p:cNvSpPr txBox="1"/>
            <p:nvPr/>
          </p:nvSpPr>
          <p:spPr>
            <a:xfrm>
              <a:off x="589841" y="6885855"/>
              <a:ext cx="763102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6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テキスト ボックス 307">
              <a:extLst>
                <a:ext uri="{FF2B5EF4-FFF2-40B4-BE49-F238E27FC236}">
                  <a16:creationId xmlns:a16="http://schemas.microsoft.com/office/drawing/2014/main" id="{70088A73-DC0B-4A8B-9261-1CFAF0DF8D41}"/>
                </a:ext>
              </a:extLst>
            </p:cNvPr>
            <p:cNvSpPr txBox="1"/>
            <p:nvPr/>
          </p:nvSpPr>
          <p:spPr>
            <a:xfrm>
              <a:off x="1500732" y="6887135"/>
              <a:ext cx="802491" cy="2605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id="{ADA172A0-0FD3-45D9-AD44-B91345195C29}"/>
                </a:ext>
              </a:extLst>
            </p:cNvPr>
            <p:cNvSpPr txBox="1"/>
            <p:nvPr/>
          </p:nvSpPr>
          <p:spPr>
            <a:xfrm>
              <a:off x="2477800" y="6887772"/>
              <a:ext cx="802491" cy="260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6w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80547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3</TotalTime>
  <Words>225</Words>
  <Application>Microsoft Office PowerPoint</Application>
  <PresentationFormat>ユーザー設定</PresentationFormat>
  <Paragraphs>106</Paragraphs>
  <Slides>2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Office テーマ</vt:lpstr>
      <vt:lpstr>Prism 9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許 櫻華</cp:lastModifiedBy>
  <cp:revision>367</cp:revision>
  <cp:lastPrinted>2022-05-06T08:17:16Z</cp:lastPrinted>
  <dcterms:created xsi:type="dcterms:W3CDTF">2021-05-11T06:36:19Z</dcterms:created>
  <dcterms:modified xsi:type="dcterms:W3CDTF">2022-06-03T16:46:42Z</dcterms:modified>
</cp:coreProperties>
</file>